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9" r:id="rId2"/>
    <p:sldId id="260" r:id="rId3"/>
    <p:sldId id="256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34" autoAdjust="0"/>
    <p:restoredTop sz="65271" autoAdjust="0"/>
  </p:normalViewPr>
  <p:slideViewPr>
    <p:cSldViewPr snapToGrid="0">
      <p:cViewPr varScale="1">
        <p:scale>
          <a:sx n="45" d="100"/>
          <a:sy n="45" d="100"/>
        </p:scale>
        <p:origin x="14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4DAEC85-2832-4C6A-9CE7-710C3FE900D9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4B058F9-D00B-4043-83B5-272C4C4F3B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560175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B058F9-D00B-4043-83B5-272C4C4F3B46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435252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BEB97E-2D26-417B-9593-0DFE1C07E41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E5B01C2-C436-42C4-8D73-F4D4A853F3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3EA4EA-114F-47E7-BCAD-EB20BC93F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B008D3-152E-4A1A-8DC1-6B54873641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B6C8CFF-7226-4D62-B4F9-F813A5238A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5850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517FED-58AA-4C2F-AB61-F85C360DEE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E8874CE-8034-4B99-9A89-1783AF53A98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6B6EA8-52A7-4FC9-8D9F-F0B92A0517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73D621-9543-41A2-AB32-40771329D5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67A27F-5B54-4ED4-8B31-BBE2FC28A6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20682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8D2AE7C-B2E2-41D1-9D06-EEB89A39821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84AD339-4606-42C6-A9F3-A00E8486C4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4DAF6A-F41F-4CD7-ACA1-AC2BD8B334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28019F-5B8F-41BF-97D4-4C8E8F2243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083608-0457-40DD-8D45-77B302C610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80200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4470A4-7268-4B47-A2B3-637C3B3A9D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FF04CC-3900-4A76-AD57-E92EAAA71D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A00B15-5978-48E4-B873-16FB41310B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B51E7F-E991-4A7B-8279-0C3DF0B764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59D42F-AA6B-4ABD-9B7F-6E4FEF4F24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4196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3B64DF-4DF8-4778-BE00-A8E53253A1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33F7BB-5D90-40A1-BB11-94AED0A522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CDE8FD-A11C-4810-B286-ACB7B1FDE1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363CDB-76C8-410A-8F10-EAA914A936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5F2F60-1A68-481B-B322-9762805015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60061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E13340-FE3F-4B58-AE4D-54059701E1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3CEED9-40EB-4299-85AC-25B1EBAA75C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F72EEA-D5ED-4A79-895D-A62E83F96C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4ED378-48C1-453F-98CF-E72D62FAED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11D184A-31EE-4A3F-A06B-ADBAF54669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C8A5F01-91FC-4AFF-A372-BFFCDFA7FB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3525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AEADB6-372D-4649-8C9B-12FFFF0816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7098BD-FD28-4620-8B44-8CBC39F979F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6CAABA-F9E7-4FC2-9C76-CB2F9B8746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86EB14E-B0E3-43E1-AD15-8339BC6ECF2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9F31187-C209-45CE-9531-7D226862BB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B79EAF-62E9-40A3-98EF-F4CB5C385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08783DF-CA16-49AC-A93A-9DA4EA5FA6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6E83DDD-F466-4A2A-BE33-1F1A635E0C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71037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5FCC90-C99F-4DEC-ABAA-0F1E8C4C7B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2CC565A-2624-4869-8F6C-843BCA35DE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89803BE-9889-450A-B94D-C05606EB0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FC8B3C-5E1B-4989-AC3D-465ADF6BEE6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0507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AA4277E-9811-44A5-AF8B-77D3FB6218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25DF359-0422-4DF2-88F1-CB2A9865CC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9CE7EB2-23BF-4CB0-AB2F-79BCF03B8C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57595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E9980E5-8871-4AF8-98A0-4121311782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5BB1B36-2BA7-48E4-A58D-A5206B9821B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E6AF04-F8D6-41A7-AEF6-7B16D367D1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AC85E7-67A1-443D-80EB-63D362AB48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8E654EA-974F-47E9-900D-A88573341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B1958E3-BC88-41FA-8CBB-07D405A110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4037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700414-680E-4063-B19A-ADDE0EE683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1FDA7CC-1963-43E1-8E51-0B7B156659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76FCFE-A266-48E2-9CB5-6B8F88D996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D1F5545-B373-4C0F-A129-399D5AF94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FB715E-23FE-4B5D-977E-F8A65EF91D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661C5F-EAE9-4A30-880F-1822E2A7F8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12963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603737A-E4A5-4AC4-9F98-3C444B9AB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B31FEF-CC7B-439D-9FFE-37EFF5F976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077A12-304D-4E18-B2A8-0818AE3B2A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813B46-296B-460E-970A-AD621CAAB83D}" type="datetimeFigureOut">
              <a:rPr lang="en-US" smtClean="0"/>
              <a:t>8/1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108BBE-96CD-4EFE-82DE-E348A4FD53D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3BA863-71C1-4BF5-AFC4-9471157E54B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671094-6D5E-4996-80DF-739F29650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36551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Chart, bar chart&#10;&#10;Description automatically generated">
            <a:extLst>
              <a:ext uri="{FF2B5EF4-FFF2-40B4-BE49-F238E27FC236}">
                <a16:creationId xmlns:a16="http://schemas.microsoft.com/office/drawing/2014/main" id="{2DBAF165-B6C2-4915-876D-5A47201D07AE}"/>
              </a:ext>
            </a:extLst>
          </p:cNvPr>
          <p:cNvPicPr>
            <a:picLocks noGrp="1" noChangeAspect="1"/>
          </p:cNvPicPr>
          <p:nvPr/>
        </p:nvPicPr>
        <p:blipFill rotWithShape="1">
          <a:blip r:embed="rId2"/>
          <a:srcRect t="1617" r="7652"/>
          <a:stretch/>
        </p:blipFill>
        <p:spPr>
          <a:xfrm>
            <a:off x="197708" y="59267"/>
            <a:ext cx="6095281" cy="487365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6123101" y="4980"/>
            <a:ext cx="740880" cy="316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55" b="1" dirty="0"/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91668" y="-13216"/>
            <a:ext cx="1866596" cy="3162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55" b="1" dirty="0"/>
              <a:t>A</a:t>
            </a:r>
          </a:p>
        </p:txBody>
      </p:sp>
      <p:sp>
        <p:nvSpPr>
          <p:cNvPr id="2" name="Rectangle 1"/>
          <p:cNvSpPr>
            <a:spLocks noChangeArrowheads="1"/>
          </p:cNvSpPr>
          <p:nvPr/>
        </p:nvSpPr>
        <p:spPr bwMode="auto">
          <a:xfrm>
            <a:off x="368572" y="5297819"/>
            <a:ext cx="11089444" cy="14689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3127" tIns="41564" rIns="83127" bIns="41564" numCol="1" anchor="ctr" anchorCtr="0" compatLnSpc="1">
            <a:prstTxWarp prst="textNoShape">
              <a:avLst/>
            </a:prstTxWarp>
            <a:spAutoFit/>
          </a:bodyPr>
          <a:lstStyle/>
          <a:p>
            <a:pPr defTabSz="831281" eaLnBrk="0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1. </a:t>
            </a:r>
            <a:r>
              <a:rPr lang="en-US" altLang="en-US" dirty="0">
                <a:latin typeface="Arial" panose="020B0604020202020204" pitchFamily="34" charset="0"/>
                <a:cs typeface="Arial" panose="020B0604020202020204" pitchFamily="34" charset="0"/>
              </a:rPr>
              <a:t>The top 10 Gene Ontology cellular components (green bars) and biological processes (red bars) enriched for (A) 115 proteins shared among three datasets (our current dataset, Alfaro et </a:t>
            </a:r>
            <a:r>
              <a:rPr lang="en-US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al, </a:t>
            </a:r>
            <a:r>
              <a:rPr lang="en-US" altLang="en-US" dirty="0">
                <a:latin typeface="Arial" panose="020B0604020202020204" pitchFamily="34" charset="0"/>
                <a:cs typeface="Arial" panose="020B0604020202020204" pitchFamily="34" charset="0"/>
              </a:rPr>
              <a:t>and Wang et al</a:t>
            </a:r>
            <a:r>
              <a:rPr lang="en-US" alt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.),</a:t>
            </a:r>
            <a:r>
              <a:rPr lang="en-US" alt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dirty="0">
                <a:latin typeface="Arial" panose="020B0604020202020204" pitchFamily="34" charset="0"/>
                <a:cs typeface="Arial" panose="020B0604020202020204" pitchFamily="34" charset="0"/>
              </a:rPr>
              <a:t>and (B) 67 unique proteins unique in this present study.  </a:t>
            </a:r>
            <a:endParaRPr lang="en-US" altLang="en-US" dirty="0">
              <a:latin typeface="Arial" panose="020B0604020202020204" pitchFamily="34" charset="0"/>
            </a:endParaRPr>
          </a:p>
          <a:p>
            <a:pPr eaLnBrk="0" fontAlgn="base">
              <a:spcBef>
                <a:spcPct val="0"/>
              </a:spcBef>
              <a:spcAft>
                <a:spcPct val="0"/>
              </a:spcAft>
              <a:tabLst>
                <a:tab pos="228600" algn="l"/>
              </a:tabLst>
            </a:pPr>
            <a:endParaRPr lang="en-US" altLang="en-US" dirty="0">
              <a:latin typeface="Arial" panose="020B0604020202020204" pitchFamily="34" charset="0"/>
            </a:endParaRPr>
          </a:p>
          <a:p>
            <a:pPr defTabSz="831281" eaLnBrk="0" fontAlgn="base">
              <a:spcBef>
                <a:spcPct val="0"/>
              </a:spcBef>
              <a:spcAft>
                <a:spcPct val="0"/>
              </a:spcAft>
            </a:pPr>
            <a:endParaRPr lang="en-US" altLang="en-US" dirty="0">
              <a:latin typeface="Arial" panose="020B0604020202020204" pitchFamily="34" charset="0"/>
            </a:endParaRPr>
          </a:p>
        </p:txBody>
      </p:sp>
      <p:pic>
        <p:nvPicPr>
          <p:cNvPr id="14" name="Picture 13" descr="Chart&#10;&#10;Description automatically generated">
            <a:extLst>
              <a:ext uri="{FF2B5EF4-FFF2-40B4-BE49-F238E27FC236}">
                <a16:creationId xmlns:a16="http://schemas.microsoft.com/office/drawing/2014/main" id="{348845A4-2C46-4FBF-AE08-AF41169B206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791" r="6826"/>
          <a:stretch/>
        </p:blipFill>
        <p:spPr>
          <a:xfrm>
            <a:off x="6486949" y="4980"/>
            <a:ext cx="5635771" cy="485750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84068590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86163" y="285481"/>
            <a:ext cx="5144674" cy="5663035"/>
            <a:chOff x="519526" y="380999"/>
            <a:chExt cx="5144674" cy="5663035"/>
          </a:xfrm>
        </p:grpSpPr>
        <p:grpSp>
          <p:nvGrpSpPr>
            <p:cNvPr id="298" name="Group 3"/>
            <p:cNvGrpSpPr/>
            <p:nvPr/>
          </p:nvGrpSpPr>
          <p:grpSpPr>
            <a:xfrm>
              <a:off x="519526" y="380999"/>
              <a:ext cx="5144674" cy="3867721"/>
              <a:chOff x="0" y="0"/>
              <a:chExt cx="4955438" cy="3867719"/>
            </a:xfrm>
          </p:grpSpPr>
          <p:sp>
            <p:nvSpPr>
              <p:cNvPr id="94" name="Straight Connector 41"/>
              <p:cNvSpPr/>
              <p:nvPr/>
            </p:nvSpPr>
            <p:spPr>
              <a:xfrm>
                <a:off x="2398391" y="2059605"/>
                <a:ext cx="1027" cy="293785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tailEnd type="triangle" w="med" len="med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grpSp>
            <p:nvGrpSpPr>
              <p:cNvPr id="113" name="Group 4108"/>
              <p:cNvGrpSpPr/>
              <p:nvPr/>
            </p:nvGrpSpPr>
            <p:grpSpPr>
              <a:xfrm>
                <a:off x="0" y="2907290"/>
                <a:ext cx="4950181" cy="276996"/>
                <a:chOff x="0" y="-25004"/>
                <a:chExt cx="4950180" cy="276994"/>
              </a:xfrm>
            </p:grpSpPr>
            <p:grpSp>
              <p:nvGrpSpPr>
                <p:cNvPr id="97" name="Oval 48"/>
                <p:cNvGrpSpPr/>
                <p:nvPr/>
              </p:nvGrpSpPr>
              <p:grpSpPr>
                <a:xfrm>
                  <a:off x="872869" y="-25004"/>
                  <a:ext cx="585834" cy="276994"/>
                  <a:chOff x="0" y="-25003"/>
                  <a:chExt cx="585833" cy="276992"/>
                </a:xfrm>
              </p:grpSpPr>
              <p:sp>
                <p:nvSpPr>
                  <p:cNvPr id="95" name="Oval"/>
                  <p:cNvSpPr/>
                  <p:nvPr/>
                </p:nvSpPr>
                <p:spPr>
                  <a:xfrm>
                    <a:off x="0" y="13143"/>
                    <a:ext cx="585833" cy="200701"/>
                  </a:xfrm>
                  <a:prstGeom prst="ellipse">
                    <a:avLst/>
                  </a:prstGeom>
                  <a:solidFill>
                    <a:srgbClr val="FF0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96" name="127"/>
                  <p:cNvSpPr txBox="1"/>
                  <p:nvPr/>
                </p:nvSpPr>
                <p:spPr>
                  <a:xfrm>
                    <a:off x="137862" y="-25003"/>
                    <a:ext cx="359062" cy="276992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  <a:extLst>
                    <a:ext uri="{C572A759-6A51-4108-AA02-DFA0A04FC94B}">
  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  </a:ext>
                  </a:extLst>
                </p:spPr>
                <p:txBody>
                  <a:bodyPr wrap="square" lIns="45719" tIns="45719" rIns="45719" bIns="45719" numCol="1" anchor="ctr">
                    <a:spAutoFit/>
                  </a:bodyPr>
                  <a:lstStyle>
                    <a:lvl1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lvl1pPr>
                  </a:lstStyle>
                  <a:p>
                    <a:r>
                      <a:rPr sz="1200" dirty="0"/>
                      <a:t>127</a:t>
                    </a:r>
                  </a:p>
                </p:txBody>
              </p:sp>
            </p:grpSp>
            <p:grpSp>
              <p:nvGrpSpPr>
                <p:cNvPr id="100" name="Oval 46"/>
                <p:cNvGrpSpPr/>
                <p:nvPr/>
              </p:nvGrpSpPr>
              <p:grpSpPr>
                <a:xfrm>
                  <a:off x="1745738" y="-25004"/>
                  <a:ext cx="585834" cy="276994"/>
                  <a:chOff x="0" y="-25003"/>
                  <a:chExt cx="585833" cy="276992"/>
                </a:xfrm>
              </p:grpSpPr>
              <p:sp>
                <p:nvSpPr>
                  <p:cNvPr id="98" name="Oval"/>
                  <p:cNvSpPr/>
                  <p:nvPr/>
                </p:nvSpPr>
                <p:spPr>
                  <a:xfrm>
                    <a:off x="0" y="13143"/>
                    <a:ext cx="585833" cy="200701"/>
                  </a:xfrm>
                  <a:prstGeom prst="ellipse">
                    <a:avLst/>
                  </a:prstGeom>
                  <a:solidFill>
                    <a:srgbClr val="0070C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99" name="128"/>
                  <p:cNvSpPr txBox="1"/>
                  <p:nvPr/>
                </p:nvSpPr>
                <p:spPr>
                  <a:xfrm>
                    <a:off x="137863" y="-25003"/>
                    <a:ext cx="345952" cy="276992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  <a:extLst>
                    <a:ext uri="{C572A759-6A51-4108-AA02-DFA0A04FC94B}">
  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  </a:ext>
                  </a:extLst>
                </p:spPr>
                <p:txBody>
                  <a:bodyPr wrap="square" lIns="45719" tIns="45719" rIns="45719" bIns="45719" numCol="1" anchor="ctr">
                    <a:spAutoFit/>
                  </a:bodyPr>
                  <a:lstStyle>
                    <a:lvl1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lvl1pPr>
                  </a:lstStyle>
                  <a:p>
                    <a:r>
                      <a:rPr sz="1200" dirty="0"/>
                      <a:t>128</a:t>
                    </a:r>
                  </a:p>
                </p:txBody>
              </p:sp>
            </p:grpSp>
            <p:grpSp>
              <p:nvGrpSpPr>
                <p:cNvPr id="103" name="Oval 44"/>
                <p:cNvGrpSpPr/>
                <p:nvPr/>
              </p:nvGrpSpPr>
              <p:grpSpPr>
                <a:xfrm>
                  <a:off x="2618607" y="-25004"/>
                  <a:ext cx="585834" cy="276994"/>
                  <a:chOff x="0" y="-25003"/>
                  <a:chExt cx="585833" cy="276992"/>
                </a:xfrm>
              </p:grpSpPr>
              <p:sp>
                <p:nvSpPr>
                  <p:cNvPr id="101" name="Oval"/>
                  <p:cNvSpPr/>
                  <p:nvPr/>
                </p:nvSpPr>
                <p:spPr>
                  <a:xfrm>
                    <a:off x="0" y="13143"/>
                    <a:ext cx="585833" cy="200701"/>
                  </a:xfrm>
                  <a:prstGeom prst="ellipse">
                    <a:avLst/>
                  </a:prstGeom>
                  <a:solidFill>
                    <a:srgbClr val="9933FF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02" name="129"/>
                  <p:cNvSpPr txBox="1"/>
                  <p:nvPr/>
                </p:nvSpPr>
                <p:spPr>
                  <a:xfrm>
                    <a:off x="137863" y="-25003"/>
                    <a:ext cx="419555" cy="276992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  <a:extLst>
                    <a:ext uri="{C572A759-6A51-4108-AA02-DFA0A04FC94B}">
  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  </a:ext>
                  </a:extLst>
                </p:spPr>
                <p:txBody>
                  <a:bodyPr wrap="square" lIns="45719" tIns="45719" rIns="45719" bIns="45719" numCol="1" anchor="ctr">
                    <a:spAutoFit/>
                  </a:bodyPr>
                  <a:lstStyle>
                    <a:lvl1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lvl1pPr>
                  </a:lstStyle>
                  <a:p>
                    <a:r>
                      <a:rPr sz="1200" dirty="0"/>
                      <a:t>129</a:t>
                    </a:r>
                  </a:p>
                </p:txBody>
              </p:sp>
            </p:grpSp>
            <p:grpSp>
              <p:nvGrpSpPr>
                <p:cNvPr id="106" name="Oval 42"/>
                <p:cNvGrpSpPr/>
                <p:nvPr/>
              </p:nvGrpSpPr>
              <p:grpSpPr>
                <a:xfrm>
                  <a:off x="4364346" y="-25004"/>
                  <a:ext cx="585834" cy="276994"/>
                  <a:chOff x="0" y="-25003"/>
                  <a:chExt cx="585833" cy="276992"/>
                </a:xfrm>
              </p:grpSpPr>
              <p:sp>
                <p:nvSpPr>
                  <p:cNvPr id="104" name="Oval"/>
                  <p:cNvSpPr/>
                  <p:nvPr/>
                </p:nvSpPr>
                <p:spPr>
                  <a:xfrm>
                    <a:off x="0" y="13143"/>
                    <a:ext cx="585833" cy="200701"/>
                  </a:xfrm>
                  <a:prstGeom prst="ellipse">
                    <a:avLst/>
                  </a:prstGeom>
                  <a:solidFill>
                    <a:srgbClr val="00B05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05" name="131"/>
                  <p:cNvSpPr txBox="1"/>
                  <p:nvPr/>
                </p:nvSpPr>
                <p:spPr>
                  <a:xfrm>
                    <a:off x="137862" y="-25003"/>
                    <a:ext cx="371380" cy="276992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  <a:extLst>
                    <a:ext uri="{C572A759-6A51-4108-AA02-DFA0A04FC94B}">
  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  </a:ext>
                  </a:extLst>
                </p:spPr>
                <p:txBody>
                  <a:bodyPr wrap="square" lIns="45719" tIns="45719" rIns="45719" bIns="45719" numCol="1" anchor="ctr">
                    <a:spAutoFit/>
                  </a:bodyPr>
                  <a:lstStyle>
                    <a:lvl1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lvl1pPr>
                  </a:lstStyle>
                  <a:p>
                    <a:r>
                      <a:rPr sz="1200" dirty="0"/>
                      <a:t>131</a:t>
                    </a:r>
                  </a:p>
                </p:txBody>
              </p:sp>
            </p:grpSp>
            <p:grpSp>
              <p:nvGrpSpPr>
                <p:cNvPr id="109" name="Oval 40"/>
                <p:cNvGrpSpPr/>
                <p:nvPr/>
              </p:nvGrpSpPr>
              <p:grpSpPr>
                <a:xfrm>
                  <a:off x="3491476" y="-25004"/>
                  <a:ext cx="585834" cy="276994"/>
                  <a:chOff x="0" y="-25003"/>
                  <a:chExt cx="585833" cy="276992"/>
                </a:xfrm>
              </p:grpSpPr>
              <p:sp>
                <p:nvSpPr>
                  <p:cNvPr id="107" name="Oval"/>
                  <p:cNvSpPr/>
                  <p:nvPr/>
                </p:nvSpPr>
                <p:spPr>
                  <a:xfrm>
                    <a:off x="0" y="13143"/>
                    <a:ext cx="585833" cy="200701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08" name="130"/>
                  <p:cNvSpPr txBox="1"/>
                  <p:nvPr/>
                </p:nvSpPr>
                <p:spPr>
                  <a:xfrm>
                    <a:off x="137862" y="-25003"/>
                    <a:ext cx="371640" cy="276992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  <a:extLst>
                    <a:ext uri="{C572A759-6A51-4108-AA02-DFA0A04FC94B}">
  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  </a:ext>
                  </a:extLst>
                </p:spPr>
                <p:txBody>
                  <a:bodyPr wrap="square" lIns="45719" tIns="45719" rIns="45719" bIns="45719" numCol="1" anchor="ctr">
                    <a:spAutoFit/>
                  </a:bodyPr>
                  <a:lstStyle>
                    <a:lvl1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lvl1pPr>
                  </a:lstStyle>
                  <a:p>
                    <a:r>
                      <a:rPr sz="1200" dirty="0"/>
                      <a:t>130</a:t>
                    </a:r>
                  </a:p>
                </p:txBody>
              </p:sp>
            </p:grpSp>
            <p:grpSp>
              <p:nvGrpSpPr>
                <p:cNvPr id="112" name="Oval 38"/>
                <p:cNvGrpSpPr/>
                <p:nvPr/>
              </p:nvGrpSpPr>
              <p:grpSpPr>
                <a:xfrm>
                  <a:off x="0" y="-25004"/>
                  <a:ext cx="585834" cy="276994"/>
                  <a:chOff x="0" y="-25003"/>
                  <a:chExt cx="585833" cy="276992"/>
                </a:xfrm>
              </p:grpSpPr>
              <p:sp>
                <p:nvSpPr>
                  <p:cNvPr id="110" name="Oval"/>
                  <p:cNvSpPr/>
                  <p:nvPr/>
                </p:nvSpPr>
                <p:spPr>
                  <a:xfrm>
                    <a:off x="0" y="13143"/>
                    <a:ext cx="585833" cy="200701"/>
                  </a:xfrm>
                  <a:prstGeom prst="ellipse">
                    <a:avLst/>
                  </a:prstGeom>
                  <a:solidFill>
                    <a:srgbClr val="FFFF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11" name="126"/>
                  <p:cNvSpPr txBox="1"/>
                  <p:nvPr/>
                </p:nvSpPr>
                <p:spPr>
                  <a:xfrm>
                    <a:off x="137863" y="-25003"/>
                    <a:ext cx="337534" cy="276992"/>
                  </a:xfrm>
                  <a:prstGeom prst="rect">
                    <a:avLst/>
                  </a:prstGeom>
                  <a:noFill/>
                  <a:ln w="12700" cap="flat">
                    <a:noFill/>
                    <a:miter lim="400000"/>
                  </a:ln>
                  <a:effectLst/>
                  <a:extLst>
                    <a:ext uri="{C572A759-6A51-4108-AA02-DFA0A04FC94B}">
  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  </a:ext>
                  </a:extLst>
                </p:spPr>
                <p:txBody>
                  <a:bodyPr wrap="square" lIns="45719" tIns="45719" rIns="45719" bIns="45719" numCol="1" anchor="ctr">
                    <a:spAutoFit/>
                  </a:bodyPr>
                  <a:lstStyle>
                    <a:lvl1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lvl1pPr>
                  </a:lstStyle>
                  <a:p>
                    <a:r>
                      <a:rPr sz="1200" dirty="0"/>
                      <a:t>126</a:t>
                    </a:r>
                  </a:p>
                </p:txBody>
              </p:sp>
            </p:grpSp>
          </p:grpSp>
          <p:sp>
            <p:nvSpPr>
              <p:cNvPr id="114" name="TextBox 229"/>
              <p:cNvSpPr txBox="1"/>
              <p:nvPr/>
            </p:nvSpPr>
            <p:spPr>
              <a:xfrm>
                <a:off x="2459534" y="2059451"/>
                <a:ext cx="1482092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sz="1200" dirty="0"/>
                  <a:t>TMT </a:t>
                </a:r>
                <a:r>
                  <a:rPr lang="en-US" sz="1200" dirty="0"/>
                  <a:t>l</a:t>
                </a:r>
                <a:r>
                  <a:rPr sz="1200" dirty="0"/>
                  <a:t>abel</a:t>
                </a:r>
                <a:r>
                  <a:rPr lang="en-US" sz="1200" dirty="0"/>
                  <a:t>ing</a:t>
                </a:r>
                <a:r>
                  <a:rPr sz="1200" dirty="0"/>
                  <a:t> (6-plex)</a:t>
                </a:r>
              </a:p>
            </p:txBody>
          </p:sp>
          <p:sp>
            <p:nvSpPr>
              <p:cNvPr id="115" name="TextBox 172"/>
              <p:cNvSpPr txBox="1"/>
              <p:nvPr/>
            </p:nvSpPr>
            <p:spPr>
              <a:xfrm>
                <a:off x="168622" y="4878"/>
                <a:ext cx="287897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sz="1200"/>
                  <a:t>C1</a:t>
                </a:r>
              </a:p>
            </p:txBody>
          </p:sp>
          <p:sp>
            <p:nvSpPr>
              <p:cNvPr id="116" name="TextBox 330"/>
              <p:cNvSpPr txBox="1"/>
              <p:nvPr/>
            </p:nvSpPr>
            <p:spPr>
              <a:xfrm>
                <a:off x="1011153" y="0"/>
                <a:ext cx="287898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 algn="ctr">
                  <a:defRPr sz="10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lang="en-US" sz="1200" dirty="0"/>
                  <a:t>C2</a:t>
                </a:r>
                <a:endParaRPr sz="1200" dirty="0"/>
              </a:p>
            </p:txBody>
          </p:sp>
          <p:sp>
            <p:nvSpPr>
              <p:cNvPr id="117" name="TextBox 336"/>
              <p:cNvSpPr txBox="1"/>
              <p:nvPr/>
            </p:nvSpPr>
            <p:spPr>
              <a:xfrm>
                <a:off x="1884852" y="4878"/>
                <a:ext cx="287897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sz="1200" dirty="0"/>
                  <a:t>C</a:t>
                </a:r>
                <a:r>
                  <a:rPr lang="en-US" sz="1200" dirty="0"/>
                  <a:t>3</a:t>
                </a:r>
                <a:endParaRPr sz="1200" dirty="0"/>
              </a:p>
            </p:txBody>
          </p:sp>
          <p:sp>
            <p:nvSpPr>
              <p:cNvPr id="118" name="TextBox 342"/>
              <p:cNvSpPr txBox="1"/>
              <p:nvPr/>
            </p:nvSpPr>
            <p:spPr>
              <a:xfrm>
                <a:off x="2700487" y="4878"/>
                <a:ext cx="392093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sz="1200" dirty="0"/>
                  <a:t>TG</a:t>
                </a:r>
                <a:r>
                  <a:rPr lang="en-US" sz="1200" dirty="0"/>
                  <a:t>1</a:t>
                </a:r>
                <a:endParaRPr sz="1200" dirty="0"/>
              </a:p>
            </p:txBody>
          </p:sp>
          <p:sp>
            <p:nvSpPr>
              <p:cNvPr id="119" name="TextBox 348"/>
              <p:cNvSpPr txBox="1"/>
              <p:nvPr/>
            </p:nvSpPr>
            <p:spPr>
              <a:xfrm>
                <a:off x="3601082" y="4878"/>
                <a:ext cx="392093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lang="en-US" sz="1200" dirty="0"/>
                  <a:t>TG2</a:t>
                </a:r>
                <a:endParaRPr sz="1200" dirty="0"/>
              </a:p>
            </p:txBody>
          </p:sp>
          <p:sp>
            <p:nvSpPr>
              <p:cNvPr id="120" name="TextBox 354"/>
              <p:cNvSpPr txBox="1"/>
              <p:nvPr/>
            </p:nvSpPr>
            <p:spPr>
              <a:xfrm>
                <a:off x="4416719" y="4878"/>
                <a:ext cx="392093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sz="1200" dirty="0"/>
                  <a:t>T</a:t>
                </a:r>
                <a:r>
                  <a:rPr lang="en-US" sz="1200" dirty="0"/>
                  <a:t>G3</a:t>
                </a:r>
                <a:endParaRPr sz="1200" dirty="0"/>
              </a:p>
            </p:txBody>
          </p:sp>
          <p:sp>
            <p:nvSpPr>
              <p:cNvPr id="121" name="Straight Connector 359"/>
              <p:cNvSpPr/>
              <p:nvPr/>
            </p:nvSpPr>
            <p:spPr>
              <a:xfrm>
                <a:off x="2403116" y="1099753"/>
                <a:ext cx="1027" cy="293785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tailEnd type="triangle" w="med" len="med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122" name="Straight Connector 360"/>
              <p:cNvSpPr/>
              <p:nvPr/>
            </p:nvSpPr>
            <p:spPr>
              <a:xfrm>
                <a:off x="2397365" y="289131"/>
                <a:ext cx="1027" cy="293785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tailEnd type="triangle" w="med" len="med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123" name="TextBox 361"/>
              <p:cNvSpPr txBox="1"/>
              <p:nvPr/>
            </p:nvSpPr>
            <p:spPr>
              <a:xfrm>
                <a:off x="2471810" y="1147316"/>
                <a:ext cx="1199778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sz="1200" dirty="0"/>
                  <a:t>Trypsin</a:t>
                </a:r>
                <a:r>
                  <a:rPr lang="en-US" sz="1200" dirty="0"/>
                  <a:t> digestion</a:t>
                </a:r>
                <a:endParaRPr sz="1200" dirty="0"/>
              </a:p>
            </p:txBody>
          </p:sp>
          <p:sp>
            <p:nvSpPr>
              <p:cNvPr id="124" name="TextBox 362"/>
              <p:cNvSpPr txBox="1"/>
              <p:nvPr/>
            </p:nvSpPr>
            <p:spPr>
              <a:xfrm>
                <a:off x="2497190" y="338790"/>
                <a:ext cx="1642919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lang="en-US" sz="1200" dirty="0"/>
                  <a:t>Tissue homogenization </a:t>
                </a:r>
                <a:endParaRPr sz="1200" dirty="0"/>
              </a:p>
            </p:txBody>
          </p:sp>
          <p:sp>
            <p:nvSpPr>
              <p:cNvPr id="125" name="Freeform 23"/>
              <p:cNvSpPr/>
              <p:nvPr/>
            </p:nvSpPr>
            <p:spPr>
              <a:xfrm>
                <a:off x="110435" y="644473"/>
                <a:ext cx="364963" cy="332394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522" h="20854" extrusionOk="0">
                    <a:moveTo>
                      <a:pt x="8278" y="2234"/>
                    </a:moveTo>
                    <a:cubicBezTo>
                      <a:pt x="7883" y="3073"/>
                      <a:pt x="7584" y="3970"/>
                      <a:pt x="7095" y="4751"/>
                    </a:cubicBezTo>
                    <a:cubicBezTo>
                      <a:pt x="6937" y="5002"/>
                      <a:pt x="6823" y="5292"/>
                      <a:pt x="6622" y="5505"/>
                    </a:cubicBezTo>
                    <a:cubicBezTo>
                      <a:pt x="6421" y="5719"/>
                      <a:pt x="6125" y="5808"/>
                      <a:pt x="5913" y="6009"/>
                    </a:cubicBezTo>
                    <a:cubicBezTo>
                      <a:pt x="5413" y="6481"/>
                      <a:pt x="5115" y="7254"/>
                      <a:pt x="4494" y="7518"/>
                    </a:cubicBezTo>
                    <a:cubicBezTo>
                      <a:pt x="3080" y="8120"/>
                      <a:pt x="3714" y="7879"/>
                      <a:pt x="2602" y="8273"/>
                    </a:cubicBezTo>
                    <a:cubicBezTo>
                      <a:pt x="920" y="8049"/>
                      <a:pt x="842" y="8555"/>
                      <a:pt x="237" y="7267"/>
                    </a:cubicBezTo>
                    <a:cubicBezTo>
                      <a:pt x="125" y="7029"/>
                      <a:pt x="79" y="6763"/>
                      <a:pt x="0" y="6512"/>
                    </a:cubicBezTo>
                    <a:cubicBezTo>
                      <a:pt x="79" y="6092"/>
                      <a:pt x="57" y="5636"/>
                      <a:pt x="237" y="5254"/>
                    </a:cubicBezTo>
                    <a:cubicBezTo>
                      <a:pt x="850" y="3948"/>
                      <a:pt x="1651" y="4593"/>
                      <a:pt x="2838" y="4751"/>
                    </a:cubicBezTo>
                    <a:cubicBezTo>
                      <a:pt x="3048" y="5421"/>
                      <a:pt x="3075" y="5883"/>
                      <a:pt x="3784" y="6260"/>
                    </a:cubicBezTo>
                    <a:cubicBezTo>
                      <a:pt x="4144" y="6451"/>
                      <a:pt x="4567" y="6462"/>
                      <a:pt x="4967" y="6512"/>
                    </a:cubicBezTo>
                    <a:cubicBezTo>
                      <a:pt x="5909" y="6630"/>
                      <a:pt x="6859" y="6680"/>
                      <a:pt x="7805" y="6763"/>
                    </a:cubicBezTo>
                    <a:cubicBezTo>
                      <a:pt x="8277" y="6680"/>
                      <a:pt x="8785" y="6719"/>
                      <a:pt x="9224" y="6512"/>
                    </a:cubicBezTo>
                    <a:cubicBezTo>
                      <a:pt x="9529" y="6367"/>
                      <a:pt x="9661" y="5964"/>
                      <a:pt x="9933" y="5757"/>
                    </a:cubicBezTo>
                    <a:cubicBezTo>
                      <a:pt x="10220" y="5539"/>
                      <a:pt x="10552" y="5393"/>
                      <a:pt x="10879" y="5254"/>
                    </a:cubicBezTo>
                    <a:cubicBezTo>
                      <a:pt x="12285" y="4655"/>
                      <a:pt x="12024" y="4870"/>
                      <a:pt x="13244" y="4499"/>
                    </a:cubicBezTo>
                    <a:cubicBezTo>
                      <a:pt x="13484" y="4426"/>
                      <a:pt x="13717" y="4331"/>
                      <a:pt x="13954" y="4247"/>
                    </a:cubicBezTo>
                    <a:cubicBezTo>
                      <a:pt x="14190" y="3996"/>
                      <a:pt x="14501" y="3804"/>
                      <a:pt x="14663" y="3492"/>
                    </a:cubicBezTo>
                    <a:cubicBezTo>
                      <a:pt x="14905" y="3029"/>
                      <a:pt x="15136" y="1983"/>
                      <a:pt x="15136" y="1983"/>
                    </a:cubicBezTo>
                    <a:cubicBezTo>
                      <a:pt x="14978" y="1647"/>
                      <a:pt x="14838" y="1302"/>
                      <a:pt x="14663" y="976"/>
                    </a:cubicBezTo>
                    <a:cubicBezTo>
                      <a:pt x="13763" y="-700"/>
                      <a:pt x="13957" y="241"/>
                      <a:pt x="11116" y="473"/>
                    </a:cubicBezTo>
                    <a:cubicBezTo>
                      <a:pt x="11037" y="725"/>
                      <a:pt x="11017" y="1007"/>
                      <a:pt x="10879" y="1228"/>
                    </a:cubicBezTo>
                    <a:cubicBezTo>
                      <a:pt x="10694" y="1524"/>
                      <a:pt x="10384" y="1709"/>
                      <a:pt x="10170" y="1983"/>
                    </a:cubicBezTo>
                    <a:cubicBezTo>
                      <a:pt x="9988" y="2215"/>
                      <a:pt x="9854" y="2486"/>
                      <a:pt x="9697" y="2738"/>
                    </a:cubicBezTo>
                    <a:cubicBezTo>
                      <a:pt x="9775" y="3660"/>
                      <a:pt x="9818" y="4587"/>
                      <a:pt x="9933" y="5505"/>
                    </a:cubicBezTo>
                    <a:cubicBezTo>
                      <a:pt x="9999" y="6032"/>
                      <a:pt x="10244" y="6749"/>
                      <a:pt x="10406" y="7267"/>
                    </a:cubicBezTo>
                    <a:cubicBezTo>
                      <a:pt x="10327" y="8441"/>
                      <a:pt x="10342" y="9626"/>
                      <a:pt x="10170" y="10789"/>
                    </a:cubicBezTo>
                    <a:cubicBezTo>
                      <a:pt x="10085" y="11360"/>
                      <a:pt x="9601" y="12320"/>
                      <a:pt x="9224" y="12802"/>
                    </a:cubicBezTo>
                    <a:cubicBezTo>
                      <a:pt x="9009" y="13075"/>
                      <a:pt x="8728" y="13284"/>
                      <a:pt x="8514" y="13557"/>
                    </a:cubicBezTo>
                    <a:cubicBezTo>
                      <a:pt x="8332" y="13789"/>
                      <a:pt x="8272" y="14136"/>
                      <a:pt x="8041" y="14312"/>
                    </a:cubicBezTo>
                    <a:cubicBezTo>
                      <a:pt x="7696" y="14574"/>
                      <a:pt x="7246" y="14631"/>
                      <a:pt x="6859" y="14815"/>
                    </a:cubicBezTo>
                    <a:cubicBezTo>
                      <a:pt x="5268" y="15567"/>
                      <a:pt x="6580" y="15140"/>
                      <a:pt x="4967" y="15570"/>
                    </a:cubicBezTo>
                    <a:cubicBezTo>
                      <a:pt x="3666" y="15454"/>
                      <a:pt x="2373" y="15830"/>
                      <a:pt x="1419" y="14815"/>
                    </a:cubicBezTo>
                    <a:cubicBezTo>
                      <a:pt x="1218" y="14601"/>
                      <a:pt x="1104" y="14312"/>
                      <a:pt x="946" y="14060"/>
                    </a:cubicBezTo>
                    <a:cubicBezTo>
                      <a:pt x="1025" y="13389"/>
                      <a:pt x="924" y="12665"/>
                      <a:pt x="1183" y="12047"/>
                    </a:cubicBezTo>
                    <a:cubicBezTo>
                      <a:pt x="1284" y="11805"/>
                      <a:pt x="1643" y="11796"/>
                      <a:pt x="1892" y="11796"/>
                    </a:cubicBezTo>
                    <a:cubicBezTo>
                      <a:pt x="2449" y="11796"/>
                      <a:pt x="2996" y="11963"/>
                      <a:pt x="3548" y="12047"/>
                    </a:cubicBezTo>
                    <a:cubicBezTo>
                      <a:pt x="3705" y="12383"/>
                      <a:pt x="3846" y="12728"/>
                      <a:pt x="4021" y="13054"/>
                    </a:cubicBezTo>
                    <a:cubicBezTo>
                      <a:pt x="4162" y="13316"/>
                      <a:pt x="4382" y="13531"/>
                      <a:pt x="4494" y="13808"/>
                    </a:cubicBezTo>
                    <a:cubicBezTo>
                      <a:pt x="4622" y="14126"/>
                      <a:pt x="4651" y="14479"/>
                      <a:pt x="4730" y="14815"/>
                    </a:cubicBezTo>
                    <a:cubicBezTo>
                      <a:pt x="4888" y="16325"/>
                      <a:pt x="4715" y="17916"/>
                      <a:pt x="5203" y="19344"/>
                    </a:cubicBezTo>
                    <a:cubicBezTo>
                      <a:pt x="5379" y="19859"/>
                      <a:pt x="6719" y="20439"/>
                      <a:pt x="7332" y="20602"/>
                    </a:cubicBezTo>
                    <a:cubicBezTo>
                      <a:pt x="7721" y="20706"/>
                      <a:pt x="8120" y="20770"/>
                      <a:pt x="8514" y="20854"/>
                    </a:cubicBezTo>
                    <a:cubicBezTo>
                      <a:pt x="9775" y="20770"/>
                      <a:pt x="11066" y="20900"/>
                      <a:pt x="12298" y="20602"/>
                    </a:cubicBezTo>
                    <a:cubicBezTo>
                      <a:pt x="12852" y="20468"/>
                      <a:pt x="13244" y="19931"/>
                      <a:pt x="13717" y="19596"/>
                    </a:cubicBezTo>
                    <a:cubicBezTo>
                      <a:pt x="14120" y="19310"/>
                      <a:pt x="15079" y="18649"/>
                      <a:pt x="15373" y="18337"/>
                    </a:cubicBezTo>
                    <a:cubicBezTo>
                      <a:pt x="15651" y="18041"/>
                      <a:pt x="15863" y="17680"/>
                      <a:pt x="16082" y="17331"/>
                    </a:cubicBezTo>
                    <a:cubicBezTo>
                      <a:pt x="16337" y="16924"/>
                      <a:pt x="16574" y="16504"/>
                      <a:pt x="16792" y="16073"/>
                    </a:cubicBezTo>
                    <a:cubicBezTo>
                      <a:pt x="17126" y="15412"/>
                      <a:pt x="17346" y="14684"/>
                      <a:pt x="17738" y="14060"/>
                    </a:cubicBezTo>
                    <a:lnTo>
                      <a:pt x="18211" y="13305"/>
                    </a:lnTo>
                    <a:cubicBezTo>
                      <a:pt x="18558" y="11829"/>
                      <a:pt x="19343" y="10102"/>
                      <a:pt x="18684" y="8525"/>
                    </a:cubicBezTo>
                    <a:cubicBezTo>
                      <a:pt x="18568" y="8248"/>
                      <a:pt x="18211" y="8189"/>
                      <a:pt x="17974" y="8021"/>
                    </a:cubicBezTo>
                    <a:cubicBezTo>
                      <a:pt x="16338" y="8215"/>
                      <a:pt x="15766" y="7805"/>
                      <a:pt x="14900" y="9280"/>
                    </a:cubicBezTo>
                    <a:cubicBezTo>
                      <a:pt x="14727" y="9573"/>
                      <a:pt x="14742" y="9950"/>
                      <a:pt x="14663" y="10286"/>
                    </a:cubicBezTo>
                    <a:cubicBezTo>
                      <a:pt x="14742" y="10873"/>
                      <a:pt x="14629" y="11529"/>
                      <a:pt x="14900" y="12047"/>
                    </a:cubicBezTo>
                    <a:cubicBezTo>
                      <a:pt x="15071" y="12375"/>
                      <a:pt x="15493" y="12550"/>
                      <a:pt x="15846" y="12550"/>
                    </a:cubicBezTo>
                    <a:cubicBezTo>
                      <a:pt x="16882" y="12550"/>
                      <a:pt x="17895" y="12215"/>
                      <a:pt x="18920" y="12047"/>
                    </a:cubicBezTo>
                    <a:cubicBezTo>
                      <a:pt x="19157" y="11879"/>
                      <a:pt x="19429" y="11758"/>
                      <a:pt x="19630" y="11544"/>
                    </a:cubicBezTo>
                    <a:cubicBezTo>
                      <a:pt x="19964" y="11188"/>
                      <a:pt x="20390" y="10177"/>
                      <a:pt x="20576" y="9783"/>
                    </a:cubicBezTo>
                    <a:cubicBezTo>
                      <a:pt x="20497" y="7854"/>
                      <a:pt x="20626" y="5902"/>
                      <a:pt x="20339" y="3996"/>
                    </a:cubicBezTo>
                    <a:cubicBezTo>
                      <a:pt x="20294" y="3697"/>
                      <a:pt x="19913" y="3520"/>
                      <a:pt x="19630" y="3492"/>
                    </a:cubicBezTo>
                    <a:cubicBezTo>
                      <a:pt x="18997" y="3431"/>
                      <a:pt x="18368" y="3660"/>
                      <a:pt x="17738" y="3744"/>
                    </a:cubicBezTo>
                    <a:cubicBezTo>
                      <a:pt x="17580" y="3996"/>
                      <a:pt x="17442" y="4263"/>
                      <a:pt x="17265" y="4499"/>
                    </a:cubicBezTo>
                    <a:cubicBezTo>
                      <a:pt x="17125" y="4684"/>
                      <a:pt x="16634" y="4834"/>
                      <a:pt x="16792" y="5002"/>
                    </a:cubicBezTo>
                    <a:cubicBezTo>
                      <a:pt x="16983" y="5206"/>
                      <a:pt x="18728" y="5643"/>
                      <a:pt x="19157" y="5757"/>
                    </a:cubicBezTo>
                    <a:cubicBezTo>
                      <a:pt x="21600" y="5497"/>
                      <a:pt x="21522" y="6348"/>
                      <a:pt x="21522" y="5254"/>
                    </a:cubicBez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algn="ctr">
                  <a:defRPr>
                    <a:solidFill>
                      <a:srgbClr val="FFFFFF"/>
                    </a:solidFill>
                  </a:defRPr>
                </a:pPr>
                <a:endParaRPr sz="1200"/>
              </a:p>
            </p:txBody>
          </p:sp>
          <p:sp>
            <p:nvSpPr>
              <p:cNvPr id="126" name="Freeform 25"/>
              <p:cNvSpPr/>
              <p:nvPr/>
            </p:nvSpPr>
            <p:spPr>
              <a:xfrm>
                <a:off x="945875" y="618165"/>
                <a:ext cx="469236" cy="385011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575" h="21320" extrusionOk="0">
                    <a:moveTo>
                      <a:pt x="6823" y="5774"/>
                    </a:moveTo>
                    <a:cubicBezTo>
                      <a:pt x="6179" y="8101"/>
                      <a:pt x="6786" y="6295"/>
                      <a:pt x="6085" y="7773"/>
                    </a:cubicBezTo>
                    <a:cubicBezTo>
                      <a:pt x="5949" y="8060"/>
                      <a:pt x="5850" y="8372"/>
                      <a:pt x="5716" y="8661"/>
                    </a:cubicBezTo>
                    <a:cubicBezTo>
                      <a:pt x="5628" y="8853"/>
                      <a:pt x="5004" y="10122"/>
                      <a:pt x="4794" y="10438"/>
                    </a:cubicBezTo>
                    <a:cubicBezTo>
                      <a:pt x="4686" y="10601"/>
                      <a:pt x="4565" y="10757"/>
                      <a:pt x="4426" y="10882"/>
                    </a:cubicBezTo>
                    <a:cubicBezTo>
                      <a:pt x="4071" y="11202"/>
                      <a:pt x="3319" y="11771"/>
                      <a:pt x="3319" y="11771"/>
                    </a:cubicBezTo>
                    <a:cubicBezTo>
                      <a:pt x="2520" y="11696"/>
                      <a:pt x="1414" y="12310"/>
                      <a:pt x="922" y="11548"/>
                    </a:cubicBezTo>
                    <a:cubicBezTo>
                      <a:pt x="279" y="10553"/>
                      <a:pt x="738" y="9034"/>
                      <a:pt x="738" y="7773"/>
                    </a:cubicBezTo>
                    <a:cubicBezTo>
                      <a:pt x="738" y="6438"/>
                      <a:pt x="630" y="5063"/>
                      <a:pt x="922" y="3775"/>
                    </a:cubicBezTo>
                    <a:cubicBezTo>
                      <a:pt x="1025" y="3318"/>
                      <a:pt x="1566" y="3222"/>
                      <a:pt x="1844" y="2887"/>
                    </a:cubicBezTo>
                    <a:cubicBezTo>
                      <a:pt x="3041" y="1446"/>
                      <a:pt x="1694" y="2422"/>
                      <a:pt x="3135" y="1555"/>
                    </a:cubicBezTo>
                    <a:cubicBezTo>
                      <a:pt x="3258" y="1333"/>
                      <a:pt x="3310" y="1018"/>
                      <a:pt x="3503" y="888"/>
                    </a:cubicBezTo>
                    <a:cubicBezTo>
                      <a:pt x="3895" y="627"/>
                      <a:pt x="4374" y="628"/>
                      <a:pt x="4794" y="444"/>
                    </a:cubicBezTo>
                    <a:cubicBezTo>
                      <a:pt x="5053" y="331"/>
                      <a:pt x="5286" y="148"/>
                      <a:pt x="5532" y="0"/>
                    </a:cubicBezTo>
                    <a:cubicBezTo>
                      <a:pt x="6577" y="74"/>
                      <a:pt x="7625" y="97"/>
                      <a:pt x="8667" y="222"/>
                    </a:cubicBezTo>
                    <a:cubicBezTo>
                      <a:pt x="8860" y="245"/>
                      <a:pt x="9050" y="330"/>
                      <a:pt x="9220" y="444"/>
                    </a:cubicBezTo>
                    <a:cubicBezTo>
                      <a:pt x="9607" y="703"/>
                      <a:pt x="10326" y="1333"/>
                      <a:pt x="10326" y="1333"/>
                    </a:cubicBezTo>
                    <a:cubicBezTo>
                      <a:pt x="10449" y="1629"/>
                      <a:pt x="10587" y="1917"/>
                      <a:pt x="10695" y="2221"/>
                    </a:cubicBezTo>
                    <a:cubicBezTo>
                      <a:pt x="11353" y="4069"/>
                      <a:pt x="10839" y="6489"/>
                      <a:pt x="10695" y="8217"/>
                    </a:cubicBezTo>
                    <a:cubicBezTo>
                      <a:pt x="10656" y="8683"/>
                      <a:pt x="10601" y="9219"/>
                      <a:pt x="10326" y="9550"/>
                    </a:cubicBezTo>
                    <a:cubicBezTo>
                      <a:pt x="9196" y="10911"/>
                      <a:pt x="9420" y="10969"/>
                      <a:pt x="8298" y="11548"/>
                    </a:cubicBezTo>
                    <a:cubicBezTo>
                      <a:pt x="8119" y="11641"/>
                      <a:pt x="7929" y="11696"/>
                      <a:pt x="7745" y="11771"/>
                    </a:cubicBezTo>
                    <a:cubicBezTo>
                      <a:pt x="7622" y="11919"/>
                      <a:pt x="7549" y="12196"/>
                      <a:pt x="7376" y="12215"/>
                    </a:cubicBezTo>
                    <a:cubicBezTo>
                      <a:pt x="6104" y="12354"/>
                      <a:pt x="5888" y="12096"/>
                      <a:pt x="4979" y="11548"/>
                    </a:cubicBezTo>
                    <a:cubicBezTo>
                      <a:pt x="4540" y="9964"/>
                      <a:pt x="4698" y="10817"/>
                      <a:pt x="4979" y="7773"/>
                    </a:cubicBezTo>
                    <a:cubicBezTo>
                      <a:pt x="5007" y="7470"/>
                      <a:pt x="5023" y="7139"/>
                      <a:pt x="5163" y="6885"/>
                    </a:cubicBezTo>
                    <a:cubicBezTo>
                      <a:pt x="5286" y="6663"/>
                      <a:pt x="5532" y="6589"/>
                      <a:pt x="5716" y="6440"/>
                    </a:cubicBezTo>
                    <a:cubicBezTo>
                      <a:pt x="6700" y="6589"/>
                      <a:pt x="7688" y="6698"/>
                      <a:pt x="8667" y="6885"/>
                    </a:cubicBezTo>
                    <a:cubicBezTo>
                      <a:pt x="8859" y="6921"/>
                      <a:pt x="9031" y="7050"/>
                      <a:pt x="9220" y="7107"/>
                    </a:cubicBezTo>
                    <a:cubicBezTo>
                      <a:pt x="9571" y="7212"/>
                      <a:pt x="10500" y="7380"/>
                      <a:pt x="10879" y="7551"/>
                    </a:cubicBezTo>
                    <a:cubicBezTo>
                      <a:pt x="11137" y="7667"/>
                      <a:pt x="11371" y="7847"/>
                      <a:pt x="11617" y="7995"/>
                    </a:cubicBezTo>
                    <a:cubicBezTo>
                      <a:pt x="11863" y="8365"/>
                      <a:pt x="12056" y="8797"/>
                      <a:pt x="12355" y="9105"/>
                    </a:cubicBezTo>
                    <a:cubicBezTo>
                      <a:pt x="13740" y="10536"/>
                      <a:pt x="12091" y="7852"/>
                      <a:pt x="13277" y="9994"/>
                    </a:cubicBezTo>
                    <a:cubicBezTo>
                      <a:pt x="13215" y="11178"/>
                      <a:pt x="13195" y="12367"/>
                      <a:pt x="13092" y="13547"/>
                    </a:cubicBezTo>
                    <a:cubicBezTo>
                      <a:pt x="13072" y="13780"/>
                      <a:pt x="13045" y="14048"/>
                      <a:pt x="12908" y="14213"/>
                    </a:cubicBezTo>
                    <a:cubicBezTo>
                      <a:pt x="12473" y="14737"/>
                      <a:pt x="12016" y="15312"/>
                      <a:pt x="11433" y="15546"/>
                    </a:cubicBezTo>
                    <a:lnTo>
                      <a:pt x="10879" y="15768"/>
                    </a:lnTo>
                    <a:cubicBezTo>
                      <a:pt x="10695" y="15916"/>
                      <a:pt x="10519" y="16080"/>
                      <a:pt x="10326" y="16212"/>
                    </a:cubicBezTo>
                    <a:cubicBezTo>
                      <a:pt x="8890" y="17201"/>
                      <a:pt x="9209" y="16628"/>
                      <a:pt x="6638" y="16434"/>
                    </a:cubicBezTo>
                    <a:cubicBezTo>
                      <a:pt x="6515" y="15990"/>
                      <a:pt x="6227" y="15567"/>
                      <a:pt x="6269" y="15102"/>
                    </a:cubicBezTo>
                    <a:cubicBezTo>
                      <a:pt x="6331" y="14436"/>
                      <a:pt x="6319" y="13753"/>
                      <a:pt x="6454" y="13103"/>
                    </a:cubicBezTo>
                    <a:cubicBezTo>
                      <a:pt x="6508" y="12844"/>
                      <a:pt x="6681" y="12642"/>
                      <a:pt x="6823" y="12437"/>
                    </a:cubicBezTo>
                    <a:cubicBezTo>
                      <a:pt x="7357" y="11665"/>
                      <a:pt x="7368" y="11775"/>
                      <a:pt x="8113" y="11326"/>
                    </a:cubicBezTo>
                    <a:cubicBezTo>
                      <a:pt x="8913" y="11400"/>
                      <a:pt x="9719" y="11398"/>
                      <a:pt x="10511" y="11548"/>
                    </a:cubicBezTo>
                    <a:cubicBezTo>
                      <a:pt x="10895" y="11621"/>
                      <a:pt x="11617" y="11993"/>
                      <a:pt x="11617" y="11993"/>
                    </a:cubicBezTo>
                    <a:cubicBezTo>
                      <a:pt x="13176" y="13244"/>
                      <a:pt x="13034" y="12568"/>
                      <a:pt x="12539" y="15546"/>
                    </a:cubicBezTo>
                    <a:cubicBezTo>
                      <a:pt x="12496" y="15808"/>
                      <a:pt x="12318" y="16014"/>
                      <a:pt x="12170" y="16212"/>
                    </a:cubicBezTo>
                    <a:cubicBezTo>
                      <a:pt x="11763" y="16757"/>
                      <a:pt x="11401" y="17390"/>
                      <a:pt x="10879" y="17767"/>
                    </a:cubicBezTo>
                    <a:cubicBezTo>
                      <a:pt x="10341" y="18156"/>
                      <a:pt x="9901" y="18450"/>
                      <a:pt x="9404" y="18877"/>
                    </a:cubicBezTo>
                    <a:cubicBezTo>
                      <a:pt x="9154" y="19092"/>
                      <a:pt x="8933" y="19360"/>
                      <a:pt x="8667" y="19543"/>
                    </a:cubicBezTo>
                    <a:cubicBezTo>
                      <a:pt x="8498" y="19660"/>
                      <a:pt x="8287" y="19661"/>
                      <a:pt x="8113" y="19766"/>
                    </a:cubicBezTo>
                    <a:cubicBezTo>
                      <a:pt x="7506" y="20132"/>
                      <a:pt x="7677" y="20308"/>
                      <a:pt x="7007" y="20432"/>
                    </a:cubicBezTo>
                    <a:cubicBezTo>
                      <a:pt x="6397" y="20545"/>
                      <a:pt x="5778" y="20580"/>
                      <a:pt x="5163" y="20654"/>
                    </a:cubicBezTo>
                    <a:cubicBezTo>
                      <a:pt x="4548" y="20580"/>
                      <a:pt x="3926" y="20569"/>
                      <a:pt x="3319" y="20432"/>
                    </a:cubicBezTo>
                    <a:cubicBezTo>
                      <a:pt x="2937" y="20346"/>
                      <a:pt x="2213" y="19988"/>
                      <a:pt x="2213" y="19988"/>
                    </a:cubicBezTo>
                    <a:cubicBezTo>
                      <a:pt x="2090" y="19766"/>
                      <a:pt x="2001" y="19510"/>
                      <a:pt x="1844" y="19321"/>
                    </a:cubicBezTo>
                    <a:cubicBezTo>
                      <a:pt x="729" y="17979"/>
                      <a:pt x="1875" y="20111"/>
                      <a:pt x="553" y="17989"/>
                    </a:cubicBezTo>
                    <a:cubicBezTo>
                      <a:pt x="280" y="17550"/>
                      <a:pt x="142" y="16949"/>
                      <a:pt x="0" y="16434"/>
                    </a:cubicBezTo>
                    <a:cubicBezTo>
                      <a:pt x="61" y="15324"/>
                      <a:pt x="-6" y="14192"/>
                      <a:pt x="184" y="13103"/>
                    </a:cubicBezTo>
                    <a:cubicBezTo>
                      <a:pt x="248" y="12741"/>
                      <a:pt x="538" y="12496"/>
                      <a:pt x="738" y="12215"/>
                    </a:cubicBezTo>
                    <a:cubicBezTo>
                      <a:pt x="1290" y="11438"/>
                      <a:pt x="1146" y="11606"/>
                      <a:pt x="1844" y="11326"/>
                    </a:cubicBezTo>
                    <a:cubicBezTo>
                      <a:pt x="2950" y="11400"/>
                      <a:pt x="4066" y="11360"/>
                      <a:pt x="5163" y="11548"/>
                    </a:cubicBezTo>
                    <a:cubicBezTo>
                      <a:pt x="5383" y="11586"/>
                      <a:pt x="5518" y="11873"/>
                      <a:pt x="5716" y="11993"/>
                    </a:cubicBezTo>
                    <a:cubicBezTo>
                      <a:pt x="5890" y="12097"/>
                      <a:pt x="6085" y="12141"/>
                      <a:pt x="6269" y="12215"/>
                    </a:cubicBezTo>
                    <a:cubicBezTo>
                      <a:pt x="6567" y="13648"/>
                      <a:pt x="6615" y="13465"/>
                      <a:pt x="6269" y="15546"/>
                    </a:cubicBezTo>
                    <a:cubicBezTo>
                      <a:pt x="6216" y="15871"/>
                      <a:pt x="6009" y="16130"/>
                      <a:pt x="5901" y="16434"/>
                    </a:cubicBezTo>
                    <a:cubicBezTo>
                      <a:pt x="5824" y="16649"/>
                      <a:pt x="5813" y="16897"/>
                      <a:pt x="5716" y="17101"/>
                    </a:cubicBezTo>
                    <a:cubicBezTo>
                      <a:pt x="5564" y="17422"/>
                      <a:pt x="5393" y="17743"/>
                      <a:pt x="5163" y="17989"/>
                    </a:cubicBezTo>
                    <a:cubicBezTo>
                      <a:pt x="4832" y="18343"/>
                      <a:pt x="4057" y="18877"/>
                      <a:pt x="4057" y="18877"/>
                    </a:cubicBezTo>
                    <a:cubicBezTo>
                      <a:pt x="3934" y="18655"/>
                      <a:pt x="3708" y="18477"/>
                      <a:pt x="3688" y="18211"/>
                    </a:cubicBezTo>
                    <a:cubicBezTo>
                      <a:pt x="3611" y="17186"/>
                      <a:pt x="3727" y="16476"/>
                      <a:pt x="4241" y="15768"/>
                    </a:cubicBezTo>
                    <a:cubicBezTo>
                      <a:pt x="4527" y="15374"/>
                      <a:pt x="4741" y="14784"/>
                      <a:pt x="5163" y="14658"/>
                    </a:cubicBezTo>
                    <a:lnTo>
                      <a:pt x="5901" y="14436"/>
                    </a:lnTo>
                    <a:cubicBezTo>
                      <a:pt x="6647" y="14548"/>
                      <a:pt x="7488" y="14474"/>
                      <a:pt x="8113" y="15102"/>
                    </a:cubicBezTo>
                    <a:cubicBezTo>
                      <a:pt x="8284" y="15273"/>
                      <a:pt x="8359" y="15546"/>
                      <a:pt x="8482" y="15768"/>
                    </a:cubicBezTo>
                    <a:cubicBezTo>
                      <a:pt x="8614" y="16242"/>
                      <a:pt x="8811" y="17345"/>
                      <a:pt x="9220" y="17767"/>
                    </a:cubicBezTo>
                    <a:cubicBezTo>
                      <a:pt x="9492" y="18048"/>
                      <a:pt x="9821" y="18240"/>
                      <a:pt x="10142" y="18433"/>
                    </a:cubicBezTo>
                    <a:cubicBezTo>
                      <a:pt x="10948" y="18918"/>
                      <a:pt x="11310" y="18907"/>
                      <a:pt x="12170" y="19321"/>
                    </a:cubicBezTo>
                    <a:cubicBezTo>
                      <a:pt x="13697" y="20057"/>
                      <a:pt x="12058" y="19561"/>
                      <a:pt x="13830" y="19988"/>
                    </a:cubicBezTo>
                    <a:cubicBezTo>
                      <a:pt x="14076" y="20136"/>
                      <a:pt x="14373" y="20198"/>
                      <a:pt x="14567" y="20432"/>
                    </a:cubicBezTo>
                    <a:cubicBezTo>
                      <a:pt x="15537" y="21600"/>
                      <a:pt x="13644" y="20764"/>
                      <a:pt x="15489" y="21320"/>
                    </a:cubicBezTo>
                    <a:cubicBezTo>
                      <a:pt x="16104" y="21246"/>
                      <a:pt x="16760" y="21374"/>
                      <a:pt x="17333" y="21098"/>
                    </a:cubicBezTo>
                    <a:cubicBezTo>
                      <a:pt x="17737" y="20904"/>
                      <a:pt x="18255" y="19988"/>
                      <a:pt x="18255" y="19988"/>
                    </a:cubicBezTo>
                    <a:cubicBezTo>
                      <a:pt x="18378" y="19543"/>
                      <a:pt x="18480" y="19090"/>
                      <a:pt x="18624" y="18655"/>
                    </a:cubicBezTo>
                    <a:cubicBezTo>
                      <a:pt x="18726" y="18348"/>
                      <a:pt x="18975" y="18097"/>
                      <a:pt x="18993" y="17767"/>
                    </a:cubicBezTo>
                    <a:cubicBezTo>
                      <a:pt x="19038" y="16951"/>
                      <a:pt x="19008" y="16105"/>
                      <a:pt x="18809" y="15324"/>
                    </a:cubicBezTo>
                    <a:cubicBezTo>
                      <a:pt x="18743" y="15069"/>
                      <a:pt x="18448" y="15012"/>
                      <a:pt x="18255" y="14880"/>
                    </a:cubicBezTo>
                    <a:cubicBezTo>
                      <a:pt x="17505" y="14364"/>
                      <a:pt x="17587" y="14456"/>
                      <a:pt x="16780" y="14213"/>
                    </a:cubicBezTo>
                    <a:cubicBezTo>
                      <a:pt x="16723" y="14225"/>
                      <a:pt x="15233" y="14337"/>
                      <a:pt x="15121" y="14880"/>
                    </a:cubicBezTo>
                    <a:cubicBezTo>
                      <a:pt x="15030" y="15317"/>
                      <a:pt x="15244" y="15768"/>
                      <a:pt x="15305" y="16212"/>
                    </a:cubicBezTo>
                    <a:cubicBezTo>
                      <a:pt x="15735" y="16138"/>
                      <a:pt x="16253" y="16312"/>
                      <a:pt x="16596" y="15990"/>
                    </a:cubicBezTo>
                    <a:cubicBezTo>
                      <a:pt x="16903" y="15703"/>
                      <a:pt x="16842" y="15102"/>
                      <a:pt x="16965" y="14658"/>
                    </a:cubicBezTo>
                    <a:lnTo>
                      <a:pt x="17149" y="13991"/>
                    </a:lnTo>
                    <a:cubicBezTo>
                      <a:pt x="17088" y="12807"/>
                      <a:pt x="17068" y="11618"/>
                      <a:pt x="16965" y="10438"/>
                    </a:cubicBezTo>
                    <a:cubicBezTo>
                      <a:pt x="16944" y="10205"/>
                      <a:pt x="16877" y="9975"/>
                      <a:pt x="16780" y="9772"/>
                    </a:cubicBezTo>
                    <a:cubicBezTo>
                      <a:pt x="16628" y="9450"/>
                      <a:pt x="16411" y="9179"/>
                      <a:pt x="16227" y="8883"/>
                    </a:cubicBezTo>
                    <a:cubicBezTo>
                      <a:pt x="16166" y="8661"/>
                      <a:pt x="16164" y="8400"/>
                      <a:pt x="16043" y="8217"/>
                    </a:cubicBezTo>
                    <a:cubicBezTo>
                      <a:pt x="15783" y="7826"/>
                      <a:pt x="15301" y="7697"/>
                      <a:pt x="14936" y="7551"/>
                    </a:cubicBezTo>
                    <a:cubicBezTo>
                      <a:pt x="14629" y="7625"/>
                      <a:pt x="14275" y="7564"/>
                      <a:pt x="14014" y="7773"/>
                    </a:cubicBezTo>
                    <a:cubicBezTo>
                      <a:pt x="13648" y="8067"/>
                      <a:pt x="13925" y="9388"/>
                      <a:pt x="14014" y="9550"/>
                    </a:cubicBezTo>
                    <a:cubicBezTo>
                      <a:pt x="14122" y="9744"/>
                      <a:pt x="14383" y="9698"/>
                      <a:pt x="14567" y="9772"/>
                    </a:cubicBezTo>
                    <a:cubicBezTo>
                      <a:pt x="14875" y="9698"/>
                      <a:pt x="15196" y="9682"/>
                      <a:pt x="15489" y="9550"/>
                    </a:cubicBezTo>
                    <a:cubicBezTo>
                      <a:pt x="15943" y="9345"/>
                      <a:pt x="16203" y="8940"/>
                      <a:pt x="16411" y="8439"/>
                    </a:cubicBezTo>
                    <a:cubicBezTo>
                      <a:pt x="16544" y="8120"/>
                      <a:pt x="16721" y="7169"/>
                      <a:pt x="16780" y="6885"/>
                    </a:cubicBezTo>
                    <a:cubicBezTo>
                      <a:pt x="16657" y="6440"/>
                      <a:pt x="16787" y="5673"/>
                      <a:pt x="16411" y="5552"/>
                    </a:cubicBezTo>
                    <a:cubicBezTo>
                      <a:pt x="15630" y="5301"/>
                      <a:pt x="14760" y="5622"/>
                      <a:pt x="14014" y="5996"/>
                    </a:cubicBezTo>
                    <a:cubicBezTo>
                      <a:pt x="13835" y="6086"/>
                      <a:pt x="14008" y="6614"/>
                      <a:pt x="14199" y="6663"/>
                    </a:cubicBezTo>
                    <a:cubicBezTo>
                      <a:pt x="15283" y="6938"/>
                      <a:pt x="16411" y="6811"/>
                      <a:pt x="17518" y="6885"/>
                    </a:cubicBezTo>
                    <a:cubicBezTo>
                      <a:pt x="18440" y="6811"/>
                      <a:pt x="19365" y="6785"/>
                      <a:pt x="20284" y="6663"/>
                    </a:cubicBezTo>
                    <a:cubicBezTo>
                      <a:pt x="20477" y="6637"/>
                      <a:pt x="20700" y="6606"/>
                      <a:pt x="20837" y="6440"/>
                    </a:cubicBezTo>
                    <a:cubicBezTo>
                      <a:pt x="21031" y="6206"/>
                      <a:pt x="21104" y="5860"/>
                      <a:pt x="21206" y="5552"/>
                    </a:cubicBezTo>
                    <a:cubicBezTo>
                      <a:pt x="21594" y="4383"/>
                      <a:pt x="21575" y="4651"/>
                      <a:pt x="21575" y="3998"/>
                    </a:cubicBez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algn="ctr">
                  <a:defRPr>
                    <a:solidFill>
                      <a:srgbClr val="FFFFFF"/>
                    </a:solidFill>
                  </a:defRPr>
                </a:pPr>
                <a:endParaRPr sz="1200"/>
              </a:p>
            </p:txBody>
          </p:sp>
          <p:grpSp>
            <p:nvGrpSpPr>
              <p:cNvPr id="129" name="Group 4099"/>
              <p:cNvGrpSpPr/>
              <p:nvPr/>
            </p:nvGrpSpPr>
            <p:grpSpPr>
              <a:xfrm>
                <a:off x="1805864" y="655939"/>
                <a:ext cx="375726" cy="309462"/>
                <a:chOff x="0" y="0"/>
                <a:chExt cx="375724" cy="309460"/>
              </a:xfrm>
            </p:grpSpPr>
            <p:sp>
              <p:nvSpPr>
                <p:cNvPr id="127" name="Freeform 26"/>
                <p:cNvSpPr/>
                <p:nvPr/>
              </p:nvSpPr>
              <p:spPr>
                <a:xfrm>
                  <a:off x="-1" y="-1"/>
                  <a:ext cx="339964" cy="309462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065" h="20837" extrusionOk="0">
                      <a:moveTo>
                        <a:pt x="6631" y="15122"/>
                      </a:moveTo>
                      <a:cubicBezTo>
                        <a:pt x="6714" y="15572"/>
                        <a:pt x="6880" y="16014"/>
                        <a:pt x="6880" y="16473"/>
                      </a:cubicBezTo>
                      <a:cubicBezTo>
                        <a:pt x="6880" y="17092"/>
                        <a:pt x="6540" y="17922"/>
                        <a:pt x="6134" y="18363"/>
                      </a:cubicBezTo>
                      <a:cubicBezTo>
                        <a:pt x="5923" y="18592"/>
                        <a:pt x="5637" y="18723"/>
                        <a:pt x="5389" y="18903"/>
                      </a:cubicBezTo>
                      <a:cubicBezTo>
                        <a:pt x="5223" y="19173"/>
                        <a:pt x="5190" y="19686"/>
                        <a:pt x="4892" y="19713"/>
                      </a:cubicBezTo>
                      <a:cubicBezTo>
                        <a:pt x="3711" y="19820"/>
                        <a:pt x="2431" y="19265"/>
                        <a:pt x="1413" y="18633"/>
                      </a:cubicBezTo>
                      <a:cubicBezTo>
                        <a:pt x="1154" y="18472"/>
                        <a:pt x="916" y="18273"/>
                        <a:pt x="667" y="18093"/>
                      </a:cubicBezTo>
                      <a:cubicBezTo>
                        <a:pt x="-8" y="16625"/>
                        <a:pt x="-302" y="16467"/>
                        <a:pt x="419" y="14312"/>
                      </a:cubicBezTo>
                      <a:cubicBezTo>
                        <a:pt x="508" y="14045"/>
                        <a:pt x="916" y="14132"/>
                        <a:pt x="1164" y="14042"/>
                      </a:cubicBezTo>
                      <a:cubicBezTo>
                        <a:pt x="1744" y="14132"/>
                        <a:pt x="2360" y="14076"/>
                        <a:pt x="2904" y="14312"/>
                      </a:cubicBezTo>
                      <a:cubicBezTo>
                        <a:pt x="3230" y="14454"/>
                        <a:pt x="3363" y="14900"/>
                        <a:pt x="3649" y="15122"/>
                      </a:cubicBezTo>
                      <a:cubicBezTo>
                        <a:pt x="3951" y="15356"/>
                        <a:pt x="4322" y="15463"/>
                        <a:pt x="4643" y="15662"/>
                      </a:cubicBezTo>
                      <a:cubicBezTo>
                        <a:pt x="5992" y="16500"/>
                        <a:pt x="4768" y="15977"/>
                        <a:pt x="6134" y="16473"/>
                      </a:cubicBezTo>
                      <a:cubicBezTo>
                        <a:pt x="7294" y="16382"/>
                        <a:pt x="8482" y="16492"/>
                        <a:pt x="9613" y="16202"/>
                      </a:cubicBezTo>
                      <a:cubicBezTo>
                        <a:pt x="9956" y="16115"/>
                        <a:pt x="10155" y="15703"/>
                        <a:pt x="10359" y="15392"/>
                      </a:cubicBezTo>
                      <a:cubicBezTo>
                        <a:pt x="10574" y="15065"/>
                        <a:pt x="10672" y="14662"/>
                        <a:pt x="10856" y="14312"/>
                      </a:cubicBezTo>
                      <a:cubicBezTo>
                        <a:pt x="11004" y="14030"/>
                        <a:pt x="11187" y="13772"/>
                        <a:pt x="11353" y="13502"/>
                      </a:cubicBezTo>
                      <a:cubicBezTo>
                        <a:pt x="11270" y="12422"/>
                        <a:pt x="11378" y="11304"/>
                        <a:pt x="11104" y="10262"/>
                      </a:cubicBezTo>
                      <a:cubicBezTo>
                        <a:pt x="11022" y="9949"/>
                        <a:pt x="10655" y="9762"/>
                        <a:pt x="10359" y="9721"/>
                      </a:cubicBezTo>
                      <a:cubicBezTo>
                        <a:pt x="9940" y="9665"/>
                        <a:pt x="9532" y="9909"/>
                        <a:pt x="9116" y="9991"/>
                      </a:cubicBezTo>
                      <a:cubicBezTo>
                        <a:pt x="8621" y="10089"/>
                        <a:pt x="8122" y="10172"/>
                        <a:pt x="7625" y="10262"/>
                      </a:cubicBezTo>
                      <a:cubicBezTo>
                        <a:pt x="7791" y="10532"/>
                        <a:pt x="7889" y="10869"/>
                        <a:pt x="8122" y="11072"/>
                      </a:cubicBezTo>
                      <a:cubicBezTo>
                        <a:pt x="8833" y="11690"/>
                        <a:pt x="10744" y="11115"/>
                        <a:pt x="11104" y="11072"/>
                      </a:cubicBezTo>
                      <a:cubicBezTo>
                        <a:pt x="11996" y="10830"/>
                        <a:pt x="12157" y="10914"/>
                        <a:pt x="12844" y="10262"/>
                      </a:cubicBezTo>
                      <a:cubicBezTo>
                        <a:pt x="13285" y="9842"/>
                        <a:pt x="14086" y="8911"/>
                        <a:pt x="14086" y="8911"/>
                      </a:cubicBezTo>
                      <a:cubicBezTo>
                        <a:pt x="13939" y="5065"/>
                        <a:pt x="15477" y="3186"/>
                        <a:pt x="13092" y="1890"/>
                      </a:cubicBezTo>
                      <a:cubicBezTo>
                        <a:pt x="12858" y="1763"/>
                        <a:pt x="12595" y="1710"/>
                        <a:pt x="12347" y="1620"/>
                      </a:cubicBezTo>
                      <a:cubicBezTo>
                        <a:pt x="12098" y="1440"/>
                        <a:pt x="11896" y="1133"/>
                        <a:pt x="11601" y="1080"/>
                      </a:cubicBezTo>
                      <a:cubicBezTo>
                        <a:pt x="10985" y="968"/>
                        <a:pt x="10421" y="1823"/>
                        <a:pt x="10110" y="2160"/>
                      </a:cubicBezTo>
                      <a:cubicBezTo>
                        <a:pt x="10028" y="2520"/>
                        <a:pt x="9956" y="2884"/>
                        <a:pt x="9862" y="3240"/>
                      </a:cubicBezTo>
                      <a:cubicBezTo>
                        <a:pt x="9790" y="3514"/>
                        <a:pt x="9613" y="3766"/>
                        <a:pt x="9613" y="4051"/>
                      </a:cubicBezTo>
                      <a:cubicBezTo>
                        <a:pt x="9613" y="4776"/>
                        <a:pt x="9605" y="5541"/>
                        <a:pt x="9862" y="6211"/>
                      </a:cubicBezTo>
                      <a:cubicBezTo>
                        <a:pt x="10042" y="6681"/>
                        <a:pt x="10563" y="6893"/>
                        <a:pt x="10856" y="7291"/>
                      </a:cubicBezTo>
                      <a:cubicBezTo>
                        <a:pt x="11229" y="7798"/>
                        <a:pt x="11353" y="8551"/>
                        <a:pt x="11850" y="8911"/>
                      </a:cubicBezTo>
                      <a:cubicBezTo>
                        <a:pt x="14514" y="10841"/>
                        <a:pt x="10471" y="7836"/>
                        <a:pt x="13341" y="10262"/>
                      </a:cubicBezTo>
                      <a:cubicBezTo>
                        <a:pt x="13812" y="10660"/>
                        <a:pt x="14459" y="10835"/>
                        <a:pt x="14832" y="11342"/>
                      </a:cubicBezTo>
                      <a:cubicBezTo>
                        <a:pt x="16057" y="13006"/>
                        <a:pt x="15352" y="12434"/>
                        <a:pt x="16820" y="13232"/>
                      </a:cubicBezTo>
                      <a:cubicBezTo>
                        <a:pt x="16937" y="13614"/>
                        <a:pt x="17317" y="14783"/>
                        <a:pt x="17317" y="15122"/>
                      </a:cubicBezTo>
                      <a:cubicBezTo>
                        <a:pt x="17317" y="15493"/>
                        <a:pt x="17162" y="15846"/>
                        <a:pt x="17069" y="16202"/>
                      </a:cubicBezTo>
                      <a:cubicBezTo>
                        <a:pt x="16997" y="16476"/>
                        <a:pt x="16984" y="16790"/>
                        <a:pt x="16820" y="17013"/>
                      </a:cubicBezTo>
                      <a:cubicBezTo>
                        <a:pt x="16633" y="17266"/>
                        <a:pt x="16304" y="17345"/>
                        <a:pt x="16074" y="17553"/>
                      </a:cubicBezTo>
                      <a:cubicBezTo>
                        <a:pt x="15805" y="17797"/>
                        <a:pt x="15577" y="18093"/>
                        <a:pt x="15329" y="18363"/>
                      </a:cubicBezTo>
                      <a:cubicBezTo>
                        <a:pt x="14961" y="19561"/>
                        <a:pt x="15271" y="19063"/>
                        <a:pt x="14086" y="19983"/>
                      </a:cubicBezTo>
                      <a:cubicBezTo>
                        <a:pt x="13843" y="20172"/>
                        <a:pt x="13341" y="20523"/>
                        <a:pt x="13341" y="20523"/>
                      </a:cubicBezTo>
                      <a:cubicBezTo>
                        <a:pt x="16314" y="21600"/>
                        <a:pt x="11027" y="19974"/>
                        <a:pt x="14335" y="14582"/>
                      </a:cubicBezTo>
                      <a:cubicBezTo>
                        <a:pt x="15026" y="13456"/>
                        <a:pt x="16820" y="14402"/>
                        <a:pt x="18063" y="14312"/>
                      </a:cubicBezTo>
                      <a:cubicBezTo>
                        <a:pt x="19811" y="13679"/>
                        <a:pt x="17653" y="14249"/>
                        <a:pt x="19802" y="14582"/>
                      </a:cubicBezTo>
                      <a:cubicBezTo>
                        <a:pt x="20061" y="14622"/>
                        <a:pt x="20299" y="14402"/>
                        <a:pt x="20548" y="14312"/>
                      </a:cubicBezTo>
                      <a:cubicBezTo>
                        <a:pt x="21030" y="12740"/>
                        <a:pt x="21298" y="12708"/>
                        <a:pt x="20796" y="11072"/>
                      </a:cubicBezTo>
                      <a:cubicBezTo>
                        <a:pt x="20702" y="10764"/>
                        <a:pt x="20510" y="10491"/>
                        <a:pt x="20299" y="10262"/>
                      </a:cubicBezTo>
                      <a:cubicBezTo>
                        <a:pt x="20088" y="10032"/>
                        <a:pt x="19802" y="9902"/>
                        <a:pt x="19554" y="9721"/>
                      </a:cubicBezTo>
                      <a:cubicBezTo>
                        <a:pt x="19263" y="9248"/>
                        <a:pt x="19031" y="8511"/>
                        <a:pt x="18311" y="8641"/>
                      </a:cubicBezTo>
                      <a:cubicBezTo>
                        <a:pt x="18016" y="8695"/>
                        <a:pt x="17814" y="9001"/>
                        <a:pt x="17566" y="9181"/>
                      </a:cubicBezTo>
                      <a:cubicBezTo>
                        <a:pt x="17483" y="9451"/>
                        <a:pt x="17317" y="9707"/>
                        <a:pt x="17317" y="9991"/>
                      </a:cubicBezTo>
                      <a:cubicBezTo>
                        <a:pt x="17317" y="11798"/>
                        <a:pt x="19183" y="10642"/>
                        <a:pt x="20299" y="10532"/>
                      </a:cubicBezTo>
                      <a:cubicBezTo>
                        <a:pt x="20212" y="9581"/>
                        <a:pt x="20180" y="7232"/>
                        <a:pt x="19554" y="6211"/>
                      </a:cubicBezTo>
                      <a:cubicBezTo>
                        <a:pt x="19388" y="5941"/>
                        <a:pt x="19290" y="5604"/>
                        <a:pt x="19057" y="5401"/>
                      </a:cubicBezTo>
                      <a:cubicBezTo>
                        <a:pt x="18852" y="5223"/>
                        <a:pt x="18560" y="5221"/>
                        <a:pt x="18311" y="5131"/>
                      </a:cubicBezTo>
                      <a:cubicBezTo>
                        <a:pt x="18722" y="3790"/>
                        <a:pt x="18647" y="4438"/>
                        <a:pt x="18311" y="2430"/>
                      </a:cubicBezTo>
                      <a:cubicBezTo>
                        <a:pt x="18250" y="2065"/>
                        <a:pt x="18215" y="1682"/>
                        <a:pt x="18063" y="1350"/>
                      </a:cubicBezTo>
                      <a:cubicBezTo>
                        <a:pt x="17958" y="1122"/>
                        <a:pt x="17748" y="969"/>
                        <a:pt x="17566" y="810"/>
                      </a:cubicBezTo>
                      <a:cubicBezTo>
                        <a:pt x="16785" y="132"/>
                        <a:pt x="16824" y="271"/>
                        <a:pt x="15826" y="0"/>
                      </a:cubicBezTo>
                      <a:cubicBezTo>
                        <a:pt x="15481" y="75"/>
                        <a:pt x="14268" y="280"/>
                        <a:pt x="13838" y="540"/>
                      </a:cubicBezTo>
                      <a:cubicBezTo>
                        <a:pt x="13316" y="855"/>
                        <a:pt x="12347" y="1620"/>
                        <a:pt x="12347" y="1620"/>
                      </a:cubicBezTo>
                      <a:cubicBezTo>
                        <a:pt x="11777" y="3478"/>
                        <a:pt x="12557" y="1222"/>
                        <a:pt x="11353" y="3511"/>
                      </a:cubicBezTo>
                      <a:cubicBezTo>
                        <a:pt x="11223" y="3758"/>
                        <a:pt x="11290" y="4119"/>
                        <a:pt x="11104" y="4321"/>
                      </a:cubicBezTo>
                      <a:cubicBezTo>
                        <a:pt x="10843" y="4605"/>
                        <a:pt x="10425" y="4647"/>
                        <a:pt x="10110" y="4861"/>
                      </a:cubicBezTo>
                      <a:cubicBezTo>
                        <a:pt x="9759" y="5099"/>
                        <a:pt x="9487" y="5470"/>
                        <a:pt x="9116" y="5671"/>
                      </a:cubicBezTo>
                      <a:cubicBezTo>
                        <a:pt x="8276" y="6128"/>
                        <a:pt x="7292" y="6283"/>
                        <a:pt x="6383" y="6481"/>
                      </a:cubicBezTo>
                      <a:cubicBezTo>
                        <a:pt x="5039" y="6384"/>
                        <a:pt x="1460" y="4815"/>
                        <a:pt x="2904" y="7561"/>
                      </a:cubicBezTo>
                      <a:cubicBezTo>
                        <a:pt x="3052" y="7843"/>
                        <a:pt x="3401" y="7921"/>
                        <a:pt x="3649" y="8101"/>
                      </a:cubicBezTo>
                      <a:cubicBezTo>
                        <a:pt x="4053" y="9416"/>
                        <a:pt x="3703" y="8561"/>
                        <a:pt x="4643" y="9991"/>
                      </a:cubicBezTo>
                      <a:cubicBezTo>
                        <a:pt x="4817" y="10256"/>
                        <a:pt x="5007" y="10511"/>
                        <a:pt x="5140" y="10802"/>
                      </a:cubicBezTo>
                      <a:cubicBezTo>
                        <a:pt x="5258" y="11056"/>
                        <a:pt x="5389" y="11612"/>
                        <a:pt x="5389" y="11612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  <p:sp>
              <p:nvSpPr>
                <p:cNvPr id="128" name="Freeform 27"/>
                <p:cNvSpPr/>
                <p:nvPr/>
              </p:nvSpPr>
              <p:spPr>
                <a:xfrm>
                  <a:off x="131080" y="178416"/>
                  <a:ext cx="244644" cy="92243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600" h="21600" extrusionOk="0">
                      <a:moveTo>
                        <a:pt x="3187" y="10330"/>
                      </a:moveTo>
                      <a:cubicBezTo>
                        <a:pt x="2833" y="12209"/>
                        <a:pt x="2395" y="13991"/>
                        <a:pt x="2125" y="15965"/>
                      </a:cubicBezTo>
                      <a:cubicBezTo>
                        <a:pt x="1919" y="17465"/>
                        <a:pt x="2104" y="19333"/>
                        <a:pt x="1771" y="20661"/>
                      </a:cubicBezTo>
                      <a:cubicBezTo>
                        <a:pt x="1563" y="21484"/>
                        <a:pt x="1062" y="21287"/>
                        <a:pt x="708" y="21600"/>
                      </a:cubicBezTo>
                      <a:cubicBezTo>
                        <a:pt x="590" y="20348"/>
                        <a:pt x="488" y="19085"/>
                        <a:pt x="354" y="17843"/>
                      </a:cubicBezTo>
                      <a:cubicBezTo>
                        <a:pt x="252" y="16892"/>
                        <a:pt x="0" y="16016"/>
                        <a:pt x="0" y="15026"/>
                      </a:cubicBezTo>
                      <a:cubicBezTo>
                        <a:pt x="0" y="13735"/>
                        <a:pt x="236" y="12522"/>
                        <a:pt x="354" y="11270"/>
                      </a:cubicBezTo>
                      <a:cubicBezTo>
                        <a:pt x="3630" y="11704"/>
                        <a:pt x="9637" y="13204"/>
                        <a:pt x="13102" y="11270"/>
                      </a:cubicBezTo>
                      <a:cubicBezTo>
                        <a:pt x="13592" y="10996"/>
                        <a:pt x="13810" y="9391"/>
                        <a:pt x="14164" y="8452"/>
                      </a:cubicBezTo>
                      <a:cubicBezTo>
                        <a:pt x="14046" y="7200"/>
                        <a:pt x="14121" y="5687"/>
                        <a:pt x="13810" y="4696"/>
                      </a:cubicBezTo>
                      <a:cubicBezTo>
                        <a:pt x="12704" y="1176"/>
                        <a:pt x="10353" y="3419"/>
                        <a:pt x="9207" y="3757"/>
                      </a:cubicBezTo>
                      <a:cubicBezTo>
                        <a:pt x="8431" y="9928"/>
                        <a:pt x="8261" y="7919"/>
                        <a:pt x="8853" y="13148"/>
                      </a:cubicBezTo>
                      <a:cubicBezTo>
                        <a:pt x="9067" y="15044"/>
                        <a:pt x="9325" y="16904"/>
                        <a:pt x="9561" y="18783"/>
                      </a:cubicBezTo>
                      <a:lnTo>
                        <a:pt x="9915" y="21600"/>
                      </a:lnTo>
                      <a:cubicBezTo>
                        <a:pt x="10539" y="21393"/>
                        <a:pt x="13201" y="20816"/>
                        <a:pt x="14164" y="19722"/>
                      </a:cubicBezTo>
                      <a:cubicBezTo>
                        <a:pt x="18971" y="14258"/>
                        <a:pt x="11810" y="20864"/>
                        <a:pt x="16289" y="16904"/>
                      </a:cubicBezTo>
                      <a:cubicBezTo>
                        <a:pt x="16525" y="15965"/>
                        <a:pt x="16847" y="15144"/>
                        <a:pt x="16997" y="14087"/>
                      </a:cubicBezTo>
                      <a:cubicBezTo>
                        <a:pt x="17517" y="10407"/>
                        <a:pt x="17494" y="4237"/>
                        <a:pt x="16997" y="939"/>
                      </a:cubicBezTo>
                      <a:cubicBezTo>
                        <a:pt x="16858" y="20"/>
                        <a:pt x="16289" y="313"/>
                        <a:pt x="15934" y="0"/>
                      </a:cubicBezTo>
                      <a:cubicBezTo>
                        <a:pt x="15580" y="313"/>
                        <a:pt x="15039" y="54"/>
                        <a:pt x="14872" y="939"/>
                      </a:cubicBezTo>
                      <a:cubicBezTo>
                        <a:pt x="14705" y="1824"/>
                        <a:pt x="14962" y="3057"/>
                        <a:pt x="15226" y="3757"/>
                      </a:cubicBezTo>
                      <a:cubicBezTo>
                        <a:pt x="15490" y="4456"/>
                        <a:pt x="15926" y="4455"/>
                        <a:pt x="16289" y="4696"/>
                      </a:cubicBezTo>
                      <a:cubicBezTo>
                        <a:pt x="16872" y="5083"/>
                        <a:pt x="17469" y="5322"/>
                        <a:pt x="18059" y="5635"/>
                      </a:cubicBezTo>
                      <a:cubicBezTo>
                        <a:pt x="21363" y="4661"/>
                        <a:pt x="20177" y="4696"/>
                        <a:pt x="21600" y="4696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</p:grpSp>
          <p:sp>
            <p:nvSpPr>
              <p:cNvPr id="130" name="Freeform 29"/>
              <p:cNvSpPr/>
              <p:nvPr/>
            </p:nvSpPr>
            <p:spPr>
              <a:xfrm>
                <a:off x="2696956" y="648052"/>
                <a:ext cx="417524" cy="325238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0871" h="21483" extrusionOk="0">
                    <a:moveTo>
                      <a:pt x="8420" y="10067"/>
                    </a:moveTo>
                    <a:cubicBezTo>
                      <a:pt x="8086" y="10243"/>
                      <a:pt x="7776" y="10549"/>
                      <a:pt x="7418" y="10596"/>
                    </a:cubicBezTo>
                    <a:cubicBezTo>
                      <a:pt x="6293" y="10745"/>
                      <a:pt x="6380" y="10082"/>
                      <a:pt x="5613" y="9272"/>
                    </a:cubicBezTo>
                    <a:cubicBezTo>
                      <a:pt x="3085" y="6599"/>
                      <a:pt x="5544" y="9711"/>
                      <a:pt x="3609" y="7153"/>
                    </a:cubicBezTo>
                    <a:cubicBezTo>
                      <a:pt x="3507" y="6615"/>
                      <a:pt x="3206" y="5830"/>
                      <a:pt x="3609" y="5298"/>
                    </a:cubicBezTo>
                    <a:cubicBezTo>
                      <a:pt x="3758" y="5101"/>
                      <a:pt x="4009" y="5122"/>
                      <a:pt x="4210" y="5033"/>
                    </a:cubicBezTo>
                    <a:cubicBezTo>
                      <a:pt x="5621" y="5655"/>
                      <a:pt x="3879" y="4846"/>
                      <a:pt x="5613" y="5828"/>
                    </a:cubicBezTo>
                    <a:cubicBezTo>
                      <a:pt x="5807" y="5938"/>
                      <a:pt x="6014" y="6005"/>
                      <a:pt x="6215" y="6093"/>
                    </a:cubicBezTo>
                    <a:cubicBezTo>
                      <a:pt x="6482" y="6358"/>
                      <a:pt x="6745" y="6631"/>
                      <a:pt x="7017" y="6888"/>
                    </a:cubicBezTo>
                    <a:cubicBezTo>
                      <a:pt x="7213" y="7073"/>
                      <a:pt x="7484" y="7153"/>
                      <a:pt x="7618" y="7417"/>
                    </a:cubicBezTo>
                    <a:cubicBezTo>
                      <a:pt x="7759" y="7697"/>
                      <a:pt x="8006" y="10038"/>
                      <a:pt x="8019" y="10067"/>
                    </a:cubicBezTo>
                    <a:cubicBezTo>
                      <a:pt x="8124" y="10309"/>
                      <a:pt x="8420" y="10243"/>
                      <a:pt x="8620" y="10331"/>
                    </a:cubicBezTo>
                    <a:cubicBezTo>
                      <a:pt x="9076" y="10031"/>
                      <a:pt x="9627" y="9721"/>
                      <a:pt x="10024" y="9272"/>
                    </a:cubicBezTo>
                    <a:cubicBezTo>
                      <a:pt x="11088" y="8067"/>
                      <a:pt x="10576" y="8465"/>
                      <a:pt x="11427" y="7153"/>
                    </a:cubicBezTo>
                    <a:cubicBezTo>
                      <a:pt x="12585" y="5367"/>
                      <a:pt x="11543" y="7320"/>
                      <a:pt x="12429" y="5563"/>
                    </a:cubicBezTo>
                    <a:cubicBezTo>
                      <a:pt x="12363" y="4768"/>
                      <a:pt x="12400" y="3946"/>
                      <a:pt x="12229" y="3179"/>
                    </a:cubicBezTo>
                    <a:cubicBezTo>
                      <a:pt x="11804" y="1270"/>
                      <a:pt x="11580" y="1028"/>
                      <a:pt x="10425" y="265"/>
                    </a:cubicBezTo>
                    <a:cubicBezTo>
                      <a:pt x="10236" y="140"/>
                      <a:pt x="10024" y="88"/>
                      <a:pt x="9823" y="0"/>
                    </a:cubicBezTo>
                    <a:cubicBezTo>
                      <a:pt x="9623" y="88"/>
                      <a:pt x="9371" y="68"/>
                      <a:pt x="9222" y="265"/>
                    </a:cubicBezTo>
                    <a:cubicBezTo>
                      <a:pt x="9072" y="462"/>
                      <a:pt x="9021" y="780"/>
                      <a:pt x="9021" y="1060"/>
                    </a:cubicBezTo>
                    <a:cubicBezTo>
                      <a:pt x="9021" y="2011"/>
                      <a:pt x="9024" y="3845"/>
                      <a:pt x="9623" y="4768"/>
                    </a:cubicBezTo>
                    <a:cubicBezTo>
                      <a:pt x="10214" y="5680"/>
                      <a:pt x="10651" y="5580"/>
                      <a:pt x="11427" y="6093"/>
                    </a:cubicBezTo>
                    <a:cubicBezTo>
                      <a:pt x="11775" y="6323"/>
                      <a:pt x="12099" y="6615"/>
                      <a:pt x="12429" y="6888"/>
                    </a:cubicBezTo>
                    <a:cubicBezTo>
                      <a:pt x="12634" y="7056"/>
                      <a:pt x="12811" y="7288"/>
                      <a:pt x="13031" y="7417"/>
                    </a:cubicBezTo>
                    <a:cubicBezTo>
                      <a:pt x="13417" y="7644"/>
                      <a:pt x="14234" y="7947"/>
                      <a:pt x="14234" y="7947"/>
                    </a:cubicBezTo>
                    <a:cubicBezTo>
                      <a:pt x="14300" y="8212"/>
                      <a:pt x="14492" y="8474"/>
                      <a:pt x="14434" y="8742"/>
                    </a:cubicBezTo>
                    <a:cubicBezTo>
                      <a:pt x="14241" y="9636"/>
                      <a:pt x="13242" y="10317"/>
                      <a:pt x="12830" y="10861"/>
                    </a:cubicBezTo>
                    <a:cubicBezTo>
                      <a:pt x="11701" y="12353"/>
                      <a:pt x="13194" y="11147"/>
                      <a:pt x="11828" y="11921"/>
                    </a:cubicBezTo>
                    <a:cubicBezTo>
                      <a:pt x="11553" y="12076"/>
                      <a:pt x="11304" y="12304"/>
                      <a:pt x="11026" y="12451"/>
                    </a:cubicBezTo>
                    <a:cubicBezTo>
                      <a:pt x="10634" y="12658"/>
                      <a:pt x="9823" y="12981"/>
                      <a:pt x="9823" y="12981"/>
                    </a:cubicBezTo>
                    <a:cubicBezTo>
                      <a:pt x="8954" y="12853"/>
                      <a:pt x="7716" y="12715"/>
                      <a:pt x="6816" y="12451"/>
                    </a:cubicBezTo>
                    <a:cubicBezTo>
                      <a:pt x="6610" y="12390"/>
                      <a:pt x="6415" y="12274"/>
                      <a:pt x="6215" y="12186"/>
                    </a:cubicBezTo>
                    <a:cubicBezTo>
                      <a:pt x="6012" y="11784"/>
                      <a:pt x="5613" y="11145"/>
                      <a:pt x="5613" y="10596"/>
                    </a:cubicBezTo>
                    <a:cubicBezTo>
                      <a:pt x="5613" y="10059"/>
                      <a:pt x="5747" y="9537"/>
                      <a:pt x="5814" y="9007"/>
                    </a:cubicBezTo>
                    <a:cubicBezTo>
                      <a:pt x="6148" y="9095"/>
                      <a:pt x="6497" y="9114"/>
                      <a:pt x="6816" y="9272"/>
                    </a:cubicBezTo>
                    <a:cubicBezTo>
                      <a:pt x="7042" y="9384"/>
                      <a:pt x="7202" y="9659"/>
                      <a:pt x="7418" y="9802"/>
                    </a:cubicBezTo>
                    <a:cubicBezTo>
                      <a:pt x="7607" y="9926"/>
                      <a:pt x="7818" y="9978"/>
                      <a:pt x="8019" y="10067"/>
                    </a:cubicBezTo>
                    <a:cubicBezTo>
                      <a:pt x="8219" y="10420"/>
                      <a:pt x="8403" y="10791"/>
                      <a:pt x="8620" y="11126"/>
                    </a:cubicBezTo>
                    <a:cubicBezTo>
                      <a:pt x="8805" y="11411"/>
                      <a:pt x="9160" y="11555"/>
                      <a:pt x="9222" y="11921"/>
                    </a:cubicBezTo>
                    <a:cubicBezTo>
                      <a:pt x="9310" y="12445"/>
                      <a:pt x="9150" y="13001"/>
                      <a:pt x="9021" y="13510"/>
                    </a:cubicBezTo>
                    <a:cubicBezTo>
                      <a:pt x="8945" y="13812"/>
                      <a:pt x="8802" y="14095"/>
                      <a:pt x="8620" y="14305"/>
                    </a:cubicBezTo>
                    <a:cubicBezTo>
                      <a:pt x="7975" y="15051"/>
                      <a:pt x="7348" y="15410"/>
                      <a:pt x="6616" y="15895"/>
                    </a:cubicBezTo>
                    <a:cubicBezTo>
                      <a:pt x="5346" y="15718"/>
                      <a:pt x="4072" y="15593"/>
                      <a:pt x="2807" y="15365"/>
                    </a:cubicBezTo>
                    <a:cubicBezTo>
                      <a:pt x="2597" y="15327"/>
                      <a:pt x="2408" y="15176"/>
                      <a:pt x="2205" y="15100"/>
                    </a:cubicBezTo>
                    <a:cubicBezTo>
                      <a:pt x="1940" y="15000"/>
                      <a:pt x="1671" y="14923"/>
                      <a:pt x="1403" y="14835"/>
                    </a:cubicBezTo>
                    <a:cubicBezTo>
                      <a:pt x="1203" y="14570"/>
                      <a:pt x="1020" y="14280"/>
                      <a:pt x="802" y="14040"/>
                    </a:cubicBezTo>
                    <a:cubicBezTo>
                      <a:pt x="617" y="13836"/>
                      <a:pt x="351" y="13759"/>
                      <a:pt x="200" y="13510"/>
                    </a:cubicBezTo>
                    <a:cubicBezTo>
                      <a:pt x="68" y="13292"/>
                      <a:pt x="67" y="12981"/>
                      <a:pt x="0" y="12716"/>
                    </a:cubicBezTo>
                    <a:cubicBezTo>
                      <a:pt x="67" y="12362"/>
                      <a:pt x="28" y="11940"/>
                      <a:pt x="200" y="11656"/>
                    </a:cubicBezTo>
                    <a:cubicBezTo>
                      <a:pt x="632" y="10943"/>
                      <a:pt x="1254" y="11723"/>
                      <a:pt x="1604" y="11921"/>
                    </a:cubicBezTo>
                    <a:cubicBezTo>
                      <a:pt x="1798" y="12031"/>
                      <a:pt x="2005" y="12097"/>
                      <a:pt x="2205" y="12186"/>
                    </a:cubicBezTo>
                    <a:cubicBezTo>
                      <a:pt x="2669" y="13105"/>
                      <a:pt x="2920" y="13210"/>
                      <a:pt x="2406" y="14570"/>
                    </a:cubicBezTo>
                    <a:cubicBezTo>
                      <a:pt x="2298" y="14855"/>
                      <a:pt x="2005" y="14923"/>
                      <a:pt x="1804" y="15100"/>
                    </a:cubicBezTo>
                    <a:cubicBezTo>
                      <a:pt x="1537" y="15011"/>
                      <a:pt x="1232" y="15037"/>
                      <a:pt x="1002" y="14835"/>
                    </a:cubicBezTo>
                    <a:cubicBezTo>
                      <a:pt x="202" y="14130"/>
                      <a:pt x="734" y="12460"/>
                      <a:pt x="802" y="11656"/>
                    </a:cubicBezTo>
                    <a:cubicBezTo>
                      <a:pt x="2539" y="11744"/>
                      <a:pt x="4279" y="11768"/>
                      <a:pt x="6014" y="11921"/>
                    </a:cubicBezTo>
                    <a:cubicBezTo>
                      <a:pt x="6289" y="11945"/>
                      <a:pt x="6592" y="11974"/>
                      <a:pt x="6816" y="12186"/>
                    </a:cubicBezTo>
                    <a:cubicBezTo>
                      <a:pt x="7088" y="12442"/>
                      <a:pt x="7217" y="12892"/>
                      <a:pt x="7418" y="13245"/>
                    </a:cubicBezTo>
                    <a:cubicBezTo>
                      <a:pt x="7551" y="13775"/>
                      <a:pt x="7871" y="14281"/>
                      <a:pt x="7818" y="14835"/>
                    </a:cubicBezTo>
                    <a:cubicBezTo>
                      <a:pt x="7752" y="15541"/>
                      <a:pt x="7448" y="16279"/>
                      <a:pt x="7618" y="16954"/>
                    </a:cubicBezTo>
                    <a:cubicBezTo>
                      <a:pt x="7694" y="17256"/>
                      <a:pt x="8019" y="16601"/>
                      <a:pt x="8219" y="16424"/>
                    </a:cubicBezTo>
                    <a:cubicBezTo>
                      <a:pt x="10567" y="16646"/>
                      <a:pt x="10587" y="15834"/>
                      <a:pt x="11627" y="17484"/>
                    </a:cubicBezTo>
                    <a:cubicBezTo>
                      <a:pt x="11782" y="17729"/>
                      <a:pt x="11895" y="18014"/>
                      <a:pt x="12028" y="18279"/>
                    </a:cubicBezTo>
                    <a:cubicBezTo>
                      <a:pt x="12095" y="18544"/>
                      <a:pt x="12323" y="18824"/>
                      <a:pt x="12229" y="19073"/>
                    </a:cubicBezTo>
                    <a:cubicBezTo>
                      <a:pt x="11918" y="19896"/>
                      <a:pt x="11212" y="18972"/>
                      <a:pt x="11026" y="18809"/>
                    </a:cubicBezTo>
                    <a:cubicBezTo>
                      <a:pt x="11093" y="18190"/>
                      <a:pt x="10973" y="17481"/>
                      <a:pt x="11227" y="16954"/>
                    </a:cubicBezTo>
                    <a:cubicBezTo>
                      <a:pt x="11594" y="16191"/>
                      <a:pt x="12571" y="15764"/>
                      <a:pt x="13231" y="15630"/>
                    </a:cubicBezTo>
                    <a:cubicBezTo>
                      <a:pt x="13829" y="15508"/>
                      <a:pt x="14434" y="15453"/>
                      <a:pt x="15036" y="15365"/>
                    </a:cubicBezTo>
                    <a:cubicBezTo>
                      <a:pt x="15160" y="15388"/>
                      <a:pt x="16819" y="15429"/>
                      <a:pt x="17040" y="16159"/>
                    </a:cubicBezTo>
                    <a:cubicBezTo>
                      <a:pt x="17119" y="16419"/>
                      <a:pt x="17012" y="16792"/>
                      <a:pt x="16840" y="16954"/>
                    </a:cubicBezTo>
                    <a:cubicBezTo>
                      <a:pt x="16496" y="17279"/>
                      <a:pt x="15637" y="17484"/>
                      <a:pt x="15637" y="17484"/>
                    </a:cubicBezTo>
                    <a:cubicBezTo>
                      <a:pt x="14664" y="17056"/>
                      <a:pt x="15254" y="17523"/>
                      <a:pt x="14635" y="16159"/>
                    </a:cubicBezTo>
                    <a:cubicBezTo>
                      <a:pt x="14387" y="15613"/>
                      <a:pt x="13833" y="14570"/>
                      <a:pt x="13833" y="14570"/>
                    </a:cubicBezTo>
                    <a:cubicBezTo>
                      <a:pt x="13766" y="14305"/>
                      <a:pt x="13617" y="14054"/>
                      <a:pt x="13632" y="13775"/>
                    </a:cubicBezTo>
                    <a:cubicBezTo>
                      <a:pt x="13685" y="12791"/>
                      <a:pt x="13782" y="11791"/>
                      <a:pt x="14033" y="10861"/>
                    </a:cubicBezTo>
                    <a:cubicBezTo>
                      <a:pt x="14129" y="10508"/>
                      <a:pt x="14411" y="10297"/>
                      <a:pt x="14635" y="10067"/>
                    </a:cubicBezTo>
                    <a:cubicBezTo>
                      <a:pt x="14921" y="9773"/>
                      <a:pt x="16428" y="8484"/>
                      <a:pt x="16840" y="8212"/>
                    </a:cubicBezTo>
                    <a:cubicBezTo>
                      <a:pt x="17595" y="7713"/>
                      <a:pt x="17878" y="7670"/>
                      <a:pt x="18644" y="7417"/>
                    </a:cubicBezTo>
                    <a:cubicBezTo>
                      <a:pt x="19245" y="7506"/>
                      <a:pt x="20020" y="7117"/>
                      <a:pt x="20448" y="7682"/>
                    </a:cubicBezTo>
                    <a:cubicBezTo>
                      <a:pt x="21600" y="9204"/>
                      <a:pt x="20078" y="9612"/>
                      <a:pt x="19646" y="9802"/>
                    </a:cubicBezTo>
                    <a:cubicBezTo>
                      <a:pt x="19446" y="9448"/>
                      <a:pt x="19262" y="9077"/>
                      <a:pt x="19045" y="8742"/>
                    </a:cubicBezTo>
                    <a:cubicBezTo>
                      <a:pt x="18860" y="8458"/>
                      <a:pt x="18601" y="8259"/>
                      <a:pt x="18444" y="7947"/>
                    </a:cubicBezTo>
                    <a:cubicBezTo>
                      <a:pt x="18326" y="7715"/>
                      <a:pt x="18338" y="7402"/>
                      <a:pt x="18243" y="7153"/>
                    </a:cubicBezTo>
                    <a:cubicBezTo>
                      <a:pt x="18135" y="6868"/>
                      <a:pt x="17950" y="6643"/>
                      <a:pt x="17842" y="6358"/>
                    </a:cubicBezTo>
                    <a:cubicBezTo>
                      <a:pt x="17748" y="6108"/>
                      <a:pt x="17430" y="5563"/>
                      <a:pt x="17642" y="5563"/>
                    </a:cubicBezTo>
                    <a:cubicBezTo>
                      <a:pt x="17883" y="5563"/>
                      <a:pt x="17909" y="6093"/>
                      <a:pt x="18043" y="6358"/>
                    </a:cubicBezTo>
                    <a:cubicBezTo>
                      <a:pt x="17685" y="7304"/>
                      <a:pt x="17769" y="7519"/>
                      <a:pt x="17040" y="7947"/>
                    </a:cubicBezTo>
                    <a:cubicBezTo>
                      <a:pt x="16654" y="8174"/>
                      <a:pt x="15837" y="8477"/>
                      <a:pt x="15837" y="8477"/>
                    </a:cubicBezTo>
                    <a:cubicBezTo>
                      <a:pt x="15570" y="8389"/>
                      <a:pt x="15300" y="8312"/>
                      <a:pt x="15036" y="8212"/>
                    </a:cubicBezTo>
                    <a:cubicBezTo>
                      <a:pt x="14832" y="8136"/>
                      <a:pt x="14557" y="8174"/>
                      <a:pt x="14434" y="7947"/>
                    </a:cubicBezTo>
                    <a:cubicBezTo>
                      <a:pt x="14188" y="7493"/>
                      <a:pt x="14190" y="6876"/>
                      <a:pt x="14033" y="6358"/>
                    </a:cubicBezTo>
                    <a:cubicBezTo>
                      <a:pt x="13922" y="5991"/>
                      <a:pt x="13754" y="5659"/>
                      <a:pt x="13632" y="5298"/>
                    </a:cubicBezTo>
                    <a:cubicBezTo>
                      <a:pt x="13313" y="4348"/>
                      <a:pt x="13251" y="4052"/>
                      <a:pt x="13031" y="3179"/>
                    </a:cubicBezTo>
                    <a:cubicBezTo>
                      <a:pt x="13098" y="2649"/>
                      <a:pt x="12836" y="1712"/>
                      <a:pt x="13231" y="1589"/>
                    </a:cubicBezTo>
                    <a:cubicBezTo>
                      <a:pt x="15519" y="878"/>
                      <a:pt x="15812" y="1840"/>
                      <a:pt x="17241" y="2649"/>
                    </a:cubicBezTo>
                    <a:cubicBezTo>
                      <a:pt x="17435" y="2759"/>
                      <a:pt x="17642" y="2826"/>
                      <a:pt x="17842" y="2914"/>
                    </a:cubicBezTo>
                    <a:cubicBezTo>
                      <a:pt x="17775" y="5387"/>
                      <a:pt x="17762" y="7863"/>
                      <a:pt x="17642" y="10331"/>
                    </a:cubicBezTo>
                    <a:cubicBezTo>
                      <a:pt x="17628" y="10610"/>
                      <a:pt x="17546" y="10884"/>
                      <a:pt x="17441" y="11126"/>
                    </a:cubicBezTo>
                    <a:cubicBezTo>
                      <a:pt x="17275" y="11510"/>
                      <a:pt x="17034" y="11827"/>
                      <a:pt x="16840" y="12186"/>
                    </a:cubicBezTo>
                    <a:cubicBezTo>
                      <a:pt x="16700" y="12445"/>
                      <a:pt x="16572" y="12716"/>
                      <a:pt x="16439" y="12981"/>
                    </a:cubicBezTo>
                    <a:lnTo>
                      <a:pt x="16038" y="14570"/>
                    </a:lnTo>
                    <a:cubicBezTo>
                      <a:pt x="15971" y="14835"/>
                      <a:pt x="15964" y="15141"/>
                      <a:pt x="15837" y="15365"/>
                    </a:cubicBezTo>
                    <a:cubicBezTo>
                      <a:pt x="15395" y="16144"/>
                      <a:pt x="15193" y="16604"/>
                      <a:pt x="14635" y="17219"/>
                    </a:cubicBezTo>
                    <a:cubicBezTo>
                      <a:pt x="14102" y="17806"/>
                      <a:pt x="13855" y="17807"/>
                      <a:pt x="13231" y="18279"/>
                    </a:cubicBezTo>
                    <a:cubicBezTo>
                      <a:pt x="12154" y="19092"/>
                      <a:pt x="13145" y="18638"/>
                      <a:pt x="11828" y="19073"/>
                    </a:cubicBezTo>
                    <a:cubicBezTo>
                      <a:pt x="10759" y="18985"/>
                      <a:pt x="9686" y="18957"/>
                      <a:pt x="8620" y="18809"/>
                    </a:cubicBezTo>
                    <a:cubicBezTo>
                      <a:pt x="8410" y="18779"/>
                      <a:pt x="7924" y="18793"/>
                      <a:pt x="8019" y="18544"/>
                    </a:cubicBezTo>
                    <a:cubicBezTo>
                      <a:pt x="8142" y="18218"/>
                      <a:pt x="8554" y="18367"/>
                      <a:pt x="8821" y="18279"/>
                    </a:cubicBezTo>
                    <a:cubicBezTo>
                      <a:pt x="9021" y="18455"/>
                      <a:pt x="9272" y="18560"/>
                      <a:pt x="9422" y="18809"/>
                    </a:cubicBezTo>
                    <a:cubicBezTo>
                      <a:pt x="9554" y="19027"/>
                      <a:pt x="9623" y="19324"/>
                      <a:pt x="9623" y="19603"/>
                    </a:cubicBezTo>
                    <a:cubicBezTo>
                      <a:pt x="9623" y="19882"/>
                      <a:pt x="9554" y="20180"/>
                      <a:pt x="9422" y="20398"/>
                    </a:cubicBezTo>
                    <a:cubicBezTo>
                      <a:pt x="9140" y="20865"/>
                      <a:pt x="8616" y="21018"/>
                      <a:pt x="8219" y="21193"/>
                    </a:cubicBezTo>
                    <a:cubicBezTo>
                      <a:pt x="7648" y="21109"/>
                      <a:pt x="6485" y="21107"/>
                      <a:pt x="5814" y="20663"/>
                    </a:cubicBezTo>
                    <a:cubicBezTo>
                      <a:pt x="5598" y="20520"/>
                      <a:pt x="5413" y="20310"/>
                      <a:pt x="5212" y="20133"/>
                    </a:cubicBezTo>
                    <a:cubicBezTo>
                      <a:pt x="5179" y="20067"/>
                      <a:pt x="4110" y="18522"/>
                      <a:pt x="5413" y="18809"/>
                    </a:cubicBezTo>
                    <a:cubicBezTo>
                      <a:pt x="5692" y="18870"/>
                      <a:pt x="5814" y="19338"/>
                      <a:pt x="6014" y="19603"/>
                    </a:cubicBezTo>
                    <a:cubicBezTo>
                      <a:pt x="6109" y="19978"/>
                      <a:pt x="6518" y="21125"/>
                      <a:pt x="6014" y="21458"/>
                    </a:cubicBezTo>
                    <a:cubicBezTo>
                      <a:pt x="5799" y="21600"/>
                      <a:pt x="5613" y="21104"/>
                      <a:pt x="5413" y="20928"/>
                    </a:cubicBezTo>
                    <a:cubicBezTo>
                      <a:pt x="6237" y="20202"/>
                      <a:pt x="5773" y="20398"/>
                      <a:pt x="6816" y="20398"/>
                    </a:cubicBez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algn="ctr">
                  <a:defRPr>
                    <a:solidFill>
                      <a:srgbClr val="FFFFFF"/>
                    </a:solidFill>
                  </a:defRPr>
                </a:pPr>
                <a:endParaRPr sz="1200"/>
              </a:p>
            </p:txBody>
          </p:sp>
          <p:sp>
            <p:nvSpPr>
              <p:cNvPr id="131" name="Freeform 150"/>
              <p:cNvSpPr/>
              <p:nvPr/>
            </p:nvSpPr>
            <p:spPr>
              <a:xfrm>
                <a:off x="3572124" y="622922"/>
                <a:ext cx="397448" cy="375497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389" h="21566" extrusionOk="0">
                    <a:moveTo>
                      <a:pt x="3052" y="11382"/>
                    </a:moveTo>
                    <a:cubicBezTo>
                      <a:pt x="3359" y="13347"/>
                      <a:pt x="3350" y="12720"/>
                      <a:pt x="3052" y="15576"/>
                    </a:cubicBezTo>
                    <a:cubicBezTo>
                      <a:pt x="3031" y="15785"/>
                      <a:pt x="2989" y="16010"/>
                      <a:pt x="2865" y="16175"/>
                    </a:cubicBezTo>
                    <a:cubicBezTo>
                      <a:pt x="2602" y="16526"/>
                      <a:pt x="2112" y="16642"/>
                      <a:pt x="1743" y="16774"/>
                    </a:cubicBezTo>
                    <a:cubicBezTo>
                      <a:pt x="1368" y="16707"/>
                      <a:pt x="959" y="16755"/>
                      <a:pt x="620" y="16574"/>
                    </a:cubicBezTo>
                    <a:cubicBezTo>
                      <a:pt x="330" y="16419"/>
                      <a:pt x="147" y="15659"/>
                      <a:pt x="59" y="15376"/>
                    </a:cubicBezTo>
                    <a:cubicBezTo>
                      <a:pt x="121" y="14777"/>
                      <a:pt x="-211" y="13933"/>
                      <a:pt x="246" y="13579"/>
                    </a:cubicBezTo>
                    <a:cubicBezTo>
                      <a:pt x="1339" y="12730"/>
                      <a:pt x="1955" y="13792"/>
                      <a:pt x="2678" y="14178"/>
                    </a:cubicBezTo>
                    <a:cubicBezTo>
                      <a:pt x="2855" y="14272"/>
                      <a:pt x="3052" y="14311"/>
                      <a:pt x="3240" y="14377"/>
                    </a:cubicBezTo>
                    <a:cubicBezTo>
                      <a:pt x="3427" y="14111"/>
                      <a:pt x="3561" y="13792"/>
                      <a:pt x="3801" y="13579"/>
                    </a:cubicBezTo>
                    <a:cubicBezTo>
                      <a:pt x="3952" y="13444"/>
                      <a:pt x="4195" y="13491"/>
                      <a:pt x="4362" y="13379"/>
                    </a:cubicBezTo>
                    <a:cubicBezTo>
                      <a:pt x="4701" y="13153"/>
                      <a:pt x="5015" y="12882"/>
                      <a:pt x="5298" y="12580"/>
                    </a:cubicBezTo>
                    <a:cubicBezTo>
                      <a:pt x="5457" y="12411"/>
                      <a:pt x="5521" y="12160"/>
                      <a:pt x="5672" y="11981"/>
                    </a:cubicBezTo>
                    <a:cubicBezTo>
                      <a:pt x="6085" y="11491"/>
                      <a:pt x="6982" y="10583"/>
                      <a:pt x="6982" y="10583"/>
                    </a:cubicBezTo>
                    <a:cubicBezTo>
                      <a:pt x="7106" y="10317"/>
                      <a:pt x="7258" y="10063"/>
                      <a:pt x="7356" y="9785"/>
                    </a:cubicBezTo>
                    <a:cubicBezTo>
                      <a:pt x="7718" y="8753"/>
                      <a:pt x="7632" y="7333"/>
                      <a:pt x="7356" y="6390"/>
                    </a:cubicBezTo>
                    <a:cubicBezTo>
                      <a:pt x="7266" y="6083"/>
                      <a:pt x="6098" y="5519"/>
                      <a:pt x="5859" y="5392"/>
                    </a:cubicBezTo>
                    <a:cubicBezTo>
                      <a:pt x="2359" y="5890"/>
                      <a:pt x="3598" y="4873"/>
                      <a:pt x="2678" y="6590"/>
                    </a:cubicBezTo>
                    <a:cubicBezTo>
                      <a:pt x="2567" y="6798"/>
                      <a:pt x="2429" y="6989"/>
                      <a:pt x="2304" y="7189"/>
                    </a:cubicBezTo>
                    <a:cubicBezTo>
                      <a:pt x="2366" y="7987"/>
                      <a:pt x="2392" y="8790"/>
                      <a:pt x="2491" y="9585"/>
                    </a:cubicBezTo>
                    <a:cubicBezTo>
                      <a:pt x="2590" y="10375"/>
                      <a:pt x="2770" y="10138"/>
                      <a:pt x="3240" y="10783"/>
                    </a:cubicBezTo>
                    <a:cubicBezTo>
                      <a:pt x="4806" y="12933"/>
                      <a:pt x="3275" y="11220"/>
                      <a:pt x="4549" y="12580"/>
                    </a:cubicBezTo>
                    <a:cubicBezTo>
                      <a:pt x="4487" y="13579"/>
                      <a:pt x="4495" y="14585"/>
                      <a:pt x="4362" y="15576"/>
                    </a:cubicBezTo>
                    <a:cubicBezTo>
                      <a:pt x="4306" y="15992"/>
                      <a:pt x="4113" y="16374"/>
                      <a:pt x="3988" y="16774"/>
                    </a:cubicBezTo>
                    <a:lnTo>
                      <a:pt x="3801" y="17373"/>
                    </a:lnTo>
                    <a:cubicBezTo>
                      <a:pt x="3973" y="20853"/>
                      <a:pt x="2866" y="20853"/>
                      <a:pt x="4549" y="21366"/>
                    </a:cubicBezTo>
                    <a:cubicBezTo>
                      <a:pt x="4796" y="21442"/>
                      <a:pt x="5048" y="21500"/>
                      <a:pt x="5298" y="21566"/>
                    </a:cubicBezTo>
                    <a:cubicBezTo>
                      <a:pt x="6233" y="21500"/>
                      <a:pt x="7193" y="21600"/>
                      <a:pt x="8104" y="21366"/>
                    </a:cubicBezTo>
                    <a:cubicBezTo>
                      <a:pt x="8211" y="21339"/>
                      <a:pt x="10029" y="20433"/>
                      <a:pt x="10537" y="19969"/>
                    </a:cubicBezTo>
                    <a:cubicBezTo>
                      <a:pt x="11239" y="19326"/>
                      <a:pt x="11320" y="19217"/>
                      <a:pt x="11659" y="18371"/>
                    </a:cubicBezTo>
                    <a:cubicBezTo>
                      <a:pt x="11924" y="17712"/>
                      <a:pt x="12408" y="16374"/>
                      <a:pt x="12408" y="16374"/>
                    </a:cubicBezTo>
                    <a:cubicBezTo>
                      <a:pt x="12345" y="15376"/>
                      <a:pt x="12590" y="14299"/>
                      <a:pt x="12221" y="13379"/>
                    </a:cubicBezTo>
                    <a:cubicBezTo>
                      <a:pt x="12095" y="13067"/>
                      <a:pt x="11570" y="13427"/>
                      <a:pt x="11285" y="13579"/>
                    </a:cubicBezTo>
                    <a:cubicBezTo>
                      <a:pt x="11048" y="13705"/>
                      <a:pt x="10893" y="13961"/>
                      <a:pt x="10724" y="14178"/>
                    </a:cubicBezTo>
                    <a:cubicBezTo>
                      <a:pt x="10393" y="14601"/>
                      <a:pt x="10204" y="15087"/>
                      <a:pt x="9975" y="15576"/>
                    </a:cubicBezTo>
                    <a:cubicBezTo>
                      <a:pt x="10038" y="15775"/>
                      <a:pt x="10008" y="16043"/>
                      <a:pt x="10162" y="16175"/>
                    </a:cubicBezTo>
                    <a:cubicBezTo>
                      <a:pt x="10653" y="16593"/>
                      <a:pt x="11833" y="16234"/>
                      <a:pt x="12221" y="16175"/>
                    </a:cubicBezTo>
                    <a:cubicBezTo>
                      <a:pt x="12720" y="15775"/>
                      <a:pt x="13281" y="15442"/>
                      <a:pt x="13530" y="14777"/>
                    </a:cubicBezTo>
                    <a:cubicBezTo>
                      <a:pt x="13671" y="14401"/>
                      <a:pt x="13655" y="13978"/>
                      <a:pt x="13718" y="13579"/>
                    </a:cubicBezTo>
                    <a:cubicBezTo>
                      <a:pt x="13655" y="12381"/>
                      <a:pt x="13624" y="11180"/>
                      <a:pt x="13530" y="9984"/>
                    </a:cubicBezTo>
                    <a:cubicBezTo>
                      <a:pt x="13499" y="9581"/>
                      <a:pt x="13463" y="9170"/>
                      <a:pt x="13343" y="8786"/>
                    </a:cubicBezTo>
                    <a:cubicBezTo>
                      <a:pt x="13272" y="8559"/>
                      <a:pt x="13081" y="8396"/>
                      <a:pt x="12969" y="8187"/>
                    </a:cubicBezTo>
                    <a:cubicBezTo>
                      <a:pt x="12831" y="7929"/>
                      <a:pt x="12720" y="7655"/>
                      <a:pt x="12595" y="7388"/>
                    </a:cubicBezTo>
                    <a:cubicBezTo>
                      <a:pt x="12533" y="7056"/>
                      <a:pt x="12485" y="6719"/>
                      <a:pt x="12408" y="6390"/>
                    </a:cubicBezTo>
                    <a:cubicBezTo>
                      <a:pt x="12277" y="5833"/>
                      <a:pt x="11908" y="4991"/>
                      <a:pt x="11659" y="4593"/>
                    </a:cubicBezTo>
                    <a:cubicBezTo>
                      <a:pt x="11513" y="4358"/>
                      <a:pt x="11285" y="4193"/>
                      <a:pt x="11098" y="3994"/>
                    </a:cubicBezTo>
                    <a:cubicBezTo>
                      <a:pt x="10911" y="4060"/>
                      <a:pt x="10676" y="4045"/>
                      <a:pt x="10537" y="4193"/>
                    </a:cubicBezTo>
                    <a:cubicBezTo>
                      <a:pt x="10397" y="4342"/>
                      <a:pt x="10350" y="4582"/>
                      <a:pt x="10350" y="4793"/>
                    </a:cubicBezTo>
                    <a:cubicBezTo>
                      <a:pt x="10350" y="5660"/>
                      <a:pt x="10327" y="6550"/>
                      <a:pt x="10537" y="7388"/>
                    </a:cubicBezTo>
                    <a:cubicBezTo>
                      <a:pt x="10607" y="7672"/>
                      <a:pt x="11459" y="7916"/>
                      <a:pt x="11659" y="7987"/>
                    </a:cubicBezTo>
                    <a:cubicBezTo>
                      <a:pt x="11846" y="7921"/>
                      <a:pt x="12158" y="7987"/>
                      <a:pt x="12221" y="7788"/>
                    </a:cubicBezTo>
                    <a:cubicBezTo>
                      <a:pt x="12321" y="7466"/>
                      <a:pt x="12332" y="6905"/>
                      <a:pt x="12034" y="6789"/>
                    </a:cubicBezTo>
                    <a:cubicBezTo>
                      <a:pt x="11444" y="6561"/>
                      <a:pt x="10786" y="6922"/>
                      <a:pt x="10162" y="6989"/>
                    </a:cubicBezTo>
                    <a:cubicBezTo>
                      <a:pt x="10090" y="7297"/>
                      <a:pt x="9788" y="8533"/>
                      <a:pt x="9788" y="8786"/>
                    </a:cubicBezTo>
                    <a:cubicBezTo>
                      <a:pt x="9788" y="9720"/>
                      <a:pt x="9823" y="10662"/>
                      <a:pt x="9975" y="11582"/>
                    </a:cubicBezTo>
                    <a:cubicBezTo>
                      <a:pt x="10072" y="12165"/>
                      <a:pt x="10565" y="12264"/>
                      <a:pt x="10911" y="12580"/>
                    </a:cubicBezTo>
                    <a:cubicBezTo>
                      <a:pt x="11179" y="12825"/>
                      <a:pt x="11349" y="13200"/>
                      <a:pt x="11659" y="13379"/>
                    </a:cubicBezTo>
                    <a:cubicBezTo>
                      <a:pt x="12058" y="13608"/>
                      <a:pt x="14091" y="14206"/>
                      <a:pt x="14653" y="14377"/>
                    </a:cubicBezTo>
                    <a:cubicBezTo>
                      <a:pt x="14591" y="14777"/>
                      <a:pt x="14586" y="15191"/>
                      <a:pt x="14466" y="15576"/>
                    </a:cubicBezTo>
                    <a:cubicBezTo>
                      <a:pt x="14395" y="15803"/>
                      <a:pt x="14183" y="15955"/>
                      <a:pt x="14092" y="16175"/>
                    </a:cubicBezTo>
                    <a:cubicBezTo>
                      <a:pt x="13932" y="16559"/>
                      <a:pt x="13936" y="17022"/>
                      <a:pt x="13718" y="17373"/>
                    </a:cubicBezTo>
                    <a:cubicBezTo>
                      <a:pt x="13593" y="17572"/>
                      <a:pt x="13444" y="17757"/>
                      <a:pt x="13343" y="17972"/>
                    </a:cubicBezTo>
                    <a:cubicBezTo>
                      <a:pt x="13003" y="18698"/>
                      <a:pt x="13179" y="19620"/>
                      <a:pt x="12408" y="20168"/>
                    </a:cubicBezTo>
                    <a:lnTo>
                      <a:pt x="11846" y="20568"/>
                    </a:lnTo>
                    <a:cubicBezTo>
                      <a:pt x="11597" y="20501"/>
                      <a:pt x="11312" y="20520"/>
                      <a:pt x="11098" y="20368"/>
                    </a:cubicBezTo>
                    <a:cubicBezTo>
                      <a:pt x="10911" y="20235"/>
                      <a:pt x="10761" y="20006"/>
                      <a:pt x="10724" y="19769"/>
                    </a:cubicBezTo>
                    <a:cubicBezTo>
                      <a:pt x="10655" y="19329"/>
                      <a:pt x="11227" y="18745"/>
                      <a:pt x="11472" y="18571"/>
                    </a:cubicBezTo>
                    <a:cubicBezTo>
                      <a:pt x="11636" y="18454"/>
                      <a:pt x="11846" y="18438"/>
                      <a:pt x="12034" y="18371"/>
                    </a:cubicBezTo>
                    <a:cubicBezTo>
                      <a:pt x="12283" y="18171"/>
                      <a:pt x="12511" y="17937"/>
                      <a:pt x="12782" y="17772"/>
                    </a:cubicBezTo>
                    <a:cubicBezTo>
                      <a:pt x="12981" y="17651"/>
                      <a:pt x="13942" y="17408"/>
                      <a:pt x="14092" y="17373"/>
                    </a:cubicBezTo>
                    <a:cubicBezTo>
                      <a:pt x="15039" y="17148"/>
                      <a:pt x="15674" y="17045"/>
                      <a:pt x="16711" y="16973"/>
                    </a:cubicBezTo>
                    <a:cubicBezTo>
                      <a:pt x="18082" y="16879"/>
                      <a:pt x="19456" y="16840"/>
                      <a:pt x="20828" y="16774"/>
                    </a:cubicBezTo>
                    <a:cubicBezTo>
                      <a:pt x="20952" y="16574"/>
                      <a:pt x="21101" y="16389"/>
                      <a:pt x="21202" y="16175"/>
                    </a:cubicBezTo>
                    <a:cubicBezTo>
                      <a:pt x="21290" y="15986"/>
                      <a:pt x="21389" y="15786"/>
                      <a:pt x="21389" y="15576"/>
                    </a:cubicBezTo>
                    <a:cubicBezTo>
                      <a:pt x="21389" y="13777"/>
                      <a:pt x="21314" y="11978"/>
                      <a:pt x="21202" y="10184"/>
                    </a:cubicBezTo>
                    <a:cubicBezTo>
                      <a:pt x="21189" y="9974"/>
                      <a:pt x="21124" y="9760"/>
                      <a:pt x="21015" y="9585"/>
                    </a:cubicBezTo>
                    <a:cubicBezTo>
                      <a:pt x="20868" y="9350"/>
                      <a:pt x="20609" y="9214"/>
                      <a:pt x="20453" y="8986"/>
                    </a:cubicBezTo>
                    <a:cubicBezTo>
                      <a:pt x="20107" y="8478"/>
                      <a:pt x="20044" y="7669"/>
                      <a:pt x="19518" y="7388"/>
                    </a:cubicBezTo>
                    <a:cubicBezTo>
                      <a:pt x="17845" y="6496"/>
                      <a:pt x="18550" y="6778"/>
                      <a:pt x="17460" y="6390"/>
                    </a:cubicBezTo>
                    <a:cubicBezTo>
                      <a:pt x="17335" y="6590"/>
                      <a:pt x="17106" y="6750"/>
                      <a:pt x="17085" y="6989"/>
                    </a:cubicBezTo>
                    <a:cubicBezTo>
                      <a:pt x="16974" y="8301"/>
                      <a:pt x="17140" y="8374"/>
                      <a:pt x="17647" y="9186"/>
                    </a:cubicBezTo>
                    <a:cubicBezTo>
                      <a:pt x="17505" y="10702"/>
                      <a:pt x="17264" y="12047"/>
                      <a:pt x="17647" y="13579"/>
                    </a:cubicBezTo>
                    <a:cubicBezTo>
                      <a:pt x="17715" y="13852"/>
                      <a:pt x="17977" y="14041"/>
                      <a:pt x="18208" y="14178"/>
                    </a:cubicBezTo>
                    <a:cubicBezTo>
                      <a:pt x="18553" y="14382"/>
                      <a:pt x="19331" y="14577"/>
                      <a:pt x="19331" y="14577"/>
                    </a:cubicBezTo>
                    <a:cubicBezTo>
                      <a:pt x="19268" y="14377"/>
                      <a:pt x="19335" y="14029"/>
                      <a:pt x="19144" y="13978"/>
                    </a:cubicBezTo>
                    <a:cubicBezTo>
                      <a:pt x="18663" y="13850"/>
                      <a:pt x="18295" y="15022"/>
                      <a:pt x="18208" y="15176"/>
                    </a:cubicBezTo>
                    <a:cubicBezTo>
                      <a:pt x="17977" y="15588"/>
                      <a:pt x="17460" y="16374"/>
                      <a:pt x="17460" y="16374"/>
                    </a:cubicBezTo>
                    <a:cubicBezTo>
                      <a:pt x="17147" y="18046"/>
                      <a:pt x="17507" y="16781"/>
                      <a:pt x="16898" y="17972"/>
                    </a:cubicBezTo>
                    <a:cubicBezTo>
                      <a:pt x="16631" y="18494"/>
                      <a:pt x="16459" y="19074"/>
                      <a:pt x="16150" y="19569"/>
                    </a:cubicBezTo>
                    <a:cubicBezTo>
                      <a:pt x="16025" y="19769"/>
                      <a:pt x="15951" y="20018"/>
                      <a:pt x="15776" y="20168"/>
                    </a:cubicBezTo>
                    <a:cubicBezTo>
                      <a:pt x="15622" y="20300"/>
                      <a:pt x="15402" y="20301"/>
                      <a:pt x="15214" y="20368"/>
                    </a:cubicBezTo>
                    <a:cubicBezTo>
                      <a:pt x="14965" y="20301"/>
                      <a:pt x="14689" y="20305"/>
                      <a:pt x="14466" y="20168"/>
                    </a:cubicBezTo>
                    <a:cubicBezTo>
                      <a:pt x="14236" y="20028"/>
                      <a:pt x="14074" y="19786"/>
                      <a:pt x="13905" y="19569"/>
                    </a:cubicBezTo>
                    <a:cubicBezTo>
                      <a:pt x="13576" y="19149"/>
                      <a:pt x="13362" y="18531"/>
                      <a:pt x="12969" y="18171"/>
                    </a:cubicBezTo>
                    <a:cubicBezTo>
                      <a:pt x="12757" y="17978"/>
                      <a:pt x="12444" y="17951"/>
                      <a:pt x="12221" y="17772"/>
                    </a:cubicBezTo>
                    <a:cubicBezTo>
                      <a:pt x="11667" y="17329"/>
                      <a:pt x="11317" y="16752"/>
                      <a:pt x="10911" y="16175"/>
                    </a:cubicBezTo>
                    <a:cubicBezTo>
                      <a:pt x="10849" y="15908"/>
                      <a:pt x="10724" y="15650"/>
                      <a:pt x="10724" y="15376"/>
                    </a:cubicBezTo>
                    <a:cubicBezTo>
                      <a:pt x="10724" y="14127"/>
                      <a:pt x="10820" y="13708"/>
                      <a:pt x="11472" y="12780"/>
                    </a:cubicBezTo>
                    <a:cubicBezTo>
                      <a:pt x="11631" y="12554"/>
                      <a:pt x="11880" y="12411"/>
                      <a:pt x="12034" y="12181"/>
                    </a:cubicBezTo>
                    <a:cubicBezTo>
                      <a:pt x="12897" y="10891"/>
                      <a:pt x="11863" y="11770"/>
                      <a:pt x="12969" y="10983"/>
                    </a:cubicBezTo>
                    <a:cubicBezTo>
                      <a:pt x="13338" y="10195"/>
                      <a:pt x="13338" y="10077"/>
                      <a:pt x="13905" y="9385"/>
                    </a:cubicBezTo>
                    <a:cubicBezTo>
                      <a:pt x="14137" y="9102"/>
                      <a:pt x="14437" y="8884"/>
                      <a:pt x="14653" y="8587"/>
                    </a:cubicBezTo>
                    <a:cubicBezTo>
                      <a:pt x="15429" y="7521"/>
                      <a:pt x="15038" y="7895"/>
                      <a:pt x="15402" y="6989"/>
                    </a:cubicBezTo>
                    <a:cubicBezTo>
                      <a:pt x="15511" y="6715"/>
                      <a:pt x="15662" y="6462"/>
                      <a:pt x="15776" y="6190"/>
                    </a:cubicBezTo>
                    <a:cubicBezTo>
                      <a:pt x="15912" y="5863"/>
                      <a:pt x="16025" y="5525"/>
                      <a:pt x="16150" y="5192"/>
                    </a:cubicBezTo>
                    <a:cubicBezTo>
                      <a:pt x="16088" y="4060"/>
                      <a:pt x="16209" y="2900"/>
                      <a:pt x="15963" y="1797"/>
                    </a:cubicBezTo>
                    <a:cubicBezTo>
                      <a:pt x="15881" y="1431"/>
                      <a:pt x="15497" y="1224"/>
                      <a:pt x="15214" y="998"/>
                    </a:cubicBezTo>
                    <a:cubicBezTo>
                      <a:pt x="14436" y="375"/>
                      <a:pt x="14627" y="785"/>
                      <a:pt x="13905" y="399"/>
                    </a:cubicBezTo>
                    <a:cubicBezTo>
                      <a:pt x="13704" y="292"/>
                      <a:pt x="13530" y="133"/>
                      <a:pt x="13343" y="0"/>
                    </a:cubicBezTo>
                    <a:cubicBezTo>
                      <a:pt x="13156" y="133"/>
                      <a:pt x="12926" y="215"/>
                      <a:pt x="12782" y="399"/>
                    </a:cubicBezTo>
                    <a:cubicBezTo>
                      <a:pt x="11804" y="1652"/>
                      <a:pt x="12475" y="4653"/>
                      <a:pt x="12595" y="5392"/>
                    </a:cubicBezTo>
                    <a:cubicBezTo>
                      <a:pt x="12633" y="5628"/>
                      <a:pt x="12955" y="5684"/>
                      <a:pt x="13156" y="5791"/>
                    </a:cubicBezTo>
                    <a:cubicBezTo>
                      <a:pt x="13333" y="5885"/>
                      <a:pt x="13526" y="5940"/>
                      <a:pt x="13718" y="5991"/>
                    </a:cubicBezTo>
                    <a:cubicBezTo>
                      <a:pt x="14613" y="6229"/>
                      <a:pt x="14467" y="6190"/>
                      <a:pt x="15214" y="6190"/>
                    </a:cubicBez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algn="ctr">
                  <a:defRPr>
                    <a:solidFill>
                      <a:srgbClr val="FFFFFF"/>
                    </a:solidFill>
                  </a:defRPr>
                </a:pPr>
                <a:endParaRPr sz="1200"/>
              </a:p>
            </p:txBody>
          </p:sp>
          <p:sp>
            <p:nvSpPr>
              <p:cNvPr id="132" name="Freeform 178"/>
              <p:cNvSpPr/>
              <p:nvPr/>
            </p:nvSpPr>
            <p:spPr>
              <a:xfrm>
                <a:off x="4484596" y="617706"/>
                <a:ext cx="345332" cy="385928"/>
              </a:xfrm>
              <a:custGeom>
                <a:avLst/>
                <a:gdLst/>
                <a:ahLst/>
                <a:cxnLst>
                  <a:cxn ang="0">
                    <a:pos x="wd2" y="hd2"/>
                  </a:cxn>
                  <a:cxn ang="5400000">
                    <a:pos x="wd2" y="hd2"/>
                  </a:cxn>
                  <a:cxn ang="10800000">
                    <a:pos x="wd2" y="hd2"/>
                  </a:cxn>
                  <a:cxn ang="16200000">
                    <a:pos x="wd2" y="hd2"/>
                  </a:cxn>
                </a:cxnLst>
                <a:rect l="0" t="0" r="r" b="b"/>
                <a:pathLst>
                  <a:path w="21407" h="21414" extrusionOk="0">
                    <a:moveTo>
                      <a:pt x="11277" y="5788"/>
                    </a:moveTo>
                    <a:cubicBezTo>
                      <a:pt x="11605" y="7549"/>
                      <a:pt x="11615" y="7033"/>
                      <a:pt x="11277" y="9453"/>
                    </a:cubicBezTo>
                    <a:cubicBezTo>
                      <a:pt x="11249" y="9655"/>
                      <a:pt x="11154" y="9846"/>
                      <a:pt x="11062" y="10032"/>
                    </a:cubicBezTo>
                    <a:cubicBezTo>
                      <a:pt x="10759" y="10641"/>
                      <a:pt x="10452" y="11386"/>
                      <a:pt x="9768" y="11768"/>
                    </a:cubicBezTo>
                    <a:cubicBezTo>
                      <a:pt x="9440" y="11952"/>
                      <a:pt x="9044" y="12013"/>
                      <a:pt x="8691" y="12154"/>
                    </a:cubicBezTo>
                    <a:cubicBezTo>
                      <a:pt x="7658" y="12565"/>
                      <a:pt x="7838" y="12578"/>
                      <a:pt x="6751" y="13119"/>
                    </a:cubicBezTo>
                    <a:cubicBezTo>
                      <a:pt x="6470" y="13258"/>
                      <a:pt x="6197" y="13422"/>
                      <a:pt x="5889" y="13505"/>
                    </a:cubicBezTo>
                    <a:cubicBezTo>
                      <a:pt x="5470" y="13617"/>
                      <a:pt x="5024" y="13621"/>
                      <a:pt x="4596" y="13698"/>
                    </a:cubicBezTo>
                    <a:cubicBezTo>
                      <a:pt x="4305" y="13750"/>
                      <a:pt x="4021" y="13826"/>
                      <a:pt x="3734" y="13890"/>
                    </a:cubicBezTo>
                    <a:cubicBezTo>
                      <a:pt x="3015" y="13826"/>
                      <a:pt x="2258" y="13915"/>
                      <a:pt x="1578" y="13698"/>
                    </a:cubicBezTo>
                    <a:cubicBezTo>
                      <a:pt x="1121" y="13551"/>
                      <a:pt x="567" y="12725"/>
                      <a:pt x="285" y="12347"/>
                    </a:cubicBezTo>
                    <a:cubicBezTo>
                      <a:pt x="16" y="11385"/>
                      <a:pt x="-193" y="11016"/>
                      <a:pt x="285" y="9839"/>
                    </a:cubicBezTo>
                    <a:cubicBezTo>
                      <a:pt x="374" y="9621"/>
                      <a:pt x="716" y="9582"/>
                      <a:pt x="932" y="9453"/>
                    </a:cubicBezTo>
                    <a:cubicBezTo>
                      <a:pt x="2225" y="9582"/>
                      <a:pt x="3560" y="9519"/>
                      <a:pt x="4811" y="9839"/>
                    </a:cubicBezTo>
                    <a:cubicBezTo>
                      <a:pt x="5617" y="10045"/>
                      <a:pt x="6260" y="10594"/>
                      <a:pt x="6967" y="10997"/>
                    </a:cubicBezTo>
                    <a:cubicBezTo>
                      <a:pt x="8945" y="12124"/>
                      <a:pt x="9120" y="12008"/>
                      <a:pt x="10415" y="13312"/>
                    </a:cubicBezTo>
                    <a:cubicBezTo>
                      <a:pt x="10654" y="13552"/>
                      <a:pt x="10846" y="13826"/>
                      <a:pt x="11062" y="14083"/>
                    </a:cubicBezTo>
                    <a:cubicBezTo>
                      <a:pt x="11238" y="14556"/>
                      <a:pt x="11375" y="15016"/>
                      <a:pt x="11708" y="15434"/>
                    </a:cubicBezTo>
                    <a:cubicBezTo>
                      <a:pt x="11885" y="15656"/>
                      <a:pt x="12107" y="15854"/>
                      <a:pt x="12355" y="16013"/>
                    </a:cubicBezTo>
                    <a:cubicBezTo>
                      <a:pt x="12616" y="16180"/>
                      <a:pt x="12930" y="16270"/>
                      <a:pt x="13217" y="16398"/>
                    </a:cubicBezTo>
                    <a:cubicBezTo>
                      <a:pt x="13863" y="16334"/>
                      <a:pt x="14514" y="16296"/>
                      <a:pt x="15157" y="16206"/>
                    </a:cubicBezTo>
                    <a:cubicBezTo>
                      <a:pt x="15880" y="16103"/>
                      <a:pt x="17312" y="15820"/>
                      <a:pt x="17312" y="15820"/>
                    </a:cubicBezTo>
                    <a:cubicBezTo>
                      <a:pt x="17528" y="15627"/>
                      <a:pt x="17694" y="15376"/>
                      <a:pt x="17959" y="15241"/>
                    </a:cubicBezTo>
                    <a:cubicBezTo>
                      <a:pt x="18216" y="15109"/>
                      <a:pt x="18589" y="15214"/>
                      <a:pt x="18821" y="15048"/>
                    </a:cubicBezTo>
                    <a:cubicBezTo>
                      <a:pt x="18998" y="14921"/>
                      <a:pt x="18956" y="14660"/>
                      <a:pt x="19036" y="14469"/>
                    </a:cubicBezTo>
                    <a:cubicBezTo>
                      <a:pt x="19172" y="14145"/>
                      <a:pt x="19324" y="13826"/>
                      <a:pt x="19467" y="13505"/>
                    </a:cubicBezTo>
                    <a:cubicBezTo>
                      <a:pt x="19395" y="12797"/>
                      <a:pt x="19470" y="12065"/>
                      <a:pt x="19252" y="11382"/>
                    </a:cubicBezTo>
                    <a:cubicBezTo>
                      <a:pt x="19168" y="11120"/>
                      <a:pt x="18800" y="11013"/>
                      <a:pt x="18605" y="10804"/>
                    </a:cubicBezTo>
                    <a:cubicBezTo>
                      <a:pt x="17855" y="9998"/>
                      <a:pt x="18589" y="10349"/>
                      <a:pt x="17528" y="10032"/>
                    </a:cubicBezTo>
                    <a:cubicBezTo>
                      <a:pt x="16953" y="10161"/>
                      <a:pt x="16258" y="10078"/>
                      <a:pt x="15803" y="10418"/>
                    </a:cubicBezTo>
                    <a:cubicBezTo>
                      <a:pt x="15310" y="10786"/>
                      <a:pt x="14941" y="11961"/>
                      <a:pt x="14941" y="11961"/>
                    </a:cubicBezTo>
                    <a:cubicBezTo>
                      <a:pt x="14869" y="12283"/>
                      <a:pt x="14726" y="12598"/>
                      <a:pt x="14726" y="12926"/>
                    </a:cubicBezTo>
                    <a:cubicBezTo>
                      <a:pt x="14726" y="13365"/>
                      <a:pt x="14926" y="14150"/>
                      <a:pt x="15372" y="14469"/>
                    </a:cubicBezTo>
                    <a:cubicBezTo>
                      <a:pt x="15550" y="14596"/>
                      <a:pt x="15803" y="14598"/>
                      <a:pt x="16019" y="14662"/>
                    </a:cubicBezTo>
                    <a:cubicBezTo>
                      <a:pt x="15731" y="14148"/>
                      <a:pt x="15487" y="13612"/>
                      <a:pt x="15157" y="13119"/>
                    </a:cubicBezTo>
                    <a:cubicBezTo>
                      <a:pt x="14393" y="11980"/>
                      <a:pt x="14643" y="12510"/>
                      <a:pt x="14295" y="11575"/>
                    </a:cubicBezTo>
                    <a:cubicBezTo>
                      <a:pt x="14366" y="10932"/>
                      <a:pt x="14400" y="10285"/>
                      <a:pt x="14510" y="9646"/>
                    </a:cubicBezTo>
                    <a:cubicBezTo>
                      <a:pt x="14545" y="9445"/>
                      <a:pt x="14663" y="9263"/>
                      <a:pt x="14726" y="9067"/>
                    </a:cubicBezTo>
                    <a:cubicBezTo>
                      <a:pt x="14807" y="8812"/>
                      <a:pt x="14847" y="8547"/>
                      <a:pt x="14941" y="8296"/>
                    </a:cubicBezTo>
                    <a:cubicBezTo>
                      <a:pt x="15064" y="7967"/>
                      <a:pt x="15261" y="7663"/>
                      <a:pt x="15372" y="7331"/>
                    </a:cubicBezTo>
                    <a:cubicBezTo>
                      <a:pt x="15477" y="7017"/>
                      <a:pt x="15516" y="6688"/>
                      <a:pt x="15588" y="6366"/>
                    </a:cubicBezTo>
                    <a:cubicBezTo>
                      <a:pt x="15516" y="5595"/>
                      <a:pt x="15595" y="4800"/>
                      <a:pt x="15372" y="4051"/>
                    </a:cubicBezTo>
                    <a:cubicBezTo>
                      <a:pt x="15294" y="3788"/>
                      <a:pt x="14974" y="3631"/>
                      <a:pt x="14726" y="3473"/>
                    </a:cubicBezTo>
                    <a:cubicBezTo>
                      <a:pt x="14259" y="3175"/>
                      <a:pt x="13745" y="3051"/>
                      <a:pt x="13217" y="2894"/>
                    </a:cubicBezTo>
                    <a:cubicBezTo>
                      <a:pt x="13001" y="3022"/>
                      <a:pt x="12641" y="3057"/>
                      <a:pt x="12570" y="3280"/>
                    </a:cubicBezTo>
                    <a:cubicBezTo>
                      <a:pt x="12470" y="3595"/>
                      <a:pt x="12527" y="4012"/>
                      <a:pt x="12786" y="4244"/>
                    </a:cubicBezTo>
                    <a:cubicBezTo>
                      <a:pt x="12946" y="4388"/>
                      <a:pt x="12930" y="3859"/>
                      <a:pt x="13001" y="3666"/>
                    </a:cubicBezTo>
                    <a:cubicBezTo>
                      <a:pt x="12570" y="3601"/>
                      <a:pt x="12135" y="3557"/>
                      <a:pt x="11708" y="3473"/>
                    </a:cubicBezTo>
                    <a:cubicBezTo>
                      <a:pt x="11486" y="3429"/>
                      <a:pt x="11289" y="3280"/>
                      <a:pt x="11062" y="3280"/>
                    </a:cubicBezTo>
                    <a:cubicBezTo>
                      <a:pt x="10482" y="3280"/>
                      <a:pt x="9912" y="3408"/>
                      <a:pt x="9337" y="3473"/>
                    </a:cubicBezTo>
                    <a:cubicBezTo>
                      <a:pt x="9266" y="3666"/>
                      <a:pt x="9097" y="3849"/>
                      <a:pt x="9122" y="4051"/>
                    </a:cubicBezTo>
                    <a:cubicBezTo>
                      <a:pt x="9172" y="4456"/>
                      <a:pt x="9332" y="4853"/>
                      <a:pt x="9553" y="5209"/>
                    </a:cubicBezTo>
                    <a:cubicBezTo>
                      <a:pt x="9736" y="5504"/>
                      <a:pt x="10495" y="6017"/>
                      <a:pt x="10846" y="6174"/>
                    </a:cubicBezTo>
                    <a:cubicBezTo>
                      <a:pt x="11049" y="6264"/>
                      <a:pt x="11277" y="6302"/>
                      <a:pt x="11493" y="6366"/>
                    </a:cubicBezTo>
                    <a:cubicBezTo>
                      <a:pt x="11852" y="6302"/>
                      <a:pt x="12406" y="6467"/>
                      <a:pt x="12570" y="6174"/>
                    </a:cubicBezTo>
                    <a:cubicBezTo>
                      <a:pt x="12797" y="5767"/>
                      <a:pt x="12454" y="5269"/>
                      <a:pt x="12355" y="4823"/>
                    </a:cubicBezTo>
                    <a:cubicBezTo>
                      <a:pt x="12310" y="4624"/>
                      <a:pt x="12285" y="4401"/>
                      <a:pt x="12139" y="4244"/>
                    </a:cubicBezTo>
                    <a:cubicBezTo>
                      <a:pt x="11909" y="3997"/>
                      <a:pt x="11587" y="3828"/>
                      <a:pt x="11277" y="3666"/>
                    </a:cubicBezTo>
                    <a:cubicBezTo>
                      <a:pt x="9785" y="2886"/>
                      <a:pt x="9947" y="2982"/>
                      <a:pt x="8691" y="2701"/>
                    </a:cubicBezTo>
                    <a:cubicBezTo>
                      <a:pt x="8044" y="2765"/>
                      <a:pt x="7362" y="2695"/>
                      <a:pt x="6751" y="2894"/>
                    </a:cubicBezTo>
                    <a:cubicBezTo>
                      <a:pt x="5286" y="3371"/>
                      <a:pt x="7362" y="3784"/>
                      <a:pt x="5673" y="3280"/>
                    </a:cubicBezTo>
                    <a:cubicBezTo>
                      <a:pt x="5458" y="3151"/>
                      <a:pt x="5286" y="2894"/>
                      <a:pt x="5027" y="2894"/>
                    </a:cubicBezTo>
                    <a:cubicBezTo>
                      <a:pt x="4768" y="2894"/>
                      <a:pt x="4542" y="3099"/>
                      <a:pt x="4380" y="3280"/>
                    </a:cubicBezTo>
                    <a:cubicBezTo>
                      <a:pt x="4238" y="3439"/>
                      <a:pt x="4266" y="3677"/>
                      <a:pt x="4165" y="3858"/>
                    </a:cubicBezTo>
                    <a:cubicBezTo>
                      <a:pt x="3329" y="5354"/>
                      <a:pt x="4060" y="3561"/>
                      <a:pt x="3518" y="5016"/>
                    </a:cubicBezTo>
                    <a:cubicBezTo>
                      <a:pt x="3446" y="5466"/>
                      <a:pt x="3620" y="6011"/>
                      <a:pt x="3303" y="6366"/>
                    </a:cubicBezTo>
                    <a:cubicBezTo>
                      <a:pt x="3141" y="6548"/>
                      <a:pt x="2850" y="6135"/>
                      <a:pt x="2656" y="5981"/>
                    </a:cubicBezTo>
                    <a:cubicBezTo>
                      <a:pt x="2200" y="5618"/>
                      <a:pt x="1363" y="4823"/>
                      <a:pt x="1363" y="4823"/>
                    </a:cubicBezTo>
                    <a:cubicBezTo>
                      <a:pt x="1291" y="4630"/>
                      <a:pt x="1237" y="4431"/>
                      <a:pt x="1147" y="4244"/>
                    </a:cubicBezTo>
                    <a:cubicBezTo>
                      <a:pt x="1021" y="3980"/>
                      <a:pt x="818" y="3745"/>
                      <a:pt x="716" y="3473"/>
                    </a:cubicBezTo>
                    <a:cubicBezTo>
                      <a:pt x="600" y="3162"/>
                      <a:pt x="573" y="2830"/>
                      <a:pt x="501" y="2508"/>
                    </a:cubicBezTo>
                    <a:cubicBezTo>
                      <a:pt x="644" y="1801"/>
                      <a:pt x="551" y="1019"/>
                      <a:pt x="932" y="386"/>
                    </a:cubicBezTo>
                    <a:cubicBezTo>
                      <a:pt x="1115" y="81"/>
                      <a:pt x="1623" y="12"/>
                      <a:pt x="2009" y="0"/>
                    </a:cubicBezTo>
                    <a:lnTo>
                      <a:pt x="7182" y="193"/>
                    </a:lnTo>
                    <a:cubicBezTo>
                      <a:pt x="7917" y="412"/>
                      <a:pt x="8841" y="663"/>
                      <a:pt x="9553" y="965"/>
                    </a:cubicBezTo>
                    <a:cubicBezTo>
                      <a:pt x="13222" y="2520"/>
                      <a:pt x="11378" y="2048"/>
                      <a:pt x="13432" y="2508"/>
                    </a:cubicBezTo>
                    <a:cubicBezTo>
                      <a:pt x="13792" y="2701"/>
                      <a:pt x="14135" y="2919"/>
                      <a:pt x="14510" y="3087"/>
                    </a:cubicBezTo>
                    <a:cubicBezTo>
                      <a:pt x="14856" y="3242"/>
                      <a:pt x="15266" y="3281"/>
                      <a:pt x="15588" y="3473"/>
                    </a:cubicBezTo>
                    <a:cubicBezTo>
                      <a:pt x="15926" y="3674"/>
                      <a:pt x="16162" y="3987"/>
                      <a:pt x="16450" y="4244"/>
                    </a:cubicBezTo>
                    <a:cubicBezTo>
                      <a:pt x="16594" y="4502"/>
                      <a:pt x="16768" y="4747"/>
                      <a:pt x="16881" y="5016"/>
                    </a:cubicBezTo>
                    <a:cubicBezTo>
                      <a:pt x="17296" y="6006"/>
                      <a:pt x="16902" y="5651"/>
                      <a:pt x="17312" y="6752"/>
                    </a:cubicBezTo>
                    <a:cubicBezTo>
                      <a:pt x="17414" y="7025"/>
                      <a:pt x="17556" y="7290"/>
                      <a:pt x="17743" y="7524"/>
                    </a:cubicBezTo>
                    <a:cubicBezTo>
                      <a:pt x="17920" y="7746"/>
                      <a:pt x="18174" y="7910"/>
                      <a:pt x="18390" y="8103"/>
                    </a:cubicBezTo>
                    <a:cubicBezTo>
                      <a:pt x="18893" y="8038"/>
                      <a:pt x="19434" y="8094"/>
                      <a:pt x="19898" y="7910"/>
                    </a:cubicBezTo>
                    <a:cubicBezTo>
                      <a:pt x="20135" y="7816"/>
                      <a:pt x="20213" y="7538"/>
                      <a:pt x="20329" y="7331"/>
                    </a:cubicBezTo>
                    <a:cubicBezTo>
                      <a:pt x="20802" y="6485"/>
                      <a:pt x="20774" y="6306"/>
                      <a:pt x="20976" y="5402"/>
                    </a:cubicBezTo>
                    <a:cubicBezTo>
                      <a:pt x="20904" y="4694"/>
                      <a:pt x="21011" y="3954"/>
                      <a:pt x="20760" y="3280"/>
                    </a:cubicBezTo>
                    <a:cubicBezTo>
                      <a:pt x="20632" y="2935"/>
                      <a:pt x="20219" y="2731"/>
                      <a:pt x="19898" y="2508"/>
                    </a:cubicBezTo>
                    <a:cubicBezTo>
                      <a:pt x="19568" y="2278"/>
                      <a:pt x="19176" y="2128"/>
                      <a:pt x="18821" y="1929"/>
                    </a:cubicBezTo>
                    <a:cubicBezTo>
                      <a:pt x="18601" y="1806"/>
                      <a:pt x="18406" y="1647"/>
                      <a:pt x="18174" y="1543"/>
                    </a:cubicBezTo>
                    <a:cubicBezTo>
                      <a:pt x="17865" y="1405"/>
                      <a:pt x="16942" y="1219"/>
                      <a:pt x="16665" y="1158"/>
                    </a:cubicBezTo>
                    <a:cubicBezTo>
                      <a:pt x="16450" y="1222"/>
                      <a:pt x="16161" y="1192"/>
                      <a:pt x="16019" y="1350"/>
                    </a:cubicBezTo>
                    <a:cubicBezTo>
                      <a:pt x="15834" y="1558"/>
                      <a:pt x="15867" y="1863"/>
                      <a:pt x="15803" y="2122"/>
                    </a:cubicBezTo>
                    <a:cubicBezTo>
                      <a:pt x="15724" y="2442"/>
                      <a:pt x="15660" y="2765"/>
                      <a:pt x="15588" y="3087"/>
                    </a:cubicBezTo>
                    <a:cubicBezTo>
                      <a:pt x="15731" y="4180"/>
                      <a:pt x="15778" y="5287"/>
                      <a:pt x="16019" y="6366"/>
                    </a:cubicBezTo>
                    <a:cubicBezTo>
                      <a:pt x="16070" y="6594"/>
                      <a:pt x="16334" y="6738"/>
                      <a:pt x="16450" y="6945"/>
                    </a:cubicBezTo>
                    <a:cubicBezTo>
                      <a:pt x="16551" y="7127"/>
                      <a:pt x="16555" y="7346"/>
                      <a:pt x="16665" y="7524"/>
                    </a:cubicBezTo>
                    <a:cubicBezTo>
                      <a:pt x="16917" y="7929"/>
                      <a:pt x="17528" y="8682"/>
                      <a:pt x="17528" y="8682"/>
                    </a:cubicBezTo>
                    <a:cubicBezTo>
                      <a:pt x="17650" y="9229"/>
                      <a:pt x="17959" y="10518"/>
                      <a:pt x="17959" y="10997"/>
                    </a:cubicBezTo>
                    <a:cubicBezTo>
                      <a:pt x="17959" y="11899"/>
                      <a:pt x="17918" y="12809"/>
                      <a:pt x="17743" y="13698"/>
                    </a:cubicBezTo>
                    <a:cubicBezTo>
                      <a:pt x="17698" y="13926"/>
                      <a:pt x="17456" y="14083"/>
                      <a:pt x="17312" y="14276"/>
                    </a:cubicBezTo>
                    <a:cubicBezTo>
                      <a:pt x="17240" y="14534"/>
                      <a:pt x="17200" y="14800"/>
                      <a:pt x="17096" y="15048"/>
                    </a:cubicBezTo>
                    <a:cubicBezTo>
                      <a:pt x="16749" y="15878"/>
                      <a:pt x="16287" y="16281"/>
                      <a:pt x="15588" y="16977"/>
                    </a:cubicBezTo>
                    <a:cubicBezTo>
                      <a:pt x="15316" y="17248"/>
                      <a:pt x="15056" y="17537"/>
                      <a:pt x="14726" y="17749"/>
                    </a:cubicBezTo>
                    <a:cubicBezTo>
                      <a:pt x="14559" y="17855"/>
                      <a:pt x="13307" y="18115"/>
                      <a:pt x="13217" y="18135"/>
                    </a:cubicBezTo>
                    <a:cubicBezTo>
                      <a:pt x="12798" y="18097"/>
                      <a:pt x="10947" y="18236"/>
                      <a:pt x="10415" y="17556"/>
                    </a:cubicBezTo>
                    <a:cubicBezTo>
                      <a:pt x="10046" y="17085"/>
                      <a:pt x="9553" y="16013"/>
                      <a:pt x="9553" y="16013"/>
                    </a:cubicBezTo>
                    <a:cubicBezTo>
                      <a:pt x="9768" y="15948"/>
                      <a:pt x="9972" y="15820"/>
                      <a:pt x="10199" y="15820"/>
                    </a:cubicBezTo>
                    <a:cubicBezTo>
                      <a:pt x="10517" y="15820"/>
                      <a:pt x="11540" y="16323"/>
                      <a:pt x="11708" y="16398"/>
                    </a:cubicBezTo>
                    <a:cubicBezTo>
                      <a:pt x="11924" y="16720"/>
                      <a:pt x="12185" y="17020"/>
                      <a:pt x="12355" y="17363"/>
                    </a:cubicBezTo>
                    <a:cubicBezTo>
                      <a:pt x="12475" y="17605"/>
                      <a:pt x="12489" y="17880"/>
                      <a:pt x="12570" y="18135"/>
                    </a:cubicBezTo>
                    <a:cubicBezTo>
                      <a:pt x="12633" y="18330"/>
                      <a:pt x="12714" y="18521"/>
                      <a:pt x="12786" y="18713"/>
                    </a:cubicBezTo>
                    <a:cubicBezTo>
                      <a:pt x="12774" y="18755"/>
                      <a:pt x="12465" y="19945"/>
                      <a:pt x="12355" y="20064"/>
                    </a:cubicBezTo>
                    <a:cubicBezTo>
                      <a:pt x="12125" y="20311"/>
                      <a:pt x="11814" y="20499"/>
                      <a:pt x="11493" y="20643"/>
                    </a:cubicBezTo>
                    <a:cubicBezTo>
                      <a:pt x="11086" y="20825"/>
                      <a:pt x="10199" y="21029"/>
                      <a:pt x="10199" y="21029"/>
                    </a:cubicBezTo>
                    <a:cubicBezTo>
                      <a:pt x="9703" y="20955"/>
                      <a:pt x="8790" y="20880"/>
                      <a:pt x="8260" y="20643"/>
                    </a:cubicBezTo>
                    <a:cubicBezTo>
                      <a:pt x="8028" y="20539"/>
                      <a:pt x="7829" y="20386"/>
                      <a:pt x="7613" y="20257"/>
                    </a:cubicBezTo>
                    <a:cubicBezTo>
                      <a:pt x="7469" y="20000"/>
                      <a:pt x="7267" y="19763"/>
                      <a:pt x="7182" y="19485"/>
                    </a:cubicBezTo>
                    <a:cubicBezTo>
                      <a:pt x="6736" y="18021"/>
                      <a:pt x="7488" y="17823"/>
                      <a:pt x="6320" y="18521"/>
                    </a:cubicBezTo>
                    <a:lnTo>
                      <a:pt x="5027" y="18328"/>
                    </a:lnTo>
                    <a:cubicBezTo>
                      <a:pt x="4793" y="17909"/>
                      <a:pt x="4999" y="17201"/>
                      <a:pt x="5458" y="16977"/>
                    </a:cubicBezTo>
                    <a:cubicBezTo>
                      <a:pt x="6029" y="16698"/>
                      <a:pt x="6751" y="17106"/>
                      <a:pt x="7398" y="17170"/>
                    </a:cubicBezTo>
                    <a:cubicBezTo>
                      <a:pt x="6973" y="20593"/>
                      <a:pt x="7795" y="18004"/>
                      <a:pt x="6536" y="19292"/>
                    </a:cubicBezTo>
                    <a:cubicBezTo>
                      <a:pt x="6194" y="19641"/>
                      <a:pt x="5673" y="20450"/>
                      <a:pt x="5673" y="20450"/>
                    </a:cubicBezTo>
                    <a:cubicBezTo>
                      <a:pt x="7601" y="21312"/>
                      <a:pt x="6788" y="21040"/>
                      <a:pt x="8044" y="21414"/>
                    </a:cubicBezTo>
                    <a:cubicBezTo>
                      <a:pt x="9231" y="21318"/>
                      <a:pt x="12151" y="21600"/>
                      <a:pt x="13648" y="20643"/>
                    </a:cubicBezTo>
                    <a:cubicBezTo>
                      <a:pt x="13896" y="20484"/>
                      <a:pt x="14051" y="20228"/>
                      <a:pt x="14295" y="20064"/>
                    </a:cubicBezTo>
                    <a:cubicBezTo>
                      <a:pt x="14630" y="19839"/>
                      <a:pt x="15024" y="19693"/>
                      <a:pt x="15372" y="19485"/>
                    </a:cubicBezTo>
                    <a:cubicBezTo>
                      <a:pt x="15671" y="19307"/>
                      <a:pt x="15940" y="19091"/>
                      <a:pt x="16234" y="18906"/>
                    </a:cubicBezTo>
                    <a:cubicBezTo>
                      <a:pt x="16659" y="18640"/>
                      <a:pt x="17528" y="18135"/>
                      <a:pt x="17528" y="18135"/>
                    </a:cubicBezTo>
                    <a:cubicBezTo>
                      <a:pt x="18060" y="16704"/>
                      <a:pt x="17755" y="17341"/>
                      <a:pt x="18390" y="16206"/>
                    </a:cubicBezTo>
                    <a:cubicBezTo>
                      <a:pt x="18318" y="15948"/>
                      <a:pt x="18439" y="15552"/>
                      <a:pt x="18174" y="15434"/>
                    </a:cubicBezTo>
                    <a:cubicBezTo>
                      <a:pt x="16855" y="14844"/>
                      <a:pt x="17145" y="15984"/>
                      <a:pt x="16881" y="16398"/>
                    </a:cubicBezTo>
                    <a:cubicBezTo>
                      <a:pt x="16730" y="16635"/>
                      <a:pt x="16450" y="16784"/>
                      <a:pt x="16234" y="16977"/>
                    </a:cubicBezTo>
                    <a:cubicBezTo>
                      <a:pt x="16091" y="17363"/>
                      <a:pt x="15660" y="17749"/>
                      <a:pt x="15803" y="18135"/>
                    </a:cubicBezTo>
                    <a:cubicBezTo>
                      <a:pt x="15947" y="18521"/>
                      <a:pt x="15993" y="18947"/>
                      <a:pt x="16234" y="19292"/>
                    </a:cubicBezTo>
                    <a:cubicBezTo>
                      <a:pt x="16652" y="19891"/>
                      <a:pt x="18213" y="19817"/>
                      <a:pt x="18605" y="19871"/>
                    </a:cubicBezTo>
                    <a:cubicBezTo>
                      <a:pt x="18967" y="19921"/>
                      <a:pt x="19324" y="20000"/>
                      <a:pt x="19683" y="20064"/>
                    </a:cubicBezTo>
                    <a:cubicBezTo>
                      <a:pt x="20114" y="20000"/>
                      <a:pt x="20585" y="20046"/>
                      <a:pt x="20976" y="19871"/>
                    </a:cubicBezTo>
                    <a:cubicBezTo>
                      <a:pt x="21208" y="19767"/>
                      <a:pt x="21407" y="19292"/>
                      <a:pt x="21407" y="19292"/>
                    </a:cubicBez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ctr">
                <a:noAutofit/>
              </a:bodyPr>
              <a:lstStyle/>
              <a:p>
                <a:pPr algn="ctr">
                  <a:defRPr>
                    <a:solidFill>
                      <a:srgbClr val="FFFFFF"/>
                    </a:solidFill>
                  </a:defRPr>
                </a:pPr>
                <a:endParaRPr sz="1200"/>
              </a:p>
            </p:txBody>
          </p:sp>
          <p:grpSp>
            <p:nvGrpSpPr>
              <p:cNvPr id="150" name="Group 4095"/>
              <p:cNvGrpSpPr/>
              <p:nvPr/>
            </p:nvGrpSpPr>
            <p:grpSpPr>
              <a:xfrm>
                <a:off x="4426" y="2413722"/>
                <a:ext cx="576981" cy="360870"/>
                <a:chOff x="0" y="0"/>
                <a:chExt cx="576980" cy="360868"/>
              </a:xfrm>
            </p:grpSpPr>
            <p:grpSp>
              <p:nvGrpSpPr>
                <p:cNvPr id="143" name="Group 86"/>
                <p:cNvGrpSpPr/>
                <p:nvPr/>
              </p:nvGrpSpPr>
              <p:grpSpPr>
                <a:xfrm>
                  <a:off x="-1" y="-1"/>
                  <a:ext cx="433282" cy="318636"/>
                  <a:chOff x="0" y="0"/>
                  <a:chExt cx="433280" cy="318635"/>
                </a:xfrm>
              </p:grpSpPr>
              <p:grpSp>
                <p:nvGrpSpPr>
                  <p:cNvPr id="137" name="Group 87"/>
                  <p:cNvGrpSpPr/>
                  <p:nvPr/>
                </p:nvGrpSpPr>
                <p:grpSpPr>
                  <a:xfrm>
                    <a:off x="59389" y="-1"/>
                    <a:ext cx="330077" cy="297147"/>
                    <a:chOff x="0" y="0"/>
                    <a:chExt cx="330075" cy="297146"/>
                  </a:xfrm>
                </p:grpSpPr>
                <p:sp>
                  <p:nvSpPr>
                    <p:cNvPr id="133" name="Freeform 93"/>
                    <p:cNvSpPr/>
                    <p:nvPr/>
                  </p:nvSpPr>
                  <p:spPr>
                    <a:xfrm>
                      <a:off x="30087" y="-1"/>
                      <a:ext cx="180521" cy="203314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716" extrusionOk="0">
                          <a:moveTo>
                            <a:pt x="21600" y="4781"/>
                          </a:moveTo>
                          <a:cubicBezTo>
                            <a:pt x="20700" y="3453"/>
                            <a:pt x="20137" y="1892"/>
                            <a:pt x="18900" y="797"/>
                          </a:cubicBezTo>
                          <a:cubicBezTo>
                            <a:pt x="17001" y="-884"/>
                            <a:pt x="12265" y="581"/>
                            <a:pt x="10800" y="797"/>
                          </a:cubicBezTo>
                          <a:cubicBezTo>
                            <a:pt x="10092" y="1737"/>
                            <a:pt x="7923" y="4164"/>
                            <a:pt x="8100" y="5578"/>
                          </a:cubicBezTo>
                          <a:cubicBezTo>
                            <a:pt x="8310" y="7247"/>
                            <a:pt x="9900" y="10358"/>
                            <a:pt x="9900" y="10358"/>
                          </a:cubicBezTo>
                          <a:cubicBezTo>
                            <a:pt x="9600" y="12483"/>
                            <a:pt x="9898" y="14744"/>
                            <a:pt x="9000" y="16732"/>
                          </a:cubicBezTo>
                          <a:cubicBezTo>
                            <a:pt x="8310" y="18261"/>
                            <a:pt x="3874" y="18863"/>
                            <a:pt x="2700" y="19123"/>
                          </a:cubicBezTo>
                          <a:lnTo>
                            <a:pt x="0" y="20716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34" name="Freeform 94"/>
                    <p:cNvSpPr/>
                    <p:nvPr/>
                  </p:nvSpPr>
                  <p:spPr>
                    <a:xfrm>
                      <a:off x="-1" y="109479"/>
                      <a:ext cx="210609" cy="86015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1600" extrusionOk="0">
                          <a:moveTo>
                            <a:pt x="0" y="0"/>
                          </a:moveTo>
                          <a:cubicBezTo>
                            <a:pt x="1162" y="2367"/>
                            <a:pt x="7153" y="15030"/>
                            <a:pt x="8486" y="15709"/>
                          </a:cubicBezTo>
                          <a:cubicBezTo>
                            <a:pt x="9771" y="16364"/>
                            <a:pt x="11078" y="16794"/>
                            <a:pt x="12343" y="17673"/>
                          </a:cubicBezTo>
                          <a:cubicBezTo>
                            <a:pt x="13912" y="18762"/>
                            <a:pt x="15345" y="21600"/>
                            <a:pt x="16971" y="21600"/>
                          </a:cubicBezTo>
                          <a:lnTo>
                            <a:pt x="21600" y="21600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35" name="Freeform 95"/>
                    <p:cNvSpPr/>
                    <p:nvPr/>
                  </p:nvSpPr>
                  <p:spPr>
                    <a:xfrm>
                      <a:off x="254858" y="17585"/>
                      <a:ext cx="75218" cy="102497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099" h="20001" extrusionOk="0">
                          <a:moveTo>
                            <a:pt x="0" y="6268"/>
                          </a:moveTo>
                          <a:cubicBezTo>
                            <a:pt x="3516" y="5759"/>
                            <a:pt x="7436" y="6029"/>
                            <a:pt x="10550" y="4742"/>
                          </a:cubicBezTo>
                          <a:cubicBezTo>
                            <a:pt x="21600" y="175"/>
                            <a:pt x="7455" y="-1599"/>
                            <a:pt x="21099" y="1690"/>
                          </a:cubicBezTo>
                          <a:cubicBezTo>
                            <a:pt x="18849" y="17961"/>
                            <a:pt x="18989" y="11837"/>
                            <a:pt x="18989" y="20001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36" name="Freeform 96"/>
                    <p:cNvSpPr/>
                    <p:nvPr/>
                  </p:nvSpPr>
                  <p:spPr>
                    <a:xfrm>
                      <a:off x="90260" y="257985"/>
                      <a:ext cx="195566" cy="39161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942" extrusionOk="0">
                          <a:moveTo>
                            <a:pt x="0" y="20942"/>
                          </a:moveTo>
                          <a:cubicBezTo>
                            <a:pt x="808" y="19316"/>
                            <a:pt x="5182" y="10035"/>
                            <a:pt x="6646" y="8397"/>
                          </a:cubicBezTo>
                          <a:cubicBezTo>
                            <a:pt x="8291" y="6558"/>
                            <a:pt x="9963" y="5414"/>
                            <a:pt x="11631" y="4215"/>
                          </a:cubicBezTo>
                          <a:cubicBezTo>
                            <a:pt x="18408" y="-658"/>
                            <a:pt x="16525" y="34"/>
                            <a:pt x="21600" y="34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</p:grpSp>
              <p:sp>
                <p:nvSpPr>
                  <p:cNvPr id="138" name="Oval 88"/>
                  <p:cNvSpPr/>
                  <p:nvPr/>
                </p:nvSpPr>
                <p:spPr>
                  <a:xfrm>
                    <a:off x="-1" y="36090"/>
                    <a:ext cx="72397" cy="81847"/>
                  </a:xfrm>
                  <a:prstGeom prst="ellipse">
                    <a:avLst/>
                  </a:prstGeom>
                  <a:solidFill>
                    <a:srgbClr val="FFFF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39" name="Oval 89"/>
                  <p:cNvSpPr/>
                  <p:nvPr/>
                </p:nvSpPr>
                <p:spPr>
                  <a:xfrm>
                    <a:off x="23034" y="186614"/>
                    <a:ext cx="72397" cy="81847"/>
                  </a:xfrm>
                  <a:prstGeom prst="ellipse">
                    <a:avLst/>
                  </a:prstGeom>
                  <a:solidFill>
                    <a:srgbClr val="FFFF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40" name="Oval 90"/>
                  <p:cNvSpPr/>
                  <p:nvPr/>
                </p:nvSpPr>
                <p:spPr>
                  <a:xfrm>
                    <a:off x="312620" y="236788"/>
                    <a:ext cx="72397" cy="81847"/>
                  </a:xfrm>
                  <a:prstGeom prst="ellipse">
                    <a:avLst/>
                  </a:prstGeom>
                  <a:solidFill>
                    <a:srgbClr val="FFFF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41" name="Oval 91"/>
                  <p:cNvSpPr/>
                  <p:nvPr/>
                </p:nvSpPr>
                <p:spPr>
                  <a:xfrm>
                    <a:off x="360884" y="117935"/>
                    <a:ext cx="72397" cy="81847"/>
                  </a:xfrm>
                  <a:prstGeom prst="ellipse">
                    <a:avLst/>
                  </a:prstGeom>
                  <a:solidFill>
                    <a:srgbClr val="FFFF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42" name="Oval 92"/>
                  <p:cNvSpPr/>
                  <p:nvPr/>
                </p:nvSpPr>
                <p:spPr>
                  <a:xfrm>
                    <a:off x="216091" y="17586"/>
                    <a:ext cx="72397" cy="81847"/>
                  </a:xfrm>
                  <a:prstGeom prst="ellipse">
                    <a:avLst/>
                  </a:prstGeom>
                  <a:solidFill>
                    <a:srgbClr val="FFFF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146" name="Group 364"/>
                <p:cNvGrpSpPr/>
                <p:nvPr/>
              </p:nvGrpSpPr>
              <p:grpSpPr>
                <a:xfrm>
                  <a:off x="394785" y="199779"/>
                  <a:ext cx="182196" cy="99350"/>
                  <a:chOff x="0" y="0"/>
                  <a:chExt cx="182195" cy="99348"/>
                </a:xfrm>
              </p:grpSpPr>
              <p:sp>
                <p:nvSpPr>
                  <p:cNvPr id="144" name="Freeform 370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145" name="Oval 371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FFFF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149" name="Group 388"/>
                <p:cNvGrpSpPr/>
                <p:nvPr/>
              </p:nvGrpSpPr>
              <p:grpSpPr>
                <a:xfrm>
                  <a:off x="36198" y="261519"/>
                  <a:ext cx="182196" cy="99350"/>
                  <a:chOff x="0" y="0"/>
                  <a:chExt cx="182195" cy="99348"/>
                </a:xfrm>
              </p:grpSpPr>
              <p:sp>
                <p:nvSpPr>
                  <p:cNvPr id="147" name="Freeform 389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148" name="Oval 390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FFFF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</p:grpSp>
          <p:grpSp>
            <p:nvGrpSpPr>
              <p:cNvPr id="168" name="Group 4098"/>
              <p:cNvGrpSpPr/>
              <p:nvPr/>
            </p:nvGrpSpPr>
            <p:grpSpPr>
              <a:xfrm>
                <a:off x="883299" y="2434839"/>
                <a:ext cx="595196" cy="318636"/>
                <a:chOff x="0" y="0"/>
                <a:chExt cx="595195" cy="318635"/>
              </a:xfrm>
            </p:grpSpPr>
            <p:grpSp>
              <p:nvGrpSpPr>
                <p:cNvPr id="161" name="Group 246"/>
                <p:cNvGrpSpPr/>
                <p:nvPr/>
              </p:nvGrpSpPr>
              <p:grpSpPr>
                <a:xfrm>
                  <a:off x="-1" y="-1"/>
                  <a:ext cx="433282" cy="318636"/>
                  <a:chOff x="0" y="0"/>
                  <a:chExt cx="433280" cy="318635"/>
                </a:xfrm>
              </p:grpSpPr>
              <p:grpSp>
                <p:nvGrpSpPr>
                  <p:cNvPr id="155" name="Group 247"/>
                  <p:cNvGrpSpPr/>
                  <p:nvPr/>
                </p:nvGrpSpPr>
                <p:grpSpPr>
                  <a:xfrm>
                    <a:off x="59389" y="-1"/>
                    <a:ext cx="349760" cy="297147"/>
                    <a:chOff x="0" y="0"/>
                    <a:chExt cx="349759" cy="297146"/>
                  </a:xfrm>
                </p:grpSpPr>
                <p:sp>
                  <p:nvSpPr>
                    <p:cNvPr id="151" name="Freeform 253"/>
                    <p:cNvSpPr/>
                    <p:nvPr/>
                  </p:nvSpPr>
                  <p:spPr>
                    <a:xfrm>
                      <a:off x="30087" y="-1"/>
                      <a:ext cx="180521" cy="203314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716" extrusionOk="0">
                          <a:moveTo>
                            <a:pt x="21600" y="4781"/>
                          </a:moveTo>
                          <a:cubicBezTo>
                            <a:pt x="20700" y="3453"/>
                            <a:pt x="20137" y="1892"/>
                            <a:pt x="18900" y="797"/>
                          </a:cubicBezTo>
                          <a:cubicBezTo>
                            <a:pt x="17001" y="-884"/>
                            <a:pt x="12265" y="581"/>
                            <a:pt x="10800" y="797"/>
                          </a:cubicBezTo>
                          <a:cubicBezTo>
                            <a:pt x="10092" y="1737"/>
                            <a:pt x="7923" y="4164"/>
                            <a:pt x="8100" y="5578"/>
                          </a:cubicBezTo>
                          <a:cubicBezTo>
                            <a:pt x="8310" y="7247"/>
                            <a:pt x="9900" y="10358"/>
                            <a:pt x="9900" y="10358"/>
                          </a:cubicBezTo>
                          <a:cubicBezTo>
                            <a:pt x="9600" y="12483"/>
                            <a:pt x="9898" y="14744"/>
                            <a:pt x="9000" y="16732"/>
                          </a:cubicBezTo>
                          <a:cubicBezTo>
                            <a:pt x="8310" y="18261"/>
                            <a:pt x="3874" y="18863"/>
                            <a:pt x="2700" y="19123"/>
                          </a:cubicBezTo>
                          <a:lnTo>
                            <a:pt x="0" y="20716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52" name="Freeform 254"/>
                    <p:cNvSpPr/>
                    <p:nvPr/>
                  </p:nvSpPr>
                  <p:spPr>
                    <a:xfrm>
                      <a:off x="-1" y="109479"/>
                      <a:ext cx="210609" cy="86015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1600" extrusionOk="0">
                          <a:moveTo>
                            <a:pt x="0" y="0"/>
                          </a:moveTo>
                          <a:cubicBezTo>
                            <a:pt x="1162" y="2367"/>
                            <a:pt x="7153" y="15030"/>
                            <a:pt x="8486" y="15709"/>
                          </a:cubicBezTo>
                          <a:cubicBezTo>
                            <a:pt x="9771" y="16364"/>
                            <a:pt x="11078" y="16794"/>
                            <a:pt x="12343" y="17673"/>
                          </a:cubicBezTo>
                          <a:cubicBezTo>
                            <a:pt x="13912" y="18762"/>
                            <a:pt x="15345" y="21600"/>
                            <a:pt x="16971" y="21600"/>
                          </a:cubicBezTo>
                          <a:lnTo>
                            <a:pt x="21600" y="21600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53" name="Freeform 255"/>
                    <p:cNvSpPr/>
                    <p:nvPr/>
                  </p:nvSpPr>
                  <p:spPr>
                    <a:xfrm>
                      <a:off x="274542" y="17585"/>
                      <a:ext cx="75218" cy="102496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099" h="20001" extrusionOk="0">
                          <a:moveTo>
                            <a:pt x="0" y="6268"/>
                          </a:moveTo>
                          <a:cubicBezTo>
                            <a:pt x="3516" y="5759"/>
                            <a:pt x="7436" y="6029"/>
                            <a:pt x="10550" y="4742"/>
                          </a:cubicBezTo>
                          <a:cubicBezTo>
                            <a:pt x="21600" y="175"/>
                            <a:pt x="7455" y="-1599"/>
                            <a:pt x="21099" y="1690"/>
                          </a:cubicBezTo>
                          <a:cubicBezTo>
                            <a:pt x="18849" y="17961"/>
                            <a:pt x="18989" y="11837"/>
                            <a:pt x="18989" y="20001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54" name="Freeform 256"/>
                    <p:cNvSpPr/>
                    <p:nvPr/>
                  </p:nvSpPr>
                  <p:spPr>
                    <a:xfrm>
                      <a:off x="90260" y="257985"/>
                      <a:ext cx="195566" cy="39161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942" extrusionOk="0">
                          <a:moveTo>
                            <a:pt x="0" y="20942"/>
                          </a:moveTo>
                          <a:cubicBezTo>
                            <a:pt x="808" y="19316"/>
                            <a:pt x="5182" y="10035"/>
                            <a:pt x="6646" y="8397"/>
                          </a:cubicBezTo>
                          <a:cubicBezTo>
                            <a:pt x="8291" y="6558"/>
                            <a:pt x="9963" y="5414"/>
                            <a:pt x="11631" y="4215"/>
                          </a:cubicBezTo>
                          <a:cubicBezTo>
                            <a:pt x="18408" y="-658"/>
                            <a:pt x="16525" y="34"/>
                            <a:pt x="21600" y="34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</p:grpSp>
              <p:sp>
                <p:nvSpPr>
                  <p:cNvPr id="156" name="Oval 248"/>
                  <p:cNvSpPr/>
                  <p:nvPr/>
                </p:nvSpPr>
                <p:spPr>
                  <a:xfrm>
                    <a:off x="-1" y="36090"/>
                    <a:ext cx="72397" cy="81847"/>
                  </a:xfrm>
                  <a:prstGeom prst="ellipse">
                    <a:avLst/>
                  </a:prstGeom>
                  <a:solidFill>
                    <a:srgbClr val="FF0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57" name="Oval 249"/>
                  <p:cNvSpPr/>
                  <p:nvPr/>
                </p:nvSpPr>
                <p:spPr>
                  <a:xfrm>
                    <a:off x="23034" y="186614"/>
                    <a:ext cx="72397" cy="81847"/>
                  </a:xfrm>
                  <a:prstGeom prst="ellipse">
                    <a:avLst/>
                  </a:prstGeom>
                  <a:solidFill>
                    <a:srgbClr val="FF0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58" name="Oval 250"/>
                  <p:cNvSpPr/>
                  <p:nvPr/>
                </p:nvSpPr>
                <p:spPr>
                  <a:xfrm>
                    <a:off x="312620" y="236788"/>
                    <a:ext cx="72397" cy="81847"/>
                  </a:xfrm>
                  <a:prstGeom prst="ellipse">
                    <a:avLst/>
                  </a:prstGeom>
                  <a:solidFill>
                    <a:srgbClr val="FF0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59" name="Oval 251"/>
                  <p:cNvSpPr/>
                  <p:nvPr/>
                </p:nvSpPr>
                <p:spPr>
                  <a:xfrm>
                    <a:off x="360884" y="117935"/>
                    <a:ext cx="72397" cy="81847"/>
                  </a:xfrm>
                  <a:prstGeom prst="ellipse">
                    <a:avLst/>
                  </a:prstGeom>
                  <a:solidFill>
                    <a:srgbClr val="FF0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60" name="Oval 252"/>
                  <p:cNvSpPr/>
                  <p:nvPr/>
                </p:nvSpPr>
                <p:spPr>
                  <a:xfrm>
                    <a:off x="216092" y="27547"/>
                    <a:ext cx="72397" cy="81847"/>
                  </a:xfrm>
                  <a:prstGeom prst="ellipse">
                    <a:avLst/>
                  </a:prstGeom>
                  <a:solidFill>
                    <a:srgbClr val="FF0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164" name="Group 373"/>
                <p:cNvGrpSpPr/>
                <p:nvPr/>
              </p:nvGrpSpPr>
              <p:grpSpPr>
                <a:xfrm>
                  <a:off x="413000" y="179948"/>
                  <a:ext cx="182196" cy="121024"/>
                  <a:chOff x="0" y="0"/>
                  <a:chExt cx="182195" cy="121022"/>
                </a:xfrm>
              </p:grpSpPr>
              <p:sp>
                <p:nvSpPr>
                  <p:cNvPr id="162" name="Freeform 374"/>
                  <p:cNvSpPr/>
                  <p:nvPr/>
                </p:nvSpPr>
                <p:spPr>
                  <a:xfrm rot="16200000">
                    <a:off x="13639" y="32166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163" name="Oval 375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FF0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167" name="Group 394"/>
                <p:cNvGrpSpPr/>
                <p:nvPr/>
              </p:nvGrpSpPr>
              <p:grpSpPr>
                <a:xfrm>
                  <a:off x="155935" y="145818"/>
                  <a:ext cx="182196" cy="99350"/>
                  <a:chOff x="0" y="0"/>
                  <a:chExt cx="182195" cy="99348"/>
                </a:xfrm>
              </p:grpSpPr>
              <p:sp>
                <p:nvSpPr>
                  <p:cNvPr id="165" name="Freeform 395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166" name="Oval 396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FF0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</p:grpSp>
          <p:grpSp>
            <p:nvGrpSpPr>
              <p:cNvPr id="186" name="Group 4101"/>
              <p:cNvGrpSpPr/>
              <p:nvPr/>
            </p:nvGrpSpPr>
            <p:grpSpPr>
              <a:xfrm>
                <a:off x="1780387" y="2434839"/>
                <a:ext cx="531014" cy="318636"/>
                <a:chOff x="0" y="0"/>
                <a:chExt cx="531013" cy="318635"/>
              </a:xfrm>
            </p:grpSpPr>
            <p:grpSp>
              <p:nvGrpSpPr>
                <p:cNvPr id="179" name="Group 81"/>
                <p:cNvGrpSpPr/>
                <p:nvPr/>
              </p:nvGrpSpPr>
              <p:grpSpPr>
                <a:xfrm>
                  <a:off x="-1" y="-1"/>
                  <a:ext cx="433282" cy="318636"/>
                  <a:chOff x="0" y="0"/>
                  <a:chExt cx="433280" cy="318635"/>
                </a:xfrm>
              </p:grpSpPr>
              <p:grpSp>
                <p:nvGrpSpPr>
                  <p:cNvPr id="173" name="Group 137"/>
                  <p:cNvGrpSpPr/>
                  <p:nvPr/>
                </p:nvGrpSpPr>
                <p:grpSpPr>
                  <a:xfrm>
                    <a:off x="59389" y="-1"/>
                    <a:ext cx="349760" cy="297147"/>
                    <a:chOff x="0" y="0"/>
                    <a:chExt cx="349759" cy="297146"/>
                  </a:xfrm>
                </p:grpSpPr>
                <p:sp>
                  <p:nvSpPr>
                    <p:cNvPr id="169" name="Freeform 143"/>
                    <p:cNvSpPr/>
                    <p:nvPr/>
                  </p:nvSpPr>
                  <p:spPr>
                    <a:xfrm>
                      <a:off x="30087" y="-1"/>
                      <a:ext cx="180521" cy="203314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716" extrusionOk="0">
                          <a:moveTo>
                            <a:pt x="21600" y="4781"/>
                          </a:moveTo>
                          <a:cubicBezTo>
                            <a:pt x="20700" y="3453"/>
                            <a:pt x="20137" y="1892"/>
                            <a:pt x="18900" y="797"/>
                          </a:cubicBezTo>
                          <a:cubicBezTo>
                            <a:pt x="17001" y="-884"/>
                            <a:pt x="12265" y="581"/>
                            <a:pt x="10800" y="797"/>
                          </a:cubicBezTo>
                          <a:cubicBezTo>
                            <a:pt x="10092" y="1737"/>
                            <a:pt x="7923" y="4164"/>
                            <a:pt x="8100" y="5578"/>
                          </a:cubicBezTo>
                          <a:cubicBezTo>
                            <a:pt x="8310" y="7247"/>
                            <a:pt x="9900" y="10358"/>
                            <a:pt x="9900" y="10358"/>
                          </a:cubicBezTo>
                          <a:cubicBezTo>
                            <a:pt x="9600" y="12483"/>
                            <a:pt x="9898" y="14744"/>
                            <a:pt x="9000" y="16732"/>
                          </a:cubicBezTo>
                          <a:cubicBezTo>
                            <a:pt x="8310" y="18261"/>
                            <a:pt x="3874" y="18863"/>
                            <a:pt x="2700" y="19123"/>
                          </a:cubicBezTo>
                          <a:lnTo>
                            <a:pt x="0" y="20716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70" name="Freeform 144"/>
                    <p:cNvSpPr/>
                    <p:nvPr/>
                  </p:nvSpPr>
                  <p:spPr>
                    <a:xfrm>
                      <a:off x="-1" y="109479"/>
                      <a:ext cx="210609" cy="86015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1600" extrusionOk="0">
                          <a:moveTo>
                            <a:pt x="0" y="0"/>
                          </a:moveTo>
                          <a:cubicBezTo>
                            <a:pt x="1162" y="2367"/>
                            <a:pt x="7153" y="15030"/>
                            <a:pt x="8486" y="15709"/>
                          </a:cubicBezTo>
                          <a:cubicBezTo>
                            <a:pt x="9771" y="16364"/>
                            <a:pt x="11078" y="16794"/>
                            <a:pt x="12343" y="17673"/>
                          </a:cubicBezTo>
                          <a:cubicBezTo>
                            <a:pt x="13912" y="18762"/>
                            <a:pt x="15345" y="21600"/>
                            <a:pt x="16971" y="21600"/>
                          </a:cubicBezTo>
                          <a:lnTo>
                            <a:pt x="21600" y="21600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71" name="Freeform 145"/>
                    <p:cNvSpPr/>
                    <p:nvPr/>
                  </p:nvSpPr>
                  <p:spPr>
                    <a:xfrm>
                      <a:off x="274542" y="17585"/>
                      <a:ext cx="75218" cy="102496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099" h="20001" extrusionOk="0">
                          <a:moveTo>
                            <a:pt x="0" y="6268"/>
                          </a:moveTo>
                          <a:cubicBezTo>
                            <a:pt x="3516" y="5759"/>
                            <a:pt x="7436" y="6029"/>
                            <a:pt x="10550" y="4742"/>
                          </a:cubicBezTo>
                          <a:cubicBezTo>
                            <a:pt x="21600" y="175"/>
                            <a:pt x="7455" y="-1599"/>
                            <a:pt x="21099" y="1690"/>
                          </a:cubicBezTo>
                          <a:cubicBezTo>
                            <a:pt x="18849" y="17961"/>
                            <a:pt x="18989" y="11837"/>
                            <a:pt x="18989" y="20001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72" name="Freeform 146"/>
                    <p:cNvSpPr/>
                    <p:nvPr/>
                  </p:nvSpPr>
                  <p:spPr>
                    <a:xfrm>
                      <a:off x="90260" y="257985"/>
                      <a:ext cx="195566" cy="39161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942" extrusionOk="0">
                          <a:moveTo>
                            <a:pt x="0" y="20942"/>
                          </a:moveTo>
                          <a:cubicBezTo>
                            <a:pt x="808" y="19316"/>
                            <a:pt x="5182" y="10035"/>
                            <a:pt x="6646" y="8397"/>
                          </a:cubicBezTo>
                          <a:cubicBezTo>
                            <a:pt x="8291" y="6558"/>
                            <a:pt x="9963" y="5414"/>
                            <a:pt x="11631" y="4215"/>
                          </a:cubicBezTo>
                          <a:cubicBezTo>
                            <a:pt x="18408" y="-658"/>
                            <a:pt x="16525" y="34"/>
                            <a:pt x="21600" y="34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</p:grpSp>
              <p:sp>
                <p:nvSpPr>
                  <p:cNvPr id="174" name="Oval 138"/>
                  <p:cNvSpPr/>
                  <p:nvPr/>
                </p:nvSpPr>
                <p:spPr>
                  <a:xfrm>
                    <a:off x="-1" y="36090"/>
                    <a:ext cx="72397" cy="81847"/>
                  </a:xfrm>
                  <a:prstGeom prst="ellipse">
                    <a:avLst/>
                  </a:prstGeom>
                  <a:solidFill>
                    <a:srgbClr val="0070C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75" name="Oval 139"/>
                  <p:cNvSpPr/>
                  <p:nvPr/>
                </p:nvSpPr>
                <p:spPr>
                  <a:xfrm>
                    <a:off x="23034" y="186614"/>
                    <a:ext cx="72397" cy="81847"/>
                  </a:xfrm>
                  <a:prstGeom prst="ellipse">
                    <a:avLst/>
                  </a:prstGeom>
                  <a:solidFill>
                    <a:srgbClr val="0070C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76" name="Oval 140"/>
                  <p:cNvSpPr/>
                  <p:nvPr/>
                </p:nvSpPr>
                <p:spPr>
                  <a:xfrm>
                    <a:off x="312620" y="236788"/>
                    <a:ext cx="72397" cy="81847"/>
                  </a:xfrm>
                  <a:prstGeom prst="ellipse">
                    <a:avLst/>
                  </a:prstGeom>
                  <a:solidFill>
                    <a:srgbClr val="0070C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77" name="Oval 141"/>
                  <p:cNvSpPr/>
                  <p:nvPr/>
                </p:nvSpPr>
                <p:spPr>
                  <a:xfrm>
                    <a:off x="360884" y="117935"/>
                    <a:ext cx="72397" cy="81847"/>
                  </a:xfrm>
                  <a:prstGeom prst="ellipse">
                    <a:avLst/>
                  </a:prstGeom>
                  <a:solidFill>
                    <a:srgbClr val="0070C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78" name="Oval 142"/>
                  <p:cNvSpPr/>
                  <p:nvPr/>
                </p:nvSpPr>
                <p:spPr>
                  <a:xfrm>
                    <a:off x="216091" y="17586"/>
                    <a:ext cx="72397" cy="81847"/>
                  </a:xfrm>
                  <a:prstGeom prst="ellipse">
                    <a:avLst/>
                  </a:prstGeom>
                  <a:solidFill>
                    <a:srgbClr val="0070C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182" name="Group 376"/>
                <p:cNvGrpSpPr/>
                <p:nvPr/>
              </p:nvGrpSpPr>
              <p:grpSpPr>
                <a:xfrm>
                  <a:off x="348818" y="182282"/>
                  <a:ext cx="182196" cy="99350"/>
                  <a:chOff x="0" y="0"/>
                  <a:chExt cx="182195" cy="99348"/>
                </a:xfrm>
              </p:grpSpPr>
              <p:sp>
                <p:nvSpPr>
                  <p:cNvPr id="180" name="Freeform 377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181" name="Oval 378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0070C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185" name="Group 397"/>
                <p:cNvGrpSpPr/>
                <p:nvPr/>
              </p:nvGrpSpPr>
              <p:grpSpPr>
                <a:xfrm>
                  <a:off x="122165" y="138470"/>
                  <a:ext cx="182196" cy="99350"/>
                  <a:chOff x="0" y="0"/>
                  <a:chExt cx="182195" cy="99348"/>
                </a:xfrm>
              </p:grpSpPr>
              <p:sp>
                <p:nvSpPr>
                  <p:cNvPr id="183" name="Freeform 398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184" name="Oval 399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0070C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</p:grpSp>
          <p:grpSp>
            <p:nvGrpSpPr>
              <p:cNvPr id="204" name="Group 4102"/>
              <p:cNvGrpSpPr/>
              <p:nvPr/>
            </p:nvGrpSpPr>
            <p:grpSpPr>
              <a:xfrm>
                <a:off x="2613293" y="2414419"/>
                <a:ext cx="562733" cy="359477"/>
                <a:chOff x="0" y="0"/>
                <a:chExt cx="562732" cy="359476"/>
              </a:xfrm>
            </p:grpSpPr>
            <p:grpSp>
              <p:nvGrpSpPr>
                <p:cNvPr id="197" name="Group 83"/>
                <p:cNvGrpSpPr/>
                <p:nvPr/>
              </p:nvGrpSpPr>
              <p:grpSpPr>
                <a:xfrm>
                  <a:off x="0" y="40841"/>
                  <a:ext cx="433281" cy="318636"/>
                  <a:chOff x="0" y="0"/>
                  <a:chExt cx="433280" cy="318635"/>
                </a:xfrm>
              </p:grpSpPr>
              <p:grpSp>
                <p:nvGrpSpPr>
                  <p:cNvPr id="191" name="Group 117"/>
                  <p:cNvGrpSpPr/>
                  <p:nvPr/>
                </p:nvGrpSpPr>
                <p:grpSpPr>
                  <a:xfrm>
                    <a:off x="59389" y="-1"/>
                    <a:ext cx="349760" cy="297147"/>
                    <a:chOff x="0" y="0"/>
                    <a:chExt cx="349759" cy="297146"/>
                  </a:xfrm>
                </p:grpSpPr>
                <p:sp>
                  <p:nvSpPr>
                    <p:cNvPr id="187" name="Freeform 123"/>
                    <p:cNvSpPr/>
                    <p:nvPr/>
                  </p:nvSpPr>
                  <p:spPr>
                    <a:xfrm>
                      <a:off x="30087" y="-1"/>
                      <a:ext cx="180521" cy="203314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716" extrusionOk="0">
                          <a:moveTo>
                            <a:pt x="21600" y="4781"/>
                          </a:moveTo>
                          <a:cubicBezTo>
                            <a:pt x="20700" y="3453"/>
                            <a:pt x="20137" y="1892"/>
                            <a:pt x="18900" y="797"/>
                          </a:cubicBezTo>
                          <a:cubicBezTo>
                            <a:pt x="17001" y="-884"/>
                            <a:pt x="12265" y="581"/>
                            <a:pt x="10800" y="797"/>
                          </a:cubicBezTo>
                          <a:cubicBezTo>
                            <a:pt x="10092" y="1737"/>
                            <a:pt x="7923" y="4164"/>
                            <a:pt x="8100" y="5578"/>
                          </a:cubicBezTo>
                          <a:cubicBezTo>
                            <a:pt x="8310" y="7247"/>
                            <a:pt x="9900" y="10358"/>
                            <a:pt x="9900" y="10358"/>
                          </a:cubicBezTo>
                          <a:cubicBezTo>
                            <a:pt x="9600" y="12483"/>
                            <a:pt x="9898" y="14744"/>
                            <a:pt x="9000" y="16732"/>
                          </a:cubicBezTo>
                          <a:cubicBezTo>
                            <a:pt x="8310" y="18261"/>
                            <a:pt x="3874" y="18863"/>
                            <a:pt x="2700" y="19123"/>
                          </a:cubicBezTo>
                          <a:lnTo>
                            <a:pt x="0" y="20716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88" name="Freeform 124"/>
                    <p:cNvSpPr/>
                    <p:nvPr/>
                  </p:nvSpPr>
                  <p:spPr>
                    <a:xfrm>
                      <a:off x="-1" y="109479"/>
                      <a:ext cx="210609" cy="86015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1600" extrusionOk="0">
                          <a:moveTo>
                            <a:pt x="0" y="0"/>
                          </a:moveTo>
                          <a:cubicBezTo>
                            <a:pt x="1162" y="2367"/>
                            <a:pt x="7153" y="15030"/>
                            <a:pt x="8486" y="15709"/>
                          </a:cubicBezTo>
                          <a:cubicBezTo>
                            <a:pt x="9771" y="16364"/>
                            <a:pt x="11078" y="16794"/>
                            <a:pt x="12343" y="17673"/>
                          </a:cubicBezTo>
                          <a:cubicBezTo>
                            <a:pt x="13912" y="18762"/>
                            <a:pt x="15345" y="21600"/>
                            <a:pt x="16971" y="21600"/>
                          </a:cubicBezTo>
                          <a:lnTo>
                            <a:pt x="21600" y="21600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89" name="Freeform 125"/>
                    <p:cNvSpPr/>
                    <p:nvPr/>
                  </p:nvSpPr>
                  <p:spPr>
                    <a:xfrm>
                      <a:off x="274542" y="17585"/>
                      <a:ext cx="75218" cy="102496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099" h="20001" extrusionOk="0">
                          <a:moveTo>
                            <a:pt x="0" y="6268"/>
                          </a:moveTo>
                          <a:cubicBezTo>
                            <a:pt x="3516" y="5759"/>
                            <a:pt x="7436" y="6029"/>
                            <a:pt x="10550" y="4742"/>
                          </a:cubicBezTo>
                          <a:cubicBezTo>
                            <a:pt x="21600" y="175"/>
                            <a:pt x="7455" y="-1599"/>
                            <a:pt x="21099" y="1690"/>
                          </a:cubicBezTo>
                          <a:cubicBezTo>
                            <a:pt x="18849" y="17961"/>
                            <a:pt x="18989" y="11837"/>
                            <a:pt x="18989" y="20001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190" name="Freeform 126"/>
                    <p:cNvSpPr/>
                    <p:nvPr/>
                  </p:nvSpPr>
                  <p:spPr>
                    <a:xfrm>
                      <a:off x="90260" y="257985"/>
                      <a:ext cx="195566" cy="39161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942" extrusionOk="0">
                          <a:moveTo>
                            <a:pt x="0" y="20942"/>
                          </a:moveTo>
                          <a:cubicBezTo>
                            <a:pt x="808" y="19316"/>
                            <a:pt x="5182" y="10035"/>
                            <a:pt x="6646" y="8397"/>
                          </a:cubicBezTo>
                          <a:cubicBezTo>
                            <a:pt x="8291" y="6558"/>
                            <a:pt x="9963" y="5414"/>
                            <a:pt x="11631" y="4215"/>
                          </a:cubicBezTo>
                          <a:cubicBezTo>
                            <a:pt x="18408" y="-658"/>
                            <a:pt x="16525" y="34"/>
                            <a:pt x="21600" y="34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</p:grpSp>
              <p:sp>
                <p:nvSpPr>
                  <p:cNvPr id="192" name="Oval 118"/>
                  <p:cNvSpPr/>
                  <p:nvPr/>
                </p:nvSpPr>
                <p:spPr>
                  <a:xfrm>
                    <a:off x="-1" y="36090"/>
                    <a:ext cx="72397" cy="81847"/>
                  </a:xfrm>
                  <a:prstGeom prst="ellipse">
                    <a:avLst/>
                  </a:prstGeom>
                  <a:solidFill>
                    <a:srgbClr val="9933FF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93" name="Oval 119"/>
                  <p:cNvSpPr/>
                  <p:nvPr/>
                </p:nvSpPr>
                <p:spPr>
                  <a:xfrm>
                    <a:off x="23034" y="186614"/>
                    <a:ext cx="72397" cy="81847"/>
                  </a:xfrm>
                  <a:prstGeom prst="ellipse">
                    <a:avLst/>
                  </a:prstGeom>
                  <a:solidFill>
                    <a:srgbClr val="9933FF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94" name="Oval 120"/>
                  <p:cNvSpPr/>
                  <p:nvPr/>
                </p:nvSpPr>
                <p:spPr>
                  <a:xfrm>
                    <a:off x="312620" y="236788"/>
                    <a:ext cx="72397" cy="81847"/>
                  </a:xfrm>
                  <a:prstGeom prst="ellipse">
                    <a:avLst/>
                  </a:prstGeom>
                  <a:solidFill>
                    <a:srgbClr val="9933FF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95" name="Oval 121"/>
                  <p:cNvSpPr/>
                  <p:nvPr/>
                </p:nvSpPr>
                <p:spPr>
                  <a:xfrm>
                    <a:off x="360884" y="117935"/>
                    <a:ext cx="72397" cy="81847"/>
                  </a:xfrm>
                  <a:prstGeom prst="ellipse">
                    <a:avLst/>
                  </a:prstGeom>
                  <a:solidFill>
                    <a:srgbClr val="9933FF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196" name="Oval 122"/>
                  <p:cNvSpPr/>
                  <p:nvPr/>
                </p:nvSpPr>
                <p:spPr>
                  <a:xfrm>
                    <a:off x="216091" y="17586"/>
                    <a:ext cx="72397" cy="81847"/>
                  </a:xfrm>
                  <a:prstGeom prst="ellipse">
                    <a:avLst/>
                  </a:prstGeom>
                  <a:solidFill>
                    <a:srgbClr val="7030A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200" name="Group 379"/>
                <p:cNvGrpSpPr/>
                <p:nvPr/>
              </p:nvGrpSpPr>
              <p:grpSpPr>
                <a:xfrm>
                  <a:off x="380537" y="242465"/>
                  <a:ext cx="182196" cy="99350"/>
                  <a:chOff x="0" y="0"/>
                  <a:chExt cx="182195" cy="99348"/>
                </a:xfrm>
              </p:grpSpPr>
              <p:sp>
                <p:nvSpPr>
                  <p:cNvPr id="198" name="Freeform 380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199" name="Oval 381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9933FF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203" name="Group 400"/>
                <p:cNvGrpSpPr/>
                <p:nvPr/>
              </p:nvGrpSpPr>
              <p:grpSpPr>
                <a:xfrm>
                  <a:off x="308084" y="0"/>
                  <a:ext cx="182196" cy="99350"/>
                  <a:chOff x="0" y="0"/>
                  <a:chExt cx="182195" cy="99348"/>
                </a:xfrm>
              </p:grpSpPr>
              <p:sp>
                <p:nvSpPr>
                  <p:cNvPr id="201" name="Freeform 401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02" name="Oval 402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9933FF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</p:grpSp>
          <p:grpSp>
            <p:nvGrpSpPr>
              <p:cNvPr id="222" name="Group 4105"/>
              <p:cNvGrpSpPr/>
              <p:nvPr/>
            </p:nvGrpSpPr>
            <p:grpSpPr>
              <a:xfrm>
                <a:off x="3477918" y="2400436"/>
                <a:ext cx="579279" cy="387444"/>
                <a:chOff x="0" y="0"/>
                <a:chExt cx="579278" cy="387443"/>
              </a:xfrm>
            </p:grpSpPr>
            <p:grpSp>
              <p:nvGrpSpPr>
                <p:cNvPr id="215" name="Group 85"/>
                <p:cNvGrpSpPr/>
                <p:nvPr/>
              </p:nvGrpSpPr>
              <p:grpSpPr>
                <a:xfrm>
                  <a:off x="-1" y="68808"/>
                  <a:ext cx="433282" cy="318636"/>
                  <a:chOff x="0" y="0"/>
                  <a:chExt cx="433280" cy="318635"/>
                </a:xfrm>
              </p:grpSpPr>
              <p:grpSp>
                <p:nvGrpSpPr>
                  <p:cNvPr id="209" name="Group 97"/>
                  <p:cNvGrpSpPr/>
                  <p:nvPr/>
                </p:nvGrpSpPr>
                <p:grpSpPr>
                  <a:xfrm>
                    <a:off x="59389" y="-1"/>
                    <a:ext cx="349760" cy="297147"/>
                    <a:chOff x="0" y="0"/>
                    <a:chExt cx="349759" cy="297146"/>
                  </a:xfrm>
                </p:grpSpPr>
                <p:sp>
                  <p:nvSpPr>
                    <p:cNvPr id="205" name="Freeform 103"/>
                    <p:cNvSpPr/>
                    <p:nvPr/>
                  </p:nvSpPr>
                  <p:spPr>
                    <a:xfrm>
                      <a:off x="30087" y="-1"/>
                      <a:ext cx="180521" cy="203314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716" extrusionOk="0">
                          <a:moveTo>
                            <a:pt x="21600" y="4781"/>
                          </a:moveTo>
                          <a:cubicBezTo>
                            <a:pt x="20700" y="3453"/>
                            <a:pt x="20137" y="1892"/>
                            <a:pt x="18900" y="797"/>
                          </a:cubicBezTo>
                          <a:cubicBezTo>
                            <a:pt x="17001" y="-884"/>
                            <a:pt x="12265" y="581"/>
                            <a:pt x="10800" y="797"/>
                          </a:cubicBezTo>
                          <a:cubicBezTo>
                            <a:pt x="10092" y="1737"/>
                            <a:pt x="7923" y="4164"/>
                            <a:pt x="8100" y="5578"/>
                          </a:cubicBezTo>
                          <a:cubicBezTo>
                            <a:pt x="8310" y="7247"/>
                            <a:pt x="9900" y="10358"/>
                            <a:pt x="9900" y="10358"/>
                          </a:cubicBezTo>
                          <a:cubicBezTo>
                            <a:pt x="9600" y="12483"/>
                            <a:pt x="9898" y="14744"/>
                            <a:pt x="9000" y="16732"/>
                          </a:cubicBezTo>
                          <a:cubicBezTo>
                            <a:pt x="8310" y="18261"/>
                            <a:pt x="3874" y="18863"/>
                            <a:pt x="2700" y="19123"/>
                          </a:cubicBezTo>
                          <a:lnTo>
                            <a:pt x="0" y="20716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206" name="Freeform 104"/>
                    <p:cNvSpPr/>
                    <p:nvPr/>
                  </p:nvSpPr>
                  <p:spPr>
                    <a:xfrm>
                      <a:off x="-1" y="109479"/>
                      <a:ext cx="210609" cy="86015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1600" extrusionOk="0">
                          <a:moveTo>
                            <a:pt x="0" y="0"/>
                          </a:moveTo>
                          <a:cubicBezTo>
                            <a:pt x="1162" y="2367"/>
                            <a:pt x="7153" y="15030"/>
                            <a:pt x="8486" y="15709"/>
                          </a:cubicBezTo>
                          <a:cubicBezTo>
                            <a:pt x="9771" y="16364"/>
                            <a:pt x="11078" y="16794"/>
                            <a:pt x="12343" y="17673"/>
                          </a:cubicBezTo>
                          <a:cubicBezTo>
                            <a:pt x="13912" y="18762"/>
                            <a:pt x="15345" y="21600"/>
                            <a:pt x="16971" y="21600"/>
                          </a:cubicBezTo>
                          <a:lnTo>
                            <a:pt x="21600" y="21600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207" name="Freeform 105"/>
                    <p:cNvSpPr/>
                    <p:nvPr/>
                  </p:nvSpPr>
                  <p:spPr>
                    <a:xfrm>
                      <a:off x="274542" y="17585"/>
                      <a:ext cx="75218" cy="102496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099" h="20001" extrusionOk="0">
                          <a:moveTo>
                            <a:pt x="0" y="6268"/>
                          </a:moveTo>
                          <a:cubicBezTo>
                            <a:pt x="3516" y="5759"/>
                            <a:pt x="7436" y="6029"/>
                            <a:pt x="10550" y="4742"/>
                          </a:cubicBezTo>
                          <a:cubicBezTo>
                            <a:pt x="21600" y="175"/>
                            <a:pt x="7455" y="-1599"/>
                            <a:pt x="21099" y="1690"/>
                          </a:cubicBezTo>
                          <a:cubicBezTo>
                            <a:pt x="18849" y="17961"/>
                            <a:pt x="18989" y="11837"/>
                            <a:pt x="18989" y="20001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208" name="Freeform 106"/>
                    <p:cNvSpPr/>
                    <p:nvPr/>
                  </p:nvSpPr>
                  <p:spPr>
                    <a:xfrm>
                      <a:off x="90260" y="257985"/>
                      <a:ext cx="195566" cy="39161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942" extrusionOk="0">
                          <a:moveTo>
                            <a:pt x="0" y="20942"/>
                          </a:moveTo>
                          <a:cubicBezTo>
                            <a:pt x="808" y="19316"/>
                            <a:pt x="5182" y="10035"/>
                            <a:pt x="6646" y="8397"/>
                          </a:cubicBezTo>
                          <a:cubicBezTo>
                            <a:pt x="8291" y="6558"/>
                            <a:pt x="9963" y="5414"/>
                            <a:pt x="11631" y="4215"/>
                          </a:cubicBezTo>
                          <a:cubicBezTo>
                            <a:pt x="18408" y="-658"/>
                            <a:pt x="16525" y="34"/>
                            <a:pt x="21600" y="34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</p:grpSp>
              <p:sp>
                <p:nvSpPr>
                  <p:cNvPr id="210" name="Oval 98"/>
                  <p:cNvSpPr/>
                  <p:nvPr/>
                </p:nvSpPr>
                <p:spPr>
                  <a:xfrm>
                    <a:off x="-1" y="36090"/>
                    <a:ext cx="72397" cy="81847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211" name="Oval 99"/>
                  <p:cNvSpPr/>
                  <p:nvPr/>
                </p:nvSpPr>
                <p:spPr>
                  <a:xfrm>
                    <a:off x="23034" y="186614"/>
                    <a:ext cx="72397" cy="81847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212" name="Oval 100"/>
                  <p:cNvSpPr/>
                  <p:nvPr/>
                </p:nvSpPr>
                <p:spPr>
                  <a:xfrm>
                    <a:off x="312620" y="236788"/>
                    <a:ext cx="72397" cy="81847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213" name="Oval 101"/>
                  <p:cNvSpPr/>
                  <p:nvPr/>
                </p:nvSpPr>
                <p:spPr>
                  <a:xfrm>
                    <a:off x="360884" y="117935"/>
                    <a:ext cx="72397" cy="81847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214" name="Oval 102"/>
                  <p:cNvSpPr/>
                  <p:nvPr/>
                </p:nvSpPr>
                <p:spPr>
                  <a:xfrm>
                    <a:off x="216091" y="17586"/>
                    <a:ext cx="72397" cy="81847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218" name="Group 382"/>
                <p:cNvGrpSpPr/>
                <p:nvPr/>
              </p:nvGrpSpPr>
              <p:grpSpPr>
                <a:xfrm>
                  <a:off x="397083" y="263563"/>
                  <a:ext cx="182196" cy="99350"/>
                  <a:chOff x="0" y="0"/>
                  <a:chExt cx="182195" cy="99348"/>
                </a:xfrm>
              </p:grpSpPr>
              <p:sp>
                <p:nvSpPr>
                  <p:cNvPr id="216" name="Freeform 383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17" name="Oval 384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221" name="Group 403"/>
                <p:cNvGrpSpPr/>
                <p:nvPr/>
              </p:nvGrpSpPr>
              <p:grpSpPr>
                <a:xfrm>
                  <a:off x="294307" y="0"/>
                  <a:ext cx="182196" cy="99350"/>
                  <a:chOff x="0" y="0"/>
                  <a:chExt cx="182195" cy="99348"/>
                </a:xfrm>
              </p:grpSpPr>
              <p:sp>
                <p:nvSpPr>
                  <p:cNvPr id="219" name="Freeform 404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20" name="Oval 405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FFC00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</p:grpSp>
          <p:grpSp>
            <p:nvGrpSpPr>
              <p:cNvPr id="240" name="Group 4107"/>
              <p:cNvGrpSpPr/>
              <p:nvPr/>
            </p:nvGrpSpPr>
            <p:grpSpPr>
              <a:xfrm>
                <a:off x="4359087" y="2430044"/>
                <a:ext cx="596351" cy="328227"/>
                <a:chOff x="0" y="0"/>
                <a:chExt cx="596350" cy="328226"/>
              </a:xfrm>
            </p:grpSpPr>
            <p:grpSp>
              <p:nvGrpSpPr>
                <p:cNvPr id="233" name="Group 84"/>
                <p:cNvGrpSpPr/>
                <p:nvPr/>
              </p:nvGrpSpPr>
              <p:grpSpPr>
                <a:xfrm>
                  <a:off x="36505" y="9591"/>
                  <a:ext cx="433282" cy="318636"/>
                  <a:chOff x="0" y="0"/>
                  <a:chExt cx="433280" cy="318635"/>
                </a:xfrm>
              </p:grpSpPr>
              <p:grpSp>
                <p:nvGrpSpPr>
                  <p:cNvPr id="227" name="Group 107"/>
                  <p:cNvGrpSpPr/>
                  <p:nvPr/>
                </p:nvGrpSpPr>
                <p:grpSpPr>
                  <a:xfrm>
                    <a:off x="59389" y="-1"/>
                    <a:ext cx="349760" cy="297147"/>
                    <a:chOff x="0" y="0"/>
                    <a:chExt cx="349759" cy="297146"/>
                  </a:xfrm>
                </p:grpSpPr>
                <p:sp>
                  <p:nvSpPr>
                    <p:cNvPr id="223" name="Freeform 113"/>
                    <p:cNvSpPr/>
                    <p:nvPr/>
                  </p:nvSpPr>
                  <p:spPr>
                    <a:xfrm>
                      <a:off x="30087" y="-1"/>
                      <a:ext cx="180521" cy="203314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716" extrusionOk="0">
                          <a:moveTo>
                            <a:pt x="21600" y="4781"/>
                          </a:moveTo>
                          <a:cubicBezTo>
                            <a:pt x="20700" y="3453"/>
                            <a:pt x="20137" y="1892"/>
                            <a:pt x="18900" y="797"/>
                          </a:cubicBezTo>
                          <a:cubicBezTo>
                            <a:pt x="17001" y="-884"/>
                            <a:pt x="12265" y="581"/>
                            <a:pt x="10800" y="797"/>
                          </a:cubicBezTo>
                          <a:cubicBezTo>
                            <a:pt x="10092" y="1737"/>
                            <a:pt x="7923" y="4164"/>
                            <a:pt x="8100" y="5578"/>
                          </a:cubicBezTo>
                          <a:cubicBezTo>
                            <a:pt x="8310" y="7247"/>
                            <a:pt x="9900" y="10358"/>
                            <a:pt x="9900" y="10358"/>
                          </a:cubicBezTo>
                          <a:cubicBezTo>
                            <a:pt x="9600" y="12483"/>
                            <a:pt x="9898" y="14744"/>
                            <a:pt x="9000" y="16732"/>
                          </a:cubicBezTo>
                          <a:cubicBezTo>
                            <a:pt x="8310" y="18261"/>
                            <a:pt x="3874" y="18863"/>
                            <a:pt x="2700" y="19123"/>
                          </a:cubicBezTo>
                          <a:lnTo>
                            <a:pt x="0" y="20716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224" name="Freeform 114"/>
                    <p:cNvSpPr/>
                    <p:nvPr/>
                  </p:nvSpPr>
                  <p:spPr>
                    <a:xfrm>
                      <a:off x="-1" y="109479"/>
                      <a:ext cx="210609" cy="86015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1600" extrusionOk="0">
                          <a:moveTo>
                            <a:pt x="0" y="0"/>
                          </a:moveTo>
                          <a:cubicBezTo>
                            <a:pt x="1162" y="2367"/>
                            <a:pt x="7153" y="15030"/>
                            <a:pt x="8486" y="15709"/>
                          </a:cubicBezTo>
                          <a:cubicBezTo>
                            <a:pt x="9771" y="16364"/>
                            <a:pt x="11078" y="16794"/>
                            <a:pt x="12343" y="17673"/>
                          </a:cubicBezTo>
                          <a:cubicBezTo>
                            <a:pt x="13912" y="18762"/>
                            <a:pt x="15345" y="21600"/>
                            <a:pt x="16971" y="21600"/>
                          </a:cubicBezTo>
                          <a:lnTo>
                            <a:pt x="21600" y="21600"/>
                          </a:ln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225" name="Freeform 115"/>
                    <p:cNvSpPr/>
                    <p:nvPr/>
                  </p:nvSpPr>
                  <p:spPr>
                    <a:xfrm>
                      <a:off x="274542" y="17585"/>
                      <a:ext cx="75218" cy="102496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099" h="20001" extrusionOk="0">
                          <a:moveTo>
                            <a:pt x="0" y="6268"/>
                          </a:moveTo>
                          <a:cubicBezTo>
                            <a:pt x="3516" y="5759"/>
                            <a:pt x="7436" y="6029"/>
                            <a:pt x="10550" y="4742"/>
                          </a:cubicBezTo>
                          <a:cubicBezTo>
                            <a:pt x="21600" y="175"/>
                            <a:pt x="7455" y="-1599"/>
                            <a:pt x="21099" y="1690"/>
                          </a:cubicBezTo>
                          <a:cubicBezTo>
                            <a:pt x="18849" y="17961"/>
                            <a:pt x="18989" y="11837"/>
                            <a:pt x="18989" y="20001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  <p:sp>
                  <p:nvSpPr>
                    <p:cNvPr id="226" name="Freeform 116"/>
                    <p:cNvSpPr/>
                    <p:nvPr/>
                  </p:nvSpPr>
                  <p:spPr>
                    <a:xfrm>
                      <a:off x="90260" y="257985"/>
                      <a:ext cx="195566" cy="39161"/>
                    </a:xfrm>
                    <a:custGeom>
                      <a:avLst/>
                      <a:gdLst/>
                      <a:ahLst/>
                      <a:cxnLst>
                        <a:cxn ang="0">
                          <a:pos x="wd2" y="hd2"/>
                        </a:cxn>
                        <a:cxn ang="5400000">
                          <a:pos x="wd2" y="hd2"/>
                        </a:cxn>
                        <a:cxn ang="10800000">
                          <a:pos x="wd2" y="hd2"/>
                        </a:cxn>
                        <a:cxn ang="16200000">
                          <a:pos x="wd2" y="hd2"/>
                        </a:cxn>
                      </a:cxnLst>
                      <a:rect l="0" t="0" r="r" b="b"/>
                      <a:pathLst>
                        <a:path w="21600" h="20942" extrusionOk="0">
                          <a:moveTo>
                            <a:pt x="0" y="20942"/>
                          </a:moveTo>
                          <a:cubicBezTo>
                            <a:pt x="808" y="19316"/>
                            <a:pt x="5182" y="10035"/>
                            <a:pt x="6646" y="8397"/>
                          </a:cubicBezTo>
                          <a:cubicBezTo>
                            <a:pt x="8291" y="6558"/>
                            <a:pt x="9963" y="5414"/>
                            <a:pt x="11631" y="4215"/>
                          </a:cubicBezTo>
                          <a:cubicBezTo>
                            <a:pt x="18408" y="-658"/>
                            <a:pt x="16525" y="34"/>
                            <a:pt x="21600" y="34"/>
                          </a:cubicBezTo>
                        </a:path>
                      </a:pathLst>
                    </a:custGeom>
                    <a:noFill/>
                    <a:ln w="12700" cap="flat">
                      <a:solidFill>
                        <a:srgbClr val="000000"/>
                      </a:solidFill>
                      <a:prstDash val="solid"/>
                      <a:round/>
                    </a:ln>
                    <a:effectLst/>
                  </p:spPr>
                  <p:txBody>
                    <a:bodyPr wrap="square" lIns="45719" tIns="45719" rIns="45719" bIns="45719" numCol="1" anchor="ctr">
                      <a:noAutofit/>
                    </a:bodyPr>
                    <a:lstStyle/>
                    <a:p>
                      <a:pPr algn="ctr">
                        <a:defRPr sz="1000">
                          <a:solidFill>
                            <a:srgbClr val="FFFFFF"/>
                          </a:solidFill>
                        </a:defRPr>
                      </a:pPr>
                      <a:endParaRPr sz="1200"/>
                    </a:p>
                  </p:txBody>
                </p:sp>
              </p:grpSp>
              <p:sp>
                <p:nvSpPr>
                  <p:cNvPr id="228" name="Oval 108"/>
                  <p:cNvSpPr/>
                  <p:nvPr/>
                </p:nvSpPr>
                <p:spPr>
                  <a:xfrm>
                    <a:off x="-1" y="36090"/>
                    <a:ext cx="72397" cy="81847"/>
                  </a:xfrm>
                  <a:prstGeom prst="ellipse">
                    <a:avLst/>
                  </a:prstGeom>
                  <a:solidFill>
                    <a:srgbClr val="00B05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229" name="Oval 109"/>
                  <p:cNvSpPr/>
                  <p:nvPr/>
                </p:nvSpPr>
                <p:spPr>
                  <a:xfrm>
                    <a:off x="23034" y="186614"/>
                    <a:ext cx="72397" cy="81847"/>
                  </a:xfrm>
                  <a:prstGeom prst="ellipse">
                    <a:avLst/>
                  </a:prstGeom>
                  <a:solidFill>
                    <a:srgbClr val="00B05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230" name="Oval 110"/>
                  <p:cNvSpPr/>
                  <p:nvPr/>
                </p:nvSpPr>
                <p:spPr>
                  <a:xfrm>
                    <a:off x="312620" y="236788"/>
                    <a:ext cx="72397" cy="81847"/>
                  </a:xfrm>
                  <a:prstGeom prst="ellipse">
                    <a:avLst/>
                  </a:prstGeom>
                  <a:solidFill>
                    <a:srgbClr val="00B05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231" name="Oval 111"/>
                  <p:cNvSpPr/>
                  <p:nvPr/>
                </p:nvSpPr>
                <p:spPr>
                  <a:xfrm>
                    <a:off x="360884" y="117935"/>
                    <a:ext cx="72397" cy="81847"/>
                  </a:xfrm>
                  <a:prstGeom prst="ellipse">
                    <a:avLst/>
                  </a:prstGeom>
                  <a:solidFill>
                    <a:srgbClr val="00B05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  <p:sp>
                <p:nvSpPr>
                  <p:cNvPr id="232" name="Oval 112"/>
                  <p:cNvSpPr/>
                  <p:nvPr/>
                </p:nvSpPr>
                <p:spPr>
                  <a:xfrm>
                    <a:off x="216091" y="17586"/>
                    <a:ext cx="72397" cy="81847"/>
                  </a:xfrm>
                  <a:prstGeom prst="ellipse">
                    <a:avLst/>
                  </a:prstGeom>
                  <a:solidFill>
                    <a:srgbClr val="00B05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236" name="Group 385"/>
                <p:cNvGrpSpPr/>
                <p:nvPr/>
              </p:nvGrpSpPr>
              <p:grpSpPr>
                <a:xfrm>
                  <a:off x="414154" y="211214"/>
                  <a:ext cx="182196" cy="99350"/>
                  <a:chOff x="0" y="0"/>
                  <a:chExt cx="182195" cy="99348"/>
                </a:xfrm>
              </p:grpSpPr>
              <p:sp>
                <p:nvSpPr>
                  <p:cNvPr id="234" name="Freeform 386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35" name="Oval 387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00B05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  <p:grpSp>
              <p:nvGrpSpPr>
                <p:cNvPr id="239" name="Group 406"/>
                <p:cNvGrpSpPr/>
                <p:nvPr/>
              </p:nvGrpSpPr>
              <p:grpSpPr>
                <a:xfrm>
                  <a:off x="-1" y="0"/>
                  <a:ext cx="182196" cy="99350"/>
                  <a:chOff x="0" y="0"/>
                  <a:chExt cx="182195" cy="99348"/>
                </a:xfrm>
              </p:grpSpPr>
              <p:sp>
                <p:nvSpPr>
                  <p:cNvPr id="237" name="Freeform 407"/>
                  <p:cNvSpPr/>
                  <p:nvPr/>
                </p:nvSpPr>
                <p:spPr>
                  <a:xfrm rot="16200000">
                    <a:off x="13639" y="10492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38" name="Oval 408"/>
                  <p:cNvSpPr/>
                  <p:nvPr/>
                </p:nvSpPr>
                <p:spPr>
                  <a:xfrm rot="16200000">
                    <a:off x="105074" y="-4726"/>
                    <a:ext cx="72397" cy="81848"/>
                  </a:xfrm>
                  <a:prstGeom prst="ellipse">
                    <a:avLst/>
                  </a:prstGeom>
                  <a:solidFill>
                    <a:srgbClr val="00B050"/>
                  </a:solidFill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1000">
                        <a:latin typeface="Arial"/>
                        <a:ea typeface="Arial"/>
                        <a:cs typeface="Arial"/>
                        <a:sym typeface="Arial"/>
                      </a:defRPr>
                    </a:pPr>
                    <a:endParaRPr sz="1200"/>
                  </a:p>
                </p:txBody>
              </p:sp>
            </p:grpSp>
          </p:grpSp>
          <p:grpSp>
            <p:nvGrpSpPr>
              <p:cNvPr id="248" name="Group 372"/>
              <p:cNvGrpSpPr/>
              <p:nvPr/>
            </p:nvGrpSpPr>
            <p:grpSpPr>
              <a:xfrm>
                <a:off x="62941" y="1610679"/>
                <a:ext cx="459951" cy="297148"/>
                <a:chOff x="0" y="0"/>
                <a:chExt cx="459950" cy="297146"/>
              </a:xfrm>
            </p:grpSpPr>
            <p:grpSp>
              <p:nvGrpSpPr>
                <p:cNvPr id="245" name="Group 54"/>
                <p:cNvGrpSpPr/>
                <p:nvPr/>
              </p:nvGrpSpPr>
              <p:grpSpPr>
                <a:xfrm>
                  <a:off x="-1" y="-1"/>
                  <a:ext cx="300871" cy="297148"/>
                  <a:chOff x="0" y="0"/>
                  <a:chExt cx="300869" cy="297146"/>
                </a:xfrm>
              </p:grpSpPr>
              <p:sp>
                <p:nvSpPr>
                  <p:cNvPr id="241" name="Freeform 60"/>
                  <p:cNvSpPr/>
                  <p:nvPr/>
                </p:nvSpPr>
                <p:spPr>
                  <a:xfrm>
                    <a:off x="30087" y="-1"/>
                    <a:ext cx="180522" cy="203314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716" extrusionOk="0">
                        <a:moveTo>
                          <a:pt x="21600" y="4781"/>
                        </a:moveTo>
                        <a:cubicBezTo>
                          <a:pt x="20700" y="3453"/>
                          <a:pt x="20137" y="1892"/>
                          <a:pt x="18900" y="797"/>
                        </a:cubicBezTo>
                        <a:cubicBezTo>
                          <a:pt x="17001" y="-884"/>
                          <a:pt x="12265" y="581"/>
                          <a:pt x="10800" y="797"/>
                        </a:cubicBezTo>
                        <a:cubicBezTo>
                          <a:pt x="10092" y="1737"/>
                          <a:pt x="7923" y="4164"/>
                          <a:pt x="8100" y="5578"/>
                        </a:cubicBezTo>
                        <a:cubicBezTo>
                          <a:pt x="8310" y="7247"/>
                          <a:pt x="9900" y="10358"/>
                          <a:pt x="9900" y="10358"/>
                        </a:cubicBezTo>
                        <a:cubicBezTo>
                          <a:pt x="9600" y="12483"/>
                          <a:pt x="9898" y="14744"/>
                          <a:pt x="9000" y="16732"/>
                        </a:cubicBezTo>
                        <a:cubicBezTo>
                          <a:pt x="8310" y="18261"/>
                          <a:pt x="3874" y="18863"/>
                          <a:pt x="2700" y="19123"/>
                        </a:cubicBezTo>
                        <a:lnTo>
                          <a:pt x="0" y="20716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42" name="Freeform 61"/>
                  <p:cNvSpPr/>
                  <p:nvPr/>
                </p:nvSpPr>
                <p:spPr>
                  <a:xfrm>
                    <a:off x="-1" y="109479"/>
                    <a:ext cx="210610" cy="86015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1600" extrusionOk="0">
                        <a:moveTo>
                          <a:pt x="0" y="0"/>
                        </a:moveTo>
                        <a:cubicBezTo>
                          <a:pt x="1162" y="2367"/>
                          <a:pt x="7153" y="15030"/>
                          <a:pt x="8486" y="15709"/>
                        </a:cubicBezTo>
                        <a:cubicBezTo>
                          <a:pt x="9771" y="16364"/>
                          <a:pt x="11078" y="16794"/>
                          <a:pt x="12343" y="17673"/>
                        </a:cubicBezTo>
                        <a:cubicBezTo>
                          <a:pt x="13912" y="18762"/>
                          <a:pt x="15345" y="21600"/>
                          <a:pt x="16971" y="21600"/>
                        </a:cubicBezTo>
                        <a:lnTo>
                          <a:pt x="21600" y="21600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43" name="Freeform 62"/>
                  <p:cNvSpPr/>
                  <p:nvPr/>
                </p:nvSpPr>
                <p:spPr>
                  <a:xfrm>
                    <a:off x="225651" y="61720"/>
                    <a:ext cx="75219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44" name="Freeform 63"/>
                  <p:cNvSpPr/>
                  <p:nvPr/>
                </p:nvSpPr>
                <p:spPr>
                  <a:xfrm>
                    <a:off x="90260" y="257986"/>
                    <a:ext cx="195566" cy="39161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942" extrusionOk="0">
                        <a:moveTo>
                          <a:pt x="0" y="20942"/>
                        </a:moveTo>
                        <a:cubicBezTo>
                          <a:pt x="808" y="19316"/>
                          <a:pt x="5182" y="10035"/>
                          <a:pt x="6646" y="8397"/>
                        </a:cubicBezTo>
                        <a:cubicBezTo>
                          <a:pt x="8291" y="6558"/>
                          <a:pt x="9963" y="5414"/>
                          <a:pt x="11631" y="4215"/>
                        </a:cubicBezTo>
                        <a:cubicBezTo>
                          <a:pt x="18408" y="-658"/>
                          <a:pt x="16525" y="34"/>
                          <a:pt x="21600" y="34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</p:grpSp>
            <p:sp>
              <p:nvSpPr>
                <p:cNvPr id="246" name="Freeform 363"/>
                <p:cNvSpPr/>
                <p:nvPr/>
              </p:nvSpPr>
              <p:spPr>
                <a:xfrm>
                  <a:off x="297266" y="155292"/>
                  <a:ext cx="162685" cy="72929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  <p:sp>
              <p:nvSpPr>
                <p:cNvPr id="247" name="Freeform 409"/>
                <p:cNvSpPr/>
                <p:nvPr/>
              </p:nvSpPr>
              <p:spPr>
                <a:xfrm>
                  <a:off x="280728" y="-1"/>
                  <a:ext cx="162685" cy="72930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</p:grpSp>
          <p:grpSp>
            <p:nvGrpSpPr>
              <p:cNvPr id="256" name="Group 4096"/>
              <p:cNvGrpSpPr/>
              <p:nvPr/>
            </p:nvGrpSpPr>
            <p:grpSpPr>
              <a:xfrm>
                <a:off x="920013" y="1601039"/>
                <a:ext cx="461848" cy="297148"/>
                <a:chOff x="0" y="0"/>
                <a:chExt cx="461847" cy="297146"/>
              </a:xfrm>
            </p:grpSpPr>
            <p:grpSp>
              <p:nvGrpSpPr>
                <p:cNvPr id="253" name="Group 55"/>
                <p:cNvGrpSpPr/>
                <p:nvPr/>
              </p:nvGrpSpPr>
              <p:grpSpPr>
                <a:xfrm>
                  <a:off x="-1" y="-1"/>
                  <a:ext cx="300871" cy="297148"/>
                  <a:chOff x="0" y="0"/>
                  <a:chExt cx="300869" cy="297146"/>
                </a:xfrm>
              </p:grpSpPr>
              <p:sp>
                <p:nvSpPr>
                  <p:cNvPr id="249" name="Freeform 56"/>
                  <p:cNvSpPr/>
                  <p:nvPr/>
                </p:nvSpPr>
                <p:spPr>
                  <a:xfrm>
                    <a:off x="30087" y="-1"/>
                    <a:ext cx="180522" cy="203314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716" extrusionOk="0">
                        <a:moveTo>
                          <a:pt x="21600" y="4781"/>
                        </a:moveTo>
                        <a:cubicBezTo>
                          <a:pt x="20700" y="3453"/>
                          <a:pt x="20137" y="1892"/>
                          <a:pt x="18900" y="797"/>
                        </a:cubicBezTo>
                        <a:cubicBezTo>
                          <a:pt x="17001" y="-884"/>
                          <a:pt x="12265" y="581"/>
                          <a:pt x="10800" y="797"/>
                        </a:cubicBezTo>
                        <a:cubicBezTo>
                          <a:pt x="10092" y="1737"/>
                          <a:pt x="7923" y="4164"/>
                          <a:pt x="8100" y="5578"/>
                        </a:cubicBezTo>
                        <a:cubicBezTo>
                          <a:pt x="8310" y="7247"/>
                          <a:pt x="9900" y="10358"/>
                          <a:pt x="9900" y="10358"/>
                        </a:cubicBezTo>
                        <a:cubicBezTo>
                          <a:pt x="9600" y="12483"/>
                          <a:pt x="9898" y="14744"/>
                          <a:pt x="9000" y="16732"/>
                        </a:cubicBezTo>
                        <a:cubicBezTo>
                          <a:pt x="8310" y="18261"/>
                          <a:pt x="3874" y="18863"/>
                          <a:pt x="2700" y="19123"/>
                        </a:cubicBezTo>
                        <a:lnTo>
                          <a:pt x="0" y="20716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50" name="Freeform 57"/>
                  <p:cNvSpPr/>
                  <p:nvPr/>
                </p:nvSpPr>
                <p:spPr>
                  <a:xfrm>
                    <a:off x="-1" y="109479"/>
                    <a:ext cx="210610" cy="86015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1600" extrusionOk="0">
                        <a:moveTo>
                          <a:pt x="0" y="0"/>
                        </a:moveTo>
                        <a:cubicBezTo>
                          <a:pt x="1162" y="2367"/>
                          <a:pt x="7153" y="15030"/>
                          <a:pt x="8486" y="15709"/>
                        </a:cubicBezTo>
                        <a:cubicBezTo>
                          <a:pt x="9771" y="16364"/>
                          <a:pt x="11078" y="16794"/>
                          <a:pt x="12343" y="17673"/>
                        </a:cubicBezTo>
                        <a:cubicBezTo>
                          <a:pt x="13912" y="18762"/>
                          <a:pt x="15345" y="21600"/>
                          <a:pt x="16971" y="21600"/>
                        </a:cubicBezTo>
                        <a:lnTo>
                          <a:pt x="21600" y="21600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51" name="Freeform 58"/>
                  <p:cNvSpPr/>
                  <p:nvPr/>
                </p:nvSpPr>
                <p:spPr>
                  <a:xfrm>
                    <a:off x="225651" y="61720"/>
                    <a:ext cx="75219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52" name="Freeform 59"/>
                  <p:cNvSpPr/>
                  <p:nvPr/>
                </p:nvSpPr>
                <p:spPr>
                  <a:xfrm>
                    <a:off x="90260" y="257986"/>
                    <a:ext cx="195566" cy="39161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942" extrusionOk="0">
                        <a:moveTo>
                          <a:pt x="0" y="20942"/>
                        </a:moveTo>
                        <a:cubicBezTo>
                          <a:pt x="808" y="19316"/>
                          <a:pt x="5182" y="10035"/>
                          <a:pt x="6646" y="8397"/>
                        </a:cubicBezTo>
                        <a:cubicBezTo>
                          <a:pt x="8291" y="6558"/>
                          <a:pt x="9963" y="5414"/>
                          <a:pt x="11631" y="4215"/>
                        </a:cubicBezTo>
                        <a:cubicBezTo>
                          <a:pt x="18408" y="-658"/>
                          <a:pt x="16525" y="34"/>
                          <a:pt x="21600" y="34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</p:grpSp>
            <p:sp>
              <p:nvSpPr>
                <p:cNvPr id="254" name="Freeform 365"/>
                <p:cNvSpPr/>
                <p:nvPr/>
              </p:nvSpPr>
              <p:spPr>
                <a:xfrm>
                  <a:off x="299163" y="175548"/>
                  <a:ext cx="162685" cy="72929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  <p:sp>
              <p:nvSpPr>
                <p:cNvPr id="255" name="Freeform 410"/>
                <p:cNvSpPr/>
                <p:nvPr/>
              </p:nvSpPr>
              <p:spPr>
                <a:xfrm>
                  <a:off x="287097" y="110800"/>
                  <a:ext cx="162685" cy="72929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</p:grpSp>
          <p:grpSp>
            <p:nvGrpSpPr>
              <p:cNvPr id="264" name="Group 4100"/>
              <p:cNvGrpSpPr/>
              <p:nvPr/>
            </p:nvGrpSpPr>
            <p:grpSpPr>
              <a:xfrm>
                <a:off x="1778982" y="1605077"/>
                <a:ext cx="474294" cy="308354"/>
                <a:chOff x="0" y="0"/>
                <a:chExt cx="474293" cy="308353"/>
              </a:xfrm>
            </p:grpSpPr>
            <p:grpSp>
              <p:nvGrpSpPr>
                <p:cNvPr id="261" name="Group 53"/>
                <p:cNvGrpSpPr/>
                <p:nvPr/>
              </p:nvGrpSpPr>
              <p:grpSpPr>
                <a:xfrm>
                  <a:off x="-1" y="44397"/>
                  <a:ext cx="300871" cy="263957"/>
                  <a:chOff x="0" y="0"/>
                  <a:chExt cx="300869" cy="263955"/>
                </a:xfrm>
              </p:grpSpPr>
              <p:sp>
                <p:nvSpPr>
                  <p:cNvPr id="257" name="Freeform 64"/>
                  <p:cNvSpPr/>
                  <p:nvPr/>
                </p:nvSpPr>
                <p:spPr>
                  <a:xfrm>
                    <a:off x="30086" y="-1"/>
                    <a:ext cx="180522" cy="203314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716" extrusionOk="0">
                        <a:moveTo>
                          <a:pt x="21600" y="4781"/>
                        </a:moveTo>
                        <a:cubicBezTo>
                          <a:pt x="20700" y="3453"/>
                          <a:pt x="20137" y="1892"/>
                          <a:pt x="18900" y="797"/>
                        </a:cubicBezTo>
                        <a:cubicBezTo>
                          <a:pt x="17001" y="-884"/>
                          <a:pt x="12265" y="581"/>
                          <a:pt x="10800" y="797"/>
                        </a:cubicBezTo>
                        <a:cubicBezTo>
                          <a:pt x="10092" y="1737"/>
                          <a:pt x="7923" y="4164"/>
                          <a:pt x="8100" y="5578"/>
                        </a:cubicBezTo>
                        <a:cubicBezTo>
                          <a:pt x="8310" y="7247"/>
                          <a:pt x="9900" y="10358"/>
                          <a:pt x="9900" y="10358"/>
                        </a:cubicBezTo>
                        <a:cubicBezTo>
                          <a:pt x="9600" y="12483"/>
                          <a:pt x="9898" y="14744"/>
                          <a:pt x="9000" y="16732"/>
                        </a:cubicBezTo>
                        <a:cubicBezTo>
                          <a:pt x="8310" y="18261"/>
                          <a:pt x="3874" y="18863"/>
                          <a:pt x="2700" y="19123"/>
                        </a:cubicBezTo>
                        <a:lnTo>
                          <a:pt x="0" y="20716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58" name="Freeform 65"/>
                  <p:cNvSpPr/>
                  <p:nvPr/>
                </p:nvSpPr>
                <p:spPr>
                  <a:xfrm>
                    <a:off x="-1" y="76288"/>
                    <a:ext cx="210610" cy="86015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1600" extrusionOk="0">
                        <a:moveTo>
                          <a:pt x="0" y="0"/>
                        </a:moveTo>
                        <a:cubicBezTo>
                          <a:pt x="1162" y="2367"/>
                          <a:pt x="7153" y="15030"/>
                          <a:pt x="8486" y="15709"/>
                        </a:cubicBezTo>
                        <a:cubicBezTo>
                          <a:pt x="9771" y="16364"/>
                          <a:pt x="11078" y="16794"/>
                          <a:pt x="12343" y="17673"/>
                        </a:cubicBezTo>
                        <a:cubicBezTo>
                          <a:pt x="13912" y="18762"/>
                          <a:pt x="15345" y="21600"/>
                          <a:pt x="16971" y="21600"/>
                        </a:cubicBezTo>
                        <a:lnTo>
                          <a:pt x="21600" y="21600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59" name="Freeform 66"/>
                  <p:cNvSpPr/>
                  <p:nvPr/>
                </p:nvSpPr>
                <p:spPr>
                  <a:xfrm>
                    <a:off x="225651" y="28529"/>
                    <a:ext cx="75219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60" name="Freeform 67"/>
                  <p:cNvSpPr/>
                  <p:nvPr/>
                </p:nvSpPr>
                <p:spPr>
                  <a:xfrm>
                    <a:off x="90260" y="224795"/>
                    <a:ext cx="195566" cy="39161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942" extrusionOk="0">
                        <a:moveTo>
                          <a:pt x="0" y="20942"/>
                        </a:moveTo>
                        <a:cubicBezTo>
                          <a:pt x="808" y="19316"/>
                          <a:pt x="5182" y="10035"/>
                          <a:pt x="6646" y="8397"/>
                        </a:cubicBezTo>
                        <a:cubicBezTo>
                          <a:pt x="8291" y="6558"/>
                          <a:pt x="9963" y="5414"/>
                          <a:pt x="11631" y="4215"/>
                        </a:cubicBezTo>
                        <a:cubicBezTo>
                          <a:pt x="18408" y="-658"/>
                          <a:pt x="16525" y="34"/>
                          <a:pt x="21600" y="34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</p:grpSp>
            <p:sp>
              <p:nvSpPr>
                <p:cNvPr id="262" name="Freeform 366"/>
                <p:cNvSpPr/>
                <p:nvPr/>
              </p:nvSpPr>
              <p:spPr>
                <a:xfrm>
                  <a:off x="311608" y="181252"/>
                  <a:ext cx="162686" cy="72930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  <p:sp>
              <p:nvSpPr>
                <p:cNvPr id="263" name="Freeform 411"/>
                <p:cNvSpPr/>
                <p:nvPr/>
              </p:nvSpPr>
              <p:spPr>
                <a:xfrm>
                  <a:off x="237125" y="-1"/>
                  <a:ext cx="162686" cy="72929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</p:grpSp>
          <p:grpSp>
            <p:nvGrpSpPr>
              <p:cNvPr id="272" name="Group 4103"/>
              <p:cNvGrpSpPr/>
              <p:nvPr/>
            </p:nvGrpSpPr>
            <p:grpSpPr>
              <a:xfrm>
                <a:off x="2650397" y="1547987"/>
                <a:ext cx="490393" cy="360719"/>
                <a:chOff x="0" y="0"/>
                <a:chExt cx="490392" cy="360717"/>
              </a:xfrm>
            </p:grpSpPr>
            <p:grpSp>
              <p:nvGrpSpPr>
                <p:cNvPr id="269" name="Group 52"/>
                <p:cNvGrpSpPr/>
                <p:nvPr/>
              </p:nvGrpSpPr>
              <p:grpSpPr>
                <a:xfrm>
                  <a:off x="-1" y="-1"/>
                  <a:ext cx="300871" cy="360719"/>
                  <a:chOff x="0" y="0"/>
                  <a:chExt cx="300869" cy="360717"/>
                </a:xfrm>
              </p:grpSpPr>
              <p:sp>
                <p:nvSpPr>
                  <p:cNvPr id="265" name="Freeform 68"/>
                  <p:cNvSpPr/>
                  <p:nvPr/>
                </p:nvSpPr>
                <p:spPr>
                  <a:xfrm>
                    <a:off x="30086" y="-1"/>
                    <a:ext cx="180522" cy="203314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716" extrusionOk="0">
                        <a:moveTo>
                          <a:pt x="21600" y="4781"/>
                        </a:moveTo>
                        <a:cubicBezTo>
                          <a:pt x="20700" y="3453"/>
                          <a:pt x="20137" y="1892"/>
                          <a:pt x="18900" y="797"/>
                        </a:cubicBezTo>
                        <a:cubicBezTo>
                          <a:pt x="17001" y="-884"/>
                          <a:pt x="12265" y="581"/>
                          <a:pt x="10800" y="797"/>
                        </a:cubicBezTo>
                        <a:cubicBezTo>
                          <a:pt x="10092" y="1737"/>
                          <a:pt x="7923" y="4164"/>
                          <a:pt x="8100" y="5578"/>
                        </a:cubicBezTo>
                        <a:cubicBezTo>
                          <a:pt x="8310" y="7247"/>
                          <a:pt x="9900" y="10358"/>
                          <a:pt x="9900" y="10358"/>
                        </a:cubicBezTo>
                        <a:cubicBezTo>
                          <a:pt x="9600" y="12483"/>
                          <a:pt x="9898" y="14744"/>
                          <a:pt x="9000" y="16732"/>
                        </a:cubicBezTo>
                        <a:cubicBezTo>
                          <a:pt x="8310" y="18261"/>
                          <a:pt x="3874" y="18863"/>
                          <a:pt x="2700" y="19123"/>
                        </a:cubicBezTo>
                        <a:lnTo>
                          <a:pt x="0" y="20716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66" name="Freeform 69"/>
                  <p:cNvSpPr/>
                  <p:nvPr/>
                </p:nvSpPr>
                <p:spPr>
                  <a:xfrm>
                    <a:off x="-1" y="173050"/>
                    <a:ext cx="210610" cy="86015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1600" extrusionOk="0">
                        <a:moveTo>
                          <a:pt x="0" y="0"/>
                        </a:moveTo>
                        <a:cubicBezTo>
                          <a:pt x="1162" y="2367"/>
                          <a:pt x="7153" y="15030"/>
                          <a:pt x="8486" y="15709"/>
                        </a:cubicBezTo>
                        <a:cubicBezTo>
                          <a:pt x="9771" y="16364"/>
                          <a:pt x="11078" y="16794"/>
                          <a:pt x="12343" y="17673"/>
                        </a:cubicBezTo>
                        <a:cubicBezTo>
                          <a:pt x="13912" y="18762"/>
                          <a:pt x="15345" y="21600"/>
                          <a:pt x="16971" y="21600"/>
                        </a:cubicBezTo>
                        <a:lnTo>
                          <a:pt x="21600" y="21600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67" name="Freeform 70"/>
                  <p:cNvSpPr/>
                  <p:nvPr/>
                </p:nvSpPr>
                <p:spPr>
                  <a:xfrm>
                    <a:off x="225651" y="125292"/>
                    <a:ext cx="75219" cy="102496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68" name="Freeform 71"/>
                  <p:cNvSpPr/>
                  <p:nvPr/>
                </p:nvSpPr>
                <p:spPr>
                  <a:xfrm>
                    <a:off x="90260" y="321557"/>
                    <a:ext cx="195566" cy="39161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942" extrusionOk="0">
                        <a:moveTo>
                          <a:pt x="0" y="20942"/>
                        </a:moveTo>
                        <a:cubicBezTo>
                          <a:pt x="808" y="19316"/>
                          <a:pt x="5182" y="10035"/>
                          <a:pt x="6646" y="8397"/>
                        </a:cubicBezTo>
                        <a:cubicBezTo>
                          <a:pt x="8291" y="6558"/>
                          <a:pt x="9963" y="5414"/>
                          <a:pt x="11631" y="4215"/>
                        </a:cubicBezTo>
                        <a:cubicBezTo>
                          <a:pt x="18408" y="-658"/>
                          <a:pt x="16525" y="34"/>
                          <a:pt x="21600" y="34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</p:grpSp>
            <p:sp>
              <p:nvSpPr>
                <p:cNvPr id="270" name="Freeform 367"/>
                <p:cNvSpPr/>
                <p:nvPr/>
              </p:nvSpPr>
              <p:spPr>
                <a:xfrm>
                  <a:off x="327708" y="226250"/>
                  <a:ext cx="162685" cy="72929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  <p:sp>
              <p:nvSpPr>
                <p:cNvPr id="271" name="Freeform 412"/>
                <p:cNvSpPr/>
                <p:nvPr/>
              </p:nvSpPr>
              <p:spPr>
                <a:xfrm>
                  <a:off x="249549" y="61813"/>
                  <a:ext cx="162685" cy="72930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</p:grpSp>
          <p:grpSp>
            <p:nvGrpSpPr>
              <p:cNvPr id="280" name="Group 4104"/>
              <p:cNvGrpSpPr/>
              <p:nvPr/>
            </p:nvGrpSpPr>
            <p:grpSpPr>
              <a:xfrm>
                <a:off x="3519074" y="1591570"/>
                <a:ext cx="490336" cy="335368"/>
                <a:chOff x="0" y="0"/>
                <a:chExt cx="490335" cy="335367"/>
              </a:xfrm>
            </p:grpSpPr>
            <p:grpSp>
              <p:nvGrpSpPr>
                <p:cNvPr id="277" name="Group 51"/>
                <p:cNvGrpSpPr/>
                <p:nvPr/>
              </p:nvGrpSpPr>
              <p:grpSpPr>
                <a:xfrm>
                  <a:off x="-1" y="38220"/>
                  <a:ext cx="319707" cy="297148"/>
                  <a:chOff x="0" y="0"/>
                  <a:chExt cx="319705" cy="297146"/>
                </a:xfrm>
              </p:grpSpPr>
              <p:sp>
                <p:nvSpPr>
                  <p:cNvPr id="273" name="Freeform 72"/>
                  <p:cNvSpPr/>
                  <p:nvPr/>
                </p:nvSpPr>
                <p:spPr>
                  <a:xfrm>
                    <a:off x="-1" y="-1"/>
                    <a:ext cx="180522" cy="203314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716" extrusionOk="0">
                        <a:moveTo>
                          <a:pt x="21600" y="4781"/>
                        </a:moveTo>
                        <a:cubicBezTo>
                          <a:pt x="20700" y="3453"/>
                          <a:pt x="20137" y="1892"/>
                          <a:pt x="18900" y="797"/>
                        </a:cubicBezTo>
                        <a:cubicBezTo>
                          <a:pt x="17001" y="-884"/>
                          <a:pt x="12265" y="581"/>
                          <a:pt x="10800" y="797"/>
                        </a:cubicBezTo>
                        <a:cubicBezTo>
                          <a:pt x="10092" y="1737"/>
                          <a:pt x="7923" y="4164"/>
                          <a:pt x="8100" y="5578"/>
                        </a:cubicBezTo>
                        <a:cubicBezTo>
                          <a:pt x="8310" y="7247"/>
                          <a:pt x="9900" y="10358"/>
                          <a:pt x="9900" y="10358"/>
                        </a:cubicBezTo>
                        <a:cubicBezTo>
                          <a:pt x="9600" y="12483"/>
                          <a:pt x="9898" y="14744"/>
                          <a:pt x="9000" y="16732"/>
                        </a:cubicBezTo>
                        <a:cubicBezTo>
                          <a:pt x="8310" y="18261"/>
                          <a:pt x="3874" y="18863"/>
                          <a:pt x="2700" y="19123"/>
                        </a:cubicBezTo>
                        <a:lnTo>
                          <a:pt x="0" y="20716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74" name="Freeform 73"/>
                  <p:cNvSpPr/>
                  <p:nvPr/>
                </p:nvSpPr>
                <p:spPr>
                  <a:xfrm>
                    <a:off x="18837" y="109479"/>
                    <a:ext cx="210609" cy="86015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1600" extrusionOk="0">
                        <a:moveTo>
                          <a:pt x="0" y="0"/>
                        </a:moveTo>
                        <a:cubicBezTo>
                          <a:pt x="1162" y="2367"/>
                          <a:pt x="7153" y="15030"/>
                          <a:pt x="8486" y="15709"/>
                        </a:cubicBezTo>
                        <a:cubicBezTo>
                          <a:pt x="9771" y="16364"/>
                          <a:pt x="11078" y="16794"/>
                          <a:pt x="12343" y="17673"/>
                        </a:cubicBezTo>
                        <a:cubicBezTo>
                          <a:pt x="13912" y="18762"/>
                          <a:pt x="15345" y="21600"/>
                          <a:pt x="16971" y="21600"/>
                        </a:cubicBezTo>
                        <a:lnTo>
                          <a:pt x="21600" y="21600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75" name="Freeform 74"/>
                  <p:cNvSpPr/>
                  <p:nvPr/>
                </p:nvSpPr>
                <p:spPr>
                  <a:xfrm>
                    <a:off x="244488" y="61720"/>
                    <a:ext cx="75218" cy="102497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76" name="Freeform 75"/>
                  <p:cNvSpPr/>
                  <p:nvPr/>
                </p:nvSpPr>
                <p:spPr>
                  <a:xfrm>
                    <a:off x="109097" y="257986"/>
                    <a:ext cx="195566" cy="39161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942" extrusionOk="0">
                        <a:moveTo>
                          <a:pt x="0" y="20942"/>
                        </a:moveTo>
                        <a:cubicBezTo>
                          <a:pt x="808" y="19316"/>
                          <a:pt x="5182" y="10035"/>
                          <a:pt x="6646" y="8397"/>
                        </a:cubicBezTo>
                        <a:cubicBezTo>
                          <a:pt x="8291" y="6558"/>
                          <a:pt x="9963" y="5414"/>
                          <a:pt x="11631" y="4215"/>
                        </a:cubicBezTo>
                        <a:cubicBezTo>
                          <a:pt x="18408" y="-658"/>
                          <a:pt x="16525" y="34"/>
                          <a:pt x="21600" y="34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</p:grpSp>
            <p:sp>
              <p:nvSpPr>
                <p:cNvPr id="278" name="Freeform 368"/>
                <p:cNvSpPr/>
                <p:nvPr/>
              </p:nvSpPr>
              <p:spPr>
                <a:xfrm>
                  <a:off x="327650" y="190707"/>
                  <a:ext cx="162685" cy="72930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  <p:sp>
              <p:nvSpPr>
                <p:cNvPr id="279" name="Freeform 413"/>
                <p:cNvSpPr/>
                <p:nvPr/>
              </p:nvSpPr>
              <p:spPr>
                <a:xfrm>
                  <a:off x="298722" y="-1"/>
                  <a:ext cx="162685" cy="72929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</p:grpSp>
          <p:grpSp>
            <p:nvGrpSpPr>
              <p:cNvPr id="288" name="Group 4106"/>
              <p:cNvGrpSpPr/>
              <p:nvPr/>
            </p:nvGrpSpPr>
            <p:grpSpPr>
              <a:xfrm>
                <a:off x="4357273" y="1603314"/>
                <a:ext cx="550721" cy="288634"/>
                <a:chOff x="0" y="0"/>
                <a:chExt cx="550720" cy="288633"/>
              </a:xfrm>
            </p:grpSpPr>
            <p:grpSp>
              <p:nvGrpSpPr>
                <p:cNvPr id="285" name="Group 50"/>
                <p:cNvGrpSpPr/>
                <p:nvPr/>
              </p:nvGrpSpPr>
              <p:grpSpPr>
                <a:xfrm>
                  <a:off x="-1" y="14732"/>
                  <a:ext cx="350129" cy="273902"/>
                  <a:chOff x="0" y="0"/>
                  <a:chExt cx="350127" cy="273900"/>
                </a:xfrm>
              </p:grpSpPr>
              <p:sp>
                <p:nvSpPr>
                  <p:cNvPr id="281" name="Freeform 76"/>
                  <p:cNvSpPr/>
                  <p:nvPr/>
                </p:nvSpPr>
                <p:spPr>
                  <a:xfrm>
                    <a:off x="79345" y="-1"/>
                    <a:ext cx="180522" cy="203314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716" extrusionOk="0">
                        <a:moveTo>
                          <a:pt x="21600" y="4781"/>
                        </a:moveTo>
                        <a:cubicBezTo>
                          <a:pt x="20700" y="3453"/>
                          <a:pt x="20137" y="1892"/>
                          <a:pt x="18900" y="797"/>
                        </a:cubicBezTo>
                        <a:cubicBezTo>
                          <a:pt x="17001" y="-884"/>
                          <a:pt x="12265" y="581"/>
                          <a:pt x="10800" y="797"/>
                        </a:cubicBezTo>
                        <a:cubicBezTo>
                          <a:pt x="10092" y="1737"/>
                          <a:pt x="7923" y="4164"/>
                          <a:pt x="8100" y="5578"/>
                        </a:cubicBezTo>
                        <a:cubicBezTo>
                          <a:pt x="8310" y="7247"/>
                          <a:pt x="9900" y="10358"/>
                          <a:pt x="9900" y="10358"/>
                        </a:cubicBezTo>
                        <a:cubicBezTo>
                          <a:pt x="9600" y="12483"/>
                          <a:pt x="9898" y="14744"/>
                          <a:pt x="9000" y="16732"/>
                        </a:cubicBezTo>
                        <a:cubicBezTo>
                          <a:pt x="8310" y="18261"/>
                          <a:pt x="3874" y="18863"/>
                          <a:pt x="2700" y="19123"/>
                        </a:cubicBezTo>
                        <a:lnTo>
                          <a:pt x="0" y="20716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82" name="Freeform 77"/>
                  <p:cNvSpPr/>
                  <p:nvPr/>
                </p:nvSpPr>
                <p:spPr>
                  <a:xfrm>
                    <a:off x="-1" y="109480"/>
                    <a:ext cx="210610" cy="86014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1600" extrusionOk="0">
                        <a:moveTo>
                          <a:pt x="0" y="0"/>
                        </a:moveTo>
                        <a:cubicBezTo>
                          <a:pt x="1162" y="2367"/>
                          <a:pt x="7153" y="15030"/>
                          <a:pt x="8486" y="15709"/>
                        </a:cubicBezTo>
                        <a:cubicBezTo>
                          <a:pt x="9771" y="16364"/>
                          <a:pt x="11078" y="16794"/>
                          <a:pt x="12343" y="17673"/>
                        </a:cubicBezTo>
                        <a:cubicBezTo>
                          <a:pt x="13912" y="18762"/>
                          <a:pt x="15345" y="21600"/>
                          <a:pt x="16971" y="21600"/>
                        </a:cubicBezTo>
                        <a:lnTo>
                          <a:pt x="21600" y="21600"/>
                        </a:ln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83" name="Freeform 78"/>
                  <p:cNvSpPr/>
                  <p:nvPr/>
                </p:nvSpPr>
                <p:spPr>
                  <a:xfrm>
                    <a:off x="274909" y="61720"/>
                    <a:ext cx="75219" cy="102496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099" h="20001" extrusionOk="0">
                        <a:moveTo>
                          <a:pt x="0" y="6268"/>
                        </a:moveTo>
                        <a:cubicBezTo>
                          <a:pt x="3516" y="5759"/>
                          <a:pt x="7436" y="6029"/>
                          <a:pt x="10550" y="4742"/>
                        </a:cubicBezTo>
                        <a:cubicBezTo>
                          <a:pt x="21600" y="175"/>
                          <a:pt x="7455" y="-1599"/>
                          <a:pt x="21099" y="1690"/>
                        </a:cubicBezTo>
                        <a:cubicBezTo>
                          <a:pt x="18849" y="17961"/>
                          <a:pt x="18989" y="11837"/>
                          <a:pt x="18989" y="20001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  <p:sp>
                <p:nvSpPr>
                  <p:cNvPr id="284" name="Freeform 79"/>
                  <p:cNvSpPr/>
                  <p:nvPr/>
                </p:nvSpPr>
                <p:spPr>
                  <a:xfrm>
                    <a:off x="139518" y="234740"/>
                    <a:ext cx="195566" cy="39160"/>
                  </a:xfrm>
                  <a:custGeom>
                    <a:avLst/>
                    <a:gdLst/>
                    <a:ahLst/>
                    <a:cxnLst>
                      <a:cxn ang="0">
                        <a:pos x="wd2" y="hd2"/>
                      </a:cxn>
                      <a:cxn ang="5400000">
                        <a:pos x="wd2" y="hd2"/>
                      </a:cxn>
                      <a:cxn ang="10800000">
                        <a:pos x="wd2" y="hd2"/>
                      </a:cxn>
                      <a:cxn ang="16200000">
                        <a:pos x="wd2" y="hd2"/>
                      </a:cxn>
                    </a:cxnLst>
                    <a:rect l="0" t="0" r="r" b="b"/>
                    <a:pathLst>
                      <a:path w="21600" h="20942" extrusionOk="0">
                        <a:moveTo>
                          <a:pt x="0" y="20942"/>
                        </a:moveTo>
                        <a:cubicBezTo>
                          <a:pt x="808" y="19316"/>
                          <a:pt x="5182" y="10035"/>
                          <a:pt x="6646" y="8397"/>
                        </a:cubicBezTo>
                        <a:cubicBezTo>
                          <a:pt x="8291" y="6558"/>
                          <a:pt x="9963" y="5414"/>
                          <a:pt x="11631" y="4215"/>
                        </a:cubicBezTo>
                        <a:cubicBezTo>
                          <a:pt x="18408" y="-658"/>
                          <a:pt x="16525" y="34"/>
                          <a:pt x="21600" y="34"/>
                        </a:cubicBezTo>
                      </a:path>
                    </a:pathLst>
                  </a:custGeom>
                  <a:noFill/>
                  <a:ln w="12700" cap="flat">
                    <a:solidFill>
                      <a:srgbClr val="000000"/>
                    </a:solidFill>
                    <a:prstDash val="solid"/>
                    <a:round/>
                  </a:ln>
                  <a:effectLst/>
                </p:spPr>
                <p:txBody>
                  <a:bodyPr wrap="square" lIns="45719" tIns="45719" rIns="45719" bIns="45719" numCol="1" anchor="ctr">
                    <a:noAutofit/>
                  </a:bodyPr>
                  <a:lstStyle/>
                  <a:p>
                    <a:pPr algn="ctr">
                      <a:defRPr sz="700">
                        <a:solidFill>
                          <a:srgbClr val="FFFFFF"/>
                        </a:solidFill>
                      </a:defRPr>
                    </a:pPr>
                    <a:endParaRPr sz="1200"/>
                  </a:p>
                </p:txBody>
              </p:sp>
            </p:grpSp>
            <p:sp>
              <p:nvSpPr>
                <p:cNvPr id="286" name="Freeform 369"/>
                <p:cNvSpPr/>
                <p:nvPr/>
              </p:nvSpPr>
              <p:spPr>
                <a:xfrm>
                  <a:off x="388036" y="165463"/>
                  <a:ext cx="162685" cy="72929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  <p:sp>
              <p:nvSpPr>
                <p:cNvPr id="287" name="Freeform 414"/>
                <p:cNvSpPr/>
                <p:nvPr/>
              </p:nvSpPr>
              <p:spPr>
                <a:xfrm>
                  <a:off x="313930" y="0"/>
                  <a:ext cx="162685" cy="72929"/>
                </a:xfrm>
                <a:custGeom>
                  <a:avLst/>
                  <a:gdLst/>
                  <a:ahLst/>
                  <a:cxnLst>
                    <a:cxn ang="0">
                      <a:pos x="wd2" y="hd2"/>
                    </a:cxn>
                    <a:cxn ang="5400000">
                      <a:pos x="wd2" y="hd2"/>
                    </a:cxn>
                    <a:cxn ang="10800000">
                      <a:pos x="wd2" y="hd2"/>
                    </a:cxn>
                    <a:cxn ang="16200000">
                      <a:pos x="wd2" y="hd2"/>
                    </a:cxn>
                  </a:cxnLst>
                  <a:rect l="0" t="0" r="r" b="b"/>
                  <a:pathLst>
                    <a:path w="21223" h="20803" extrusionOk="0">
                      <a:moveTo>
                        <a:pt x="0" y="20803"/>
                      </a:moveTo>
                      <a:cubicBezTo>
                        <a:pt x="1359" y="2978"/>
                        <a:pt x="-377" y="17652"/>
                        <a:pt x="2196" y="6401"/>
                      </a:cubicBezTo>
                      <a:cubicBezTo>
                        <a:pt x="2541" y="4892"/>
                        <a:pt x="2382" y="2793"/>
                        <a:pt x="2927" y="1600"/>
                      </a:cubicBezTo>
                      <a:cubicBezTo>
                        <a:pt x="3473" y="408"/>
                        <a:pt x="4391" y="533"/>
                        <a:pt x="5123" y="0"/>
                      </a:cubicBezTo>
                      <a:cubicBezTo>
                        <a:pt x="7562" y="533"/>
                        <a:pt x="10248" y="-797"/>
                        <a:pt x="12441" y="1600"/>
                      </a:cubicBezTo>
                      <a:cubicBezTo>
                        <a:pt x="14014" y="3320"/>
                        <a:pt x="13700" y="9985"/>
                        <a:pt x="15368" y="11202"/>
                      </a:cubicBezTo>
                      <a:lnTo>
                        <a:pt x="17564" y="12802"/>
                      </a:lnTo>
                      <a:cubicBezTo>
                        <a:pt x="18296" y="12268"/>
                        <a:pt x="19157" y="12255"/>
                        <a:pt x="19759" y="11202"/>
                      </a:cubicBezTo>
                      <a:cubicBezTo>
                        <a:pt x="20446" y="10000"/>
                        <a:pt x="21223" y="6401"/>
                        <a:pt x="21223" y="6401"/>
                      </a:cubicBez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</a:ln>
                <a:effectLst/>
              </p:spPr>
              <p:txBody>
                <a:bodyPr wrap="square" lIns="45719" tIns="45719" rIns="45719" bIns="45719" numCol="1" anchor="ctr">
                  <a:noAutofit/>
                </a:bodyPr>
                <a:lstStyle/>
                <a:p>
                  <a:pPr algn="ctr">
                    <a:defRPr>
                      <a:solidFill>
                        <a:srgbClr val="FFFFFF"/>
                      </a:solidFill>
                    </a:defRPr>
                  </a:pPr>
                  <a:endParaRPr sz="1200"/>
                </a:p>
              </p:txBody>
            </p:sp>
          </p:grpSp>
          <p:sp>
            <p:nvSpPr>
              <p:cNvPr id="289" name="Straight Connector 4110"/>
              <p:cNvSpPr/>
              <p:nvPr/>
            </p:nvSpPr>
            <p:spPr>
              <a:xfrm>
                <a:off x="275266" y="3305625"/>
                <a:ext cx="4407410" cy="1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290" name="Straight Connector 4114"/>
              <p:cNvSpPr/>
              <p:nvPr/>
            </p:nvSpPr>
            <p:spPr>
              <a:xfrm flipH="1">
                <a:off x="274423" y="3146137"/>
                <a:ext cx="1" cy="152401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291" name="Straight Connector 435"/>
              <p:cNvSpPr/>
              <p:nvPr/>
            </p:nvSpPr>
            <p:spPr>
              <a:xfrm>
                <a:off x="1150531" y="3146137"/>
                <a:ext cx="1" cy="152401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292" name="Straight Connector 436"/>
              <p:cNvSpPr/>
              <p:nvPr/>
            </p:nvSpPr>
            <p:spPr>
              <a:xfrm>
                <a:off x="2042980" y="3147909"/>
                <a:ext cx="1" cy="152401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293" name="Straight Connector 437"/>
              <p:cNvSpPr/>
              <p:nvPr/>
            </p:nvSpPr>
            <p:spPr>
              <a:xfrm>
                <a:off x="2899946" y="3146137"/>
                <a:ext cx="1" cy="152401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294" name="Straight Connector 438"/>
              <p:cNvSpPr/>
              <p:nvPr/>
            </p:nvSpPr>
            <p:spPr>
              <a:xfrm>
                <a:off x="3772226" y="3146137"/>
                <a:ext cx="1" cy="152401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295" name="Straight Connector 440"/>
              <p:cNvSpPr/>
              <p:nvPr/>
            </p:nvSpPr>
            <p:spPr>
              <a:xfrm>
                <a:off x="4684082" y="3153225"/>
                <a:ext cx="1" cy="152401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296" name="Straight Connector 442"/>
              <p:cNvSpPr/>
              <p:nvPr/>
            </p:nvSpPr>
            <p:spPr>
              <a:xfrm>
                <a:off x="2403629" y="3307681"/>
                <a:ext cx="1" cy="246889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tailEnd type="triangle" w="med" len="med"/>
              </a:ln>
              <a:effectLst/>
            </p:spPr>
            <p:txBody>
              <a:bodyPr wrap="square" lIns="45719" tIns="45719" rIns="45719" bIns="45719" numCol="1" anchor="t">
                <a:noAutofit/>
              </a:bodyPr>
              <a:lstStyle/>
              <a:p>
                <a:endParaRPr sz="1200"/>
              </a:p>
            </p:txBody>
          </p:sp>
          <p:sp>
            <p:nvSpPr>
              <p:cNvPr id="297" name="TextBox 444"/>
              <p:cNvSpPr txBox="1"/>
              <p:nvPr/>
            </p:nvSpPr>
            <p:spPr>
              <a:xfrm>
                <a:off x="1505788" y="3590722"/>
                <a:ext cx="2259176" cy="276997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45719" tIns="45719" rIns="45719" bIns="45719" numCol="1" anchor="t">
                <a:spAutoFit/>
              </a:bodyPr>
              <a:lstStyle>
                <a:lvl1pPr>
                  <a:defRPr sz="1000" b="1">
                    <a:latin typeface="Arial"/>
                    <a:ea typeface="Arial"/>
                    <a:cs typeface="Arial"/>
                    <a:sym typeface="Arial"/>
                  </a:defRPr>
                </a:lvl1pPr>
              </a:lstStyle>
              <a:p>
                <a:r>
                  <a:rPr sz="1200" b="0" dirty="0"/>
                  <a:t>Combined  TMT labeled peptides</a:t>
                </a:r>
              </a:p>
            </p:txBody>
          </p:sp>
        </p:grpSp>
        <p:sp>
          <p:nvSpPr>
            <p:cNvPr id="300" name="TextBox 622"/>
            <p:cNvSpPr txBox="1"/>
            <p:nvPr/>
          </p:nvSpPr>
          <p:spPr>
            <a:xfrm>
              <a:off x="2599380" y="4608822"/>
              <a:ext cx="869788" cy="276999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none" lIns="45719" rIns="45719">
              <a:spAutoFit/>
            </a:bodyPr>
            <a:lstStyle>
              <a:lvl1pPr>
                <a:defRPr sz="10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rPr lang="en-US" sz="1200" b="1" dirty="0"/>
                <a:t>6</a:t>
              </a:r>
              <a:r>
                <a:rPr sz="1200" b="1" dirty="0"/>
                <a:t> fractions</a:t>
              </a:r>
            </a:p>
          </p:txBody>
        </p:sp>
        <p:sp>
          <p:nvSpPr>
            <p:cNvPr id="301" name="TextBox 623"/>
            <p:cNvSpPr txBox="1"/>
            <p:nvPr/>
          </p:nvSpPr>
          <p:spPr>
            <a:xfrm>
              <a:off x="2269237" y="5213037"/>
              <a:ext cx="1494959" cy="276999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none" lIns="45719" rIns="45719">
              <a:spAutoFit/>
            </a:bodyPr>
            <a:lstStyle>
              <a:lvl1pPr algn="ctr">
                <a:defRPr sz="10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rPr sz="1200" b="1" dirty="0"/>
                <a:t>O-</a:t>
              </a:r>
              <a:r>
                <a:rPr sz="1200" b="1" dirty="0" err="1"/>
                <a:t>GlcNAc</a:t>
              </a:r>
              <a:r>
                <a:rPr sz="1200" b="1" dirty="0"/>
                <a:t> peptides</a:t>
              </a:r>
            </a:p>
          </p:txBody>
        </p:sp>
        <p:sp>
          <p:nvSpPr>
            <p:cNvPr id="302" name="Straight Connector 636"/>
            <p:cNvSpPr/>
            <p:nvPr/>
          </p:nvSpPr>
          <p:spPr>
            <a:xfrm>
              <a:off x="2912854" y="4267200"/>
              <a:ext cx="1" cy="381001"/>
            </a:xfrm>
            <a:prstGeom prst="line">
              <a:avLst/>
            </a:prstGeom>
            <a:ln w="12700">
              <a:solidFill>
                <a:srgbClr val="000000"/>
              </a:solidFill>
              <a:tailEnd type="triangle"/>
            </a:ln>
          </p:spPr>
          <p:txBody>
            <a:bodyPr lIns="45719" rIns="45719"/>
            <a:lstStyle/>
            <a:p>
              <a:endParaRPr/>
            </a:p>
          </p:txBody>
        </p:sp>
        <p:sp>
          <p:nvSpPr>
            <p:cNvPr id="305" name="Straight Connector 258"/>
            <p:cNvSpPr/>
            <p:nvPr/>
          </p:nvSpPr>
          <p:spPr>
            <a:xfrm>
              <a:off x="2931049" y="4826353"/>
              <a:ext cx="1" cy="381001"/>
            </a:xfrm>
            <a:prstGeom prst="line">
              <a:avLst/>
            </a:prstGeom>
            <a:ln w="12700">
              <a:solidFill>
                <a:srgbClr val="000000"/>
              </a:solidFill>
              <a:tailEnd type="triangle"/>
            </a:ln>
          </p:spPr>
          <p:txBody>
            <a:bodyPr lIns="45719" rIns="45719"/>
            <a:lstStyle/>
            <a:p>
              <a:endParaRPr/>
            </a:p>
          </p:txBody>
        </p:sp>
        <p:sp>
          <p:nvSpPr>
            <p:cNvPr id="307" name="TextBox 229">
              <a:extLst>
                <a:ext uri="{FF2B5EF4-FFF2-40B4-BE49-F238E27FC236}">
                  <a16:creationId xmlns:a16="http://schemas.microsoft.com/office/drawing/2014/main" id="{C4303EFD-5445-47B8-9755-A5D6146A829C}"/>
                </a:ext>
              </a:extLst>
            </p:cNvPr>
            <p:cNvSpPr txBox="1"/>
            <p:nvPr/>
          </p:nvSpPr>
          <p:spPr>
            <a:xfrm>
              <a:off x="2948023" y="4906997"/>
              <a:ext cx="518730" cy="27699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rPr lang="en-US" sz="1200" dirty="0"/>
                <a:t>CEPC</a:t>
              </a:r>
              <a:endParaRPr sz="1200" dirty="0"/>
            </a:p>
          </p:txBody>
        </p:sp>
        <p:sp>
          <p:nvSpPr>
            <p:cNvPr id="308" name="TextBox 229">
              <a:extLst>
                <a:ext uri="{FF2B5EF4-FFF2-40B4-BE49-F238E27FC236}">
                  <a16:creationId xmlns:a16="http://schemas.microsoft.com/office/drawing/2014/main" id="{2869C9F8-BF20-4E7E-B6ED-69337FE9A0DD}"/>
                </a:ext>
              </a:extLst>
            </p:cNvPr>
            <p:cNvSpPr txBox="1"/>
            <p:nvPr/>
          </p:nvSpPr>
          <p:spPr>
            <a:xfrm>
              <a:off x="2944962" y="4311199"/>
              <a:ext cx="1975860" cy="276997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none" lIns="45719" tIns="45719" rIns="45719" bIns="45719" numCol="1" anchor="t">
              <a:spAutoFit/>
            </a:bodyPr>
            <a:lstStyle>
              <a:lvl1pPr>
                <a:defRPr sz="10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rPr lang="en-US" sz="1200" dirty="0"/>
                <a:t>High pH RPLC fractionation</a:t>
              </a:r>
              <a:endParaRPr sz="1200" dirty="0"/>
            </a:p>
          </p:txBody>
        </p:sp>
        <p:sp>
          <p:nvSpPr>
            <p:cNvPr id="309" name="Straight Connector 258">
              <a:extLst>
                <a:ext uri="{FF2B5EF4-FFF2-40B4-BE49-F238E27FC236}">
                  <a16:creationId xmlns:a16="http://schemas.microsoft.com/office/drawing/2014/main" id="{818EF9DD-B75A-4A12-9FDF-C9FB98B7C4FB}"/>
                </a:ext>
              </a:extLst>
            </p:cNvPr>
            <p:cNvSpPr/>
            <p:nvPr/>
          </p:nvSpPr>
          <p:spPr>
            <a:xfrm>
              <a:off x="2944962" y="5490036"/>
              <a:ext cx="9177" cy="276999"/>
            </a:xfrm>
            <a:prstGeom prst="line">
              <a:avLst/>
            </a:prstGeom>
            <a:ln w="12700">
              <a:solidFill>
                <a:srgbClr val="000000"/>
              </a:solidFill>
              <a:tailEnd type="triangle"/>
            </a:ln>
          </p:spPr>
          <p:txBody>
            <a:bodyPr lIns="45719" rIns="45719"/>
            <a:lstStyle/>
            <a:p>
              <a:endParaRPr/>
            </a:p>
          </p:txBody>
        </p:sp>
        <p:sp>
          <p:nvSpPr>
            <p:cNvPr id="310" name="TextBox 623">
              <a:extLst>
                <a:ext uri="{FF2B5EF4-FFF2-40B4-BE49-F238E27FC236}">
                  <a16:creationId xmlns:a16="http://schemas.microsoft.com/office/drawing/2014/main" id="{148A1138-F315-48CC-902E-2754BF039D05}"/>
                </a:ext>
              </a:extLst>
            </p:cNvPr>
            <p:cNvSpPr txBox="1"/>
            <p:nvPr/>
          </p:nvSpPr>
          <p:spPr>
            <a:xfrm>
              <a:off x="2522427" y="5767035"/>
              <a:ext cx="853758" cy="276999"/>
            </a:xfrm>
            <a:prstGeom prst="rect">
              <a:avLst/>
            </a:prstGeom>
            <a:ln w="12700">
              <a:miter lim="400000"/>
            </a:ln>
            <a:extLst>
              <a:ext uri="{C572A759-6A51-4108-AA02-DFA0A04FC94B}">
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</a:ext>
            </a:extLst>
          </p:spPr>
          <p:txBody>
            <a:bodyPr wrap="none" lIns="45719" rIns="45719">
              <a:spAutoFit/>
            </a:bodyPr>
            <a:lstStyle>
              <a:lvl1pPr algn="ctr">
                <a:defRPr sz="1000">
                  <a:latin typeface="Arial"/>
                  <a:ea typeface="Arial"/>
                  <a:cs typeface="Arial"/>
                  <a:sym typeface="Arial"/>
                </a:defRPr>
              </a:lvl1pPr>
            </a:lstStyle>
            <a:p>
              <a:r>
                <a:rPr lang="en-US" sz="1200" b="1" dirty="0"/>
                <a:t>LC-MS/MS</a:t>
              </a:r>
              <a:endParaRPr sz="1200" b="1" dirty="0"/>
            </a:p>
          </p:txBody>
        </p:sp>
      </p:grpSp>
      <p:sp>
        <p:nvSpPr>
          <p:cNvPr id="299" name="Rectangle 298"/>
          <p:cNvSpPr>
            <a:spLocks noChangeArrowheads="1"/>
          </p:cNvSpPr>
          <p:nvPr/>
        </p:nvSpPr>
        <p:spPr bwMode="auto">
          <a:xfrm>
            <a:off x="6015288" y="1689931"/>
            <a:ext cx="5744824" cy="20537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83127" tIns="41564" rIns="83127" bIns="41564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831281" eaLnBrk="0" fontAlgn="base">
              <a:spcBef>
                <a:spcPct val="0"/>
              </a:spcBef>
              <a:spcAft>
                <a:spcPct val="0"/>
              </a:spcAft>
            </a:pPr>
            <a:r>
              <a:rPr lang="en-US" alt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2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The experimental workflow. Cortex tissues from controls and Thiamet G treated mice were quickly frozen in -</a:t>
            </a:r>
            <a:r>
              <a:rPr lang="en-US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80°C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prior processing.  For O-GlcNAc enrichment and LC-MS/MS analyses, tissues were homogenized and trypsin digested before TMT labeling with isobaric tags.  The labeled peptides were then combined, fractionated, and subjected to CEPC enrichment and LC-MS/MS for each fraction. </a:t>
            </a:r>
            <a:endParaRPr lang="en-US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90089083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09C9209-7F12-4A6E-99A0-3D4DC95F70D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7040" y="3446706"/>
            <a:ext cx="9665595" cy="329234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D07A012D-6D28-47C5-BA66-0C11C0F515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6102" y="92758"/>
            <a:ext cx="9716533" cy="3292343"/>
          </a:xfrm>
          <a:prstGeom prst="rect">
            <a:avLst/>
          </a:prstGeom>
        </p:spPr>
      </p:pic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7E0D6553-598A-4E56-BF36-8A9E829849BE}"/>
              </a:ext>
            </a:extLst>
          </p:cNvPr>
          <p:cNvCxnSpPr>
            <a:cxnSpLocks/>
          </p:cNvCxnSpPr>
          <p:nvPr/>
        </p:nvCxnSpPr>
        <p:spPr>
          <a:xfrm>
            <a:off x="5382152" y="5713048"/>
            <a:ext cx="152023" cy="468797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10">
            <a:extLst>
              <a:ext uri="{FF2B5EF4-FFF2-40B4-BE49-F238E27FC236}">
                <a16:creationId xmlns:a16="http://schemas.microsoft.com/office/drawing/2014/main" id="{ACB23781-4536-43CA-8542-793E6C6F1B8B}"/>
              </a:ext>
            </a:extLst>
          </p:cNvPr>
          <p:cNvSpPr txBox="1"/>
          <p:nvPr/>
        </p:nvSpPr>
        <p:spPr>
          <a:xfrm>
            <a:off x="5200429" y="5510837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</a:p>
        </p:txBody>
      </p: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DA4B549E-D2C0-420A-989D-B48994419BCA}"/>
              </a:ext>
            </a:extLst>
          </p:cNvPr>
          <p:cNvCxnSpPr>
            <a:cxnSpLocks/>
          </p:cNvCxnSpPr>
          <p:nvPr/>
        </p:nvCxnSpPr>
        <p:spPr>
          <a:xfrm>
            <a:off x="914617" y="5947446"/>
            <a:ext cx="49353" cy="25846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1E72D6DD-AFAF-494E-B655-396F9A8EB957}"/>
              </a:ext>
            </a:extLst>
          </p:cNvPr>
          <p:cNvSpPr txBox="1"/>
          <p:nvPr/>
        </p:nvSpPr>
        <p:spPr>
          <a:xfrm>
            <a:off x="733118" y="5729092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FECF57C0-ED10-4E46-88E3-8958FB64ADA4}"/>
              </a:ext>
            </a:extLst>
          </p:cNvPr>
          <p:cNvCxnSpPr>
            <a:cxnSpLocks/>
          </p:cNvCxnSpPr>
          <p:nvPr/>
        </p:nvCxnSpPr>
        <p:spPr>
          <a:xfrm>
            <a:off x="1203375" y="5947446"/>
            <a:ext cx="37320" cy="33641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48B9D92A-7893-4D9A-A0F7-D600E5464D62}"/>
              </a:ext>
            </a:extLst>
          </p:cNvPr>
          <p:cNvSpPr txBox="1"/>
          <p:nvPr/>
        </p:nvSpPr>
        <p:spPr>
          <a:xfrm>
            <a:off x="1040510" y="5729092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2</a:t>
            </a:r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CE606749-D693-4559-A009-F1D0BD6A9ADD}"/>
              </a:ext>
            </a:extLst>
          </p:cNvPr>
          <p:cNvCxnSpPr>
            <a:cxnSpLocks/>
          </p:cNvCxnSpPr>
          <p:nvPr/>
        </p:nvCxnSpPr>
        <p:spPr>
          <a:xfrm flipH="1">
            <a:off x="1858316" y="5741125"/>
            <a:ext cx="123967" cy="54784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DE83CB28-FC04-4D43-9C13-4B7CFC22C0EE}"/>
              </a:ext>
            </a:extLst>
          </p:cNvPr>
          <p:cNvSpPr txBox="1"/>
          <p:nvPr/>
        </p:nvSpPr>
        <p:spPr>
          <a:xfrm>
            <a:off x="1819418" y="5510837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4</a:t>
            </a: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C224F7DC-EA21-4F3D-B747-618E5180DBFE}"/>
              </a:ext>
            </a:extLst>
          </p:cNvPr>
          <p:cNvCxnSpPr>
            <a:cxnSpLocks/>
          </p:cNvCxnSpPr>
          <p:nvPr/>
        </p:nvCxnSpPr>
        <p:spPr>
          <a:xfrm flipH="1">
            <a:off x="2122800" y="5611257"/>
            <a:ext cx="91227" cy="55465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766F3F63-5856-4257-BB1C-1F0CF1782799}"/>
              </a:ext>
            </a:extLst>
          </p:cNvPr>
          <p:cNvSpPr txBox="1"/>
          <p:nvPr/>
        </p:nvSpPr>
        <p:spPr>
          <a:xfrm>
            <a:off x="2051162" y="5388435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5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C19F7B67-5D85-4CBC-9748-E614B9AF0A88}"/>
              </a:ext>
            </a:extLst>
          </p:cNvPr>
          <p:cNvCxnSpPr>
            <a:cxnSpLocks/>
          </p:cNvCxnSpPr>
          <p:nvPr/>
        </p:nvCxnSpPr>
        <p:spPr>
          <a:xfrm flipH="1">
            <a:off x="2545998" y="5741125"/>
            <a:ext cx="51299" cy="5039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B292875B-F928-4944-A210-D730A1C7C954}"/>
              </a:ext>
            </a:extLst>
          </p:cNvPr>
          <p:cNvSpPr txBox="1"/>
          <p:nvPr/>
        </p:nvSpPr>
        <p:spPr>
          <a:xfrm>
            <a:off x="2437039" y="551924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6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3DA5F25-5DB0-468F-9C37-98DFB799D453}"/>
              </a:ext>
            </a:extLst>
          </p:cNvPr>
          <p:cNvCxnSpPr>
            <a:cxnSpLocks/>
          </p:cNvCxnSpPr>
          <p:nvPr/>
        </p:nvCxnSpPr>
        <p:spPr>
          <a:xfrm flipH="1">
            <a:off x="2819856" y="6165909"/>
            <a:ext cx="51872" cy="23032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F346A09B-9EF2-479F-9D27-AD8009FDF911}"/>
              </a:ext>
            </a:extLst>
          </p:cNvPr>
          <p:cNvSpPr txBox="1"/>
          <p:nvPr/>
        </p:nvSpPr>
        <p:spPr>
          <a:xfrm>
            <a:off x="2786002" y="5995249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7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24A3A75C-8CC2-4524-88F6-85A48F45F401}"/>
              </a:ext>
            </a:extLst>
          </p:cNvPr>
          <p:cNvCxnSpPr>
            <a:cxnSpLocks/>
          </p:cNvCxnSpPr>
          <p:nvPr/>
        </p:nvCxnSpPr>
        <p:spPr>
          <a:xfrm>
            <a:off x="3008618" y="5434793"/>
            <a:ext cx="75946" cy="49259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4EBD6026-C1D3-4B6B-BDB7-3865583DCF25}"/>
              </a:ext>
            </a:extLst>
          </p:cNvPr>
          <p:cNvSpPr txBox="1"/>
          <p:nvPr/>
        </p:nvSpPr>
        <p:spPr>
          <a:xfrm>
            <a:off x="2841781" y="5214647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8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75387EB-7FCE-4C27-9EFE-B1E826AFA5A9}"/>
              </a:ext>
            </a:extLst>
          </p:cNvPr>
          <p:cNvSpPr txBox="1"/>
          <p:nvPr/>
        </p:nvSpPr>
        <p:spPr>
          <a:xfrm>
            <a:off x="3198717" y="3847060"/>
            <a:ext cx="32573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9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3468E19B-1AA4-4BA6-A934-38B05A91C4FB}"/>
              </a:ext>
            </a:extLst>
          </p:cNvPr>
          <p:cNvCxnSpPr>
            <a:cxnSpLocks/>
          </p:cNvCxnSpPr>
          <p:nvPr/>
        </p:nvCxnSpPr>
        <p:spPr>
          <a:xfrm flipH="1">
            <a:off x="3835256" y="5476257"/>
            <a:ext cx="75224" cy="4872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>
            <a:extLst>
              <a:ext uri="{FF2B5EF4-FFF2-40B4-BE49-F238E27FC236}">
                <a16:creationId xmlns:a16="http://schemas.microsoft.com/office/drawing/2014/main" id="{B7DCE6F1-54C5-4CDA-8E47-5DBA6C24AF50}"/>
              </a:ext>
            </a:extLst>
          </p:cNvPr>
          <p:cNvSpPr txBox="1"/>
          <p:nvPr/>
        </p:nvSpPr>
        <p:spPr>
          <a:xfrm>
            <a:off x="3835256" y="5303988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0</a:t>
            </a:r>
          </a:p>
        </p:txBody>
      </p:sp>
      <p:cxnSp>
        <p:nvCxnSpPr>
          <p:cNvPr id="43" name="Straight Connector 42">
            <a:extLst>
              <a:ext uri="{FF2B5EF4-FFF2-40B4-BE49-F238E27FC236}">
                <a16:creationId xmlns:a16="http://schemas.microsoft.com/office/drawing/2014/main" id="{667E8EDF-7969-483C-9A69-65FEEDD103D2}"/>
              </a:ext>
            </a:extLst>
          </p:cNvPr>
          <p:cNvCxnSpPr>
            <a:cxnSpLocks/>
          </p:cNvCxnSpPr>
          <p:nvPr/>
        </p:nvCxnSpPr>
        <p:spPr>
          <a:xfrm flipH="1">
            <a:off x="4441458" y="5214423"/>
            <a:ext cx="51299" cy="5039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id="{1380F4B7-0CD4-4C80-BD7D-26A52790124B}"/>
              </a:ext>
            </a:extLst>
          </p:cNvPr>
          <p:cNvSpPr txBox="1"/>
          <p:nvPr/>
        </p:nvSpPr>
        <p:spPr>
          <a:xfrm>
            <a:off x="4294626" y="4999189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A1E4D81-8A56-41AD-A930-2758D9C8CBB1}"/>
              </a:ext>
            </a:extLst>
          </p:cNvPr>
          <p:cNvSpPr txBox="1"/>
          <p:nvPr/>
        </p:nvSpPr>
        <p:spPr>
          <a:xfrm>
            <a:off x="4854204" y="5594276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2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93ACA0E3-73D5-4A85-93C0-A8E35EDA168E}"/>
              </a:ext>
            </a:extLst>
          </p:cNvPr>
          <p:cNvSpPr txBox="1"/>
          <p:nvPr/>
        </p:nvSpPr>
        <p:spPr>
          <a:xfrm>
            <a:off x="5061901" y="5083842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3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3DC2F87D-0872-4AD1-87F2-48B71A8F377B}"/>
              </a:ext>
            </a:extLst>
          </p:cNvPr>
          <p:cNvSpPr txBox="1"/>
          <p:nvPr/>
        </p:nvSpPr>
        <p:spPr>
          <a:xfrm>
            <a:off x="5989486" y="5476257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4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14E26741-AAAD-4B13-B035-921485BED9BA}"/>
              </a:ext>
            </a:extLst>
          </p:cNvPr>
          <p:cNvSpPr txBox="1"/>
          <p:nvPr/>
        </p:nvSpPr>
        <p:spPr>
          <a:xfrm>
            <a:off x="6456878" y="5582243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5</a:t>
            </a:r>
          </a:p>
        </p:txBody>
      </p: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E32D6FFA-4496-408D-944D-05C5E2BE8C59}"/>
              </a:ext>
            </a:extLst>
          </p:cNvPr>
          <p:cNvCxnSpPr>
            <a:cxnSpLocks/>
          </p:cNvCxnSpPr>
          <p:nvPr/>
        </p:nvCxnSpPr>
        <p:spPr>
          <a:xfrm flipH="1">
            <a:off x="6999262" y="5504631"/>
            <a:ext cx="51299" cy="50396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3F52AF9D-0EE7-44CF-A5C6-5D97707A2EC1}"/>
              </a:ext>
            </a:extLst>
          </p:cNvPr>
          <p:cNvSpPr txBox="1"/>
          <p:nvPr/>
        </p:nvSpPr>
        <p:spPr>
          <a:xfrm>
            <a:off x="6849081" y="5289228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6</a:t>
            </a:r>
          </a:p>
        </p:txBody>
      </p:sp>
      <p:cxnSp>
        <p:nvCxnSpPr>
          <p:cNvPr id="51" name="Straight Connector 50">
            <a:extLst>
              <a:ext uri="{FF2B5EF4-FFF2-40B4-BE49-F238E27FC236}">
                <a16:creationId xmlns:a16="http://schemas.microsoft.com/office/drawing/2014/main" id="{5CCBE18E-4F55-4DCB-8B94-127E5B510392}"/>
              </a:ext>
            </a:extLst>
          </p:cNvPr>
          <p:cNvCxnSpPr>
            <a:cxnSpLocks/>
          </p:cNvCxnSpPr>
          <p:nvPr/>
        </p:nvCxnSpPr>
        <p:spPr>
          <a:xfrm flipH="1">
            <a:off x="7680373" y="5737098"/>
            <a:ext cx="59719" cy="48084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9D0E53C1-E465-4E92-AB84-695363C254B6}"/>
              </a:ext>
            </a:extLst>
          </p:cNvPr>
          <p:cNvSpPr txBox="1"/>
          <p:nvPr/>
        </p:nvSpPr>
        <p:spPr>
          <a:xfrm>
            <a:off x="7557393" y="5504631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8</a:t>
            </a:r>
          </a:p>
        </p:txBody>
      </p:sp>
      <p:cxnSp>
        <p:nvCxnSpPr>
          <p:cNvPr id="54" name="Straight Connector 53">
            <a:extLst>
              <a:ext uri="{FF2B5EF4-FFF2-40B4-BE49-F238E27FC236}">
                <a16:creationId xmlns:a16="http://schemas.microsoft.com/office/drawing/2014/main" id="{EDA57BEA-F632-4476-8D71-F0578BCE8AA0}"/>
              </a:ext>
            </a:extLst>
          </p:cNvPr>
          <p:cNvCxnSpPr>
            <a:cxnSpLocks/>
          </p:cNvCxnSpPr>
          <p:nvPr/>
        </p:nvCxnSpPr>
        <p:spPr>
          <a:xfrm flipH="1">
            <a:off x="8012748" y="5784218"/>
            <a:ext cx="59719" cy="48084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>
            <a:extLst>
              <a:ext uri="{FF2B5EF4-FFF2-40B4-BE49-F238E27FC236}">
                <a16:creationId xmlns:a16="http://schemas.microsoft.com/office/drawing/2014/main" id="{9F8D0DDB-B787-42B6-BF50-E5E9921E6B89}"/>
              </a:ext>
            </a:extLst>
          </p:cNvPr>
          <p:cNvSpPr txBox="1"/>
          <p:nvPr/>
        </p:nvSpPr>
        <p:spPr>
          <a:xfrm>
            <a:off x="7891852" y="5568893"/>
            <a:ext cx="39626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9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FFFB62DB-5A4A-470C-ACE8-D677367890ED}"/>
              </a:ext>
            </a:extLst>
          </p:cNvPr>
          <p:cNvSpPr txBox="1"/>
          <p:nvPr/>
        </p:nvSpPr>
        <p:spPr>
          <a:xfrm>
            <a:off x="3612851" y="3518698"/>
            <a:ext cx="86395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cNAc</a:t>
            </a:r>
            <a:endParaRPr 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AAE2ECA2-BAEB-44B2-BC5F-112BBCF7D713}"/>
              </a:ext>
            </a:extLst>
          </p:cNvPr>
          <p:cNvSpPr/>
          <p:nvPr/>
        </p:nvSpPr>
        <p:spPr>
          <a:xfrm>
            <a:off x="3872868" y="3853295"/>
            <a:ext cx="5973174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   </a:t>
            </a:r>
            <a:r>
              <a:rPr lang="en-US" sz="15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A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   F   S   E   Q   V  G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S  G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A  G  R</a:t>
            </a:r>
          </a:p>
        </p:txBody>
      </p:sp>
      <p:grpSp>
        <p:nvGrpSpPr>
          <p:cNvPr id="60" name="Group 59">
            <a:extLst>
              <a:ext uri="{FF2B5EF4-FFF2-40B4-BE49-F238E27FC236}">
                <a16:creationId xmlns:a16="http://schemas.microsoft.com/office/drawing/2014/main" id="{C7E47C1E-948C-4901-90B3-CE6A639F9D88}"/>
              </a:ext>
            </a:extLst>
          </p:cNvPr>
          <p:cNvGrpSpPr/>
          <p:nvPr/>
        </p:nvGrpSpPr>
        <p:grpSpPr>
          <a:xfrm>
            <a:off x="9532321" y="3881312"/>
            <a:ext cx="164882" cy="274320"/>
            <a:chOff x="8894183" y="520304"/>
            <a:chExt cx="164882" cy="274320"/>
          </a:xfrm>
        </p:grpSpPr>
        <p:cxnSp>
          <p:nvCxnSpPr>
            <p:cNvPr id="132" name="Straight Connector 131">
              <a:extLst>
                <a:ext uri="{FF2B5EF4-FFF2-40B4-BE49-F238E27FC236}">
                  <a16:creationId xmlns:a16="http://schemas.microsoft.com/office/drawing/2014/main" id="{F48B51F0-B32C-4801-9857-FA02BBC53D92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3" name="Straight Connector 132">
              <a:extLst>
                <a:ext uri="{FF2B5EF4-FFF2-40B4-BE49-F238E27FC236}">
                  <a16:creationId xmlns:a16="http://schemas.microsoft.com/office/drawing/2014/main" id="{18E90EA8-5ED7-41D4-A9B7-30A20D21764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1" name="Group 60">
            <a:extLst>
              <a:ext uri="{FF2B5EF4-FFF2-40B4-BE49-F238E27FC236}">
                <a16:creationId xmlns:a16="http://schemas.microsoft.com/office/drawing/2014/main" id="{79B64CC8-B152-4EBB-A0E8-09E9EFAE45C1}"/>
              </a:ext>
            </a:extLst>
          </p:cNvPr>
          <p:cNvGrpSpPr/>
          <p:nvPr/>
        </p:nvGrpSpPr>
        <p:grpSpPr>
          <a:xfrm>
            <a:off x="9298113" y="3881312"/>
            <a:ext cx="164882" cy="274320"/>
            <a:chOff x="8894183" y="520304"/>
            <a:chExt cx="164882" cy="274320"/>
          </a:xfrm>
        </p:grpSpPr>
        <p:cxnSp>
          <p:nvCxnSpPr>
            <p:cNvPr id="130" name="Straight Connector 129">
              <a:extLst>
                <a:ext uri="{FF2B5EF4-FFF2-40B4-BE49-F238E27FC236}">
                  <a16:creationId xmlns:a16="http://schemas.microsoft.com/office/drawing/2014/main" id="{8DC66FCC-8BFD-402D-8F8B-8AE5B3962242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1" name="Straight Connector 130">
              <a:extLst>
                <a:ext uri="{FF2B5EF4-FFF2-40B4-BE49-F238E27FC236}">
                  <a16:creationId xmlns:a16="http://schemas.microsoft.com/office/drawing/2014/main" id="{6409AF8A-44FB-45DB-8F9B-4E06281EA91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2" name="Group 61">
            <a:extLst>
              <a:ext uri="{FF2B5EF4-FFF2-40B4-BE49-F238E27FC236}">
                <a16:creationId xmlns:a16="http://schemas.microsoft.com/office/drawing/2014/main" id="{3A74FECA-9134-43D1-B182-2B4D6DAA4719}"/>
              </a:ext>
            </a:extLst>
          </p:cNvPr>
          <p:cNvGrpSpPr/>
          <p:nvPr/>
        </p:nvGrpSpPr>
        <p:grpSpPr>
          <a:xfrm>
            <a:off x="8313930" y="3881454"/>
            <a:ext cx="164882" cy="274320"/>
            <a:chOff x="8894183" y="520304"/>
            <a:chExt cx="164882" cy="274320"/>
          </a:xfrm>
        </p:grpSpPr>
        <p:cxnSp>
          <p:nvCxnSpPr>
            <p:cNvPr id="128" name="Straight Connector 127">
              <a:extLst>
                <a:ext uri="{FF2B5EF4-FFF2-40B4-BE49-F238E27FC236}">
                  <a16:creationId xmlns:a16="http://schemas.microsoft.com/office/drawing/2014/main" id="{CF443C69-CC63-4B3E-BA56-3AA1370A6E12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9" name="Straight Connector 128">
              <a:extLst>
                <a:ext uri="{FF2B5EF4-FFF2-40B4-BE49-F238E27FC236}">
                  <a16:creationId xmlns:a16="http://schemas.microsoft.com/office/drawing/2014/main" id="{C75E9337-AB4A-4907-A9FE-682D78AAAC8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3" name="Group 62">
            <a:extLst>
              <a:ext uri="{FF2B5EF4-FFF2-40B4-BE49-F238E27FC236}">
                <a16:creationId xmlns:a16="http://schemas.microsoft.com/office/drawing/2014/main" id="{F62A8FFC-87AC-468A-8F29-6486C7AF7A59}"/>
              </a:ext>
            </a:extLst>
          </p:cNvPr>
          <p:cNvGrpSpPr/>
          <p:nvPr/>
        </p:nvGrpSpPr>
        <p:grpSpPr>
          <a:xfrm>
            <a:off x="8048602" y="3885152"/>
            <a:ext cx="164882" cy="274320"/>
            <a:chOff x="8894713" y="520304"/>
            <a:chExt cx="164882" cy="274320"/>
          </a:xfrm>
        </p:grpSpPr>
        <p:cxnSp>
          <p:nvCxnSpPr>
            <p:cNvPr id="126" name="Straight Connector 125">
              <a:extLst>
                <a:ext uri="{FF2B5EF4-FFF2-40B4-BE49-F238E27FC236}">
                  <a16:creationId xmlns:a16="http://schemas.microsoft.com/office/drawing/2014/main" id="{2C5BAE24-4FA7-4EF7-9531-7A4C5163A4FD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7" name="Straight Connector 126">
              <a:extLst>
                <a:ext uri="{FF2B5EF4-FFF2-40B4-BE49-F238E27FC236}">
                  <a16:creationId xmlns:a16="http://schemas.microsoft.com/office/drawing/2014/main" id="{27B97817-1646-4EA7-B5AB-FEEEDCD85C51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71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4" name="Group 63">
            <a:extLst>
              <a:ext uri="{FF2B5EF4-FFF2-40B4-BE49-F238E27FC236}">
                <a16:creationId xmlns:a16="http://schemas.microsoft.com/office/drawing/2014/main" id="{239110E2-157B-49C5-A364-7B96836D51AE}"/>
              </a:ext>
            </a:extLst>
          </p:cNvPr>
          <p:cNvGrpSpPr/>
          <p:nvPr/>
        </p:nvGrpSpPr>
        <p:grpSpPr>
          <a:xfrm>
            <a:off x="7788602" y="3885152"/>
            <a:ext cx="164882" cy="274320"/>
            <a:chOff x="8889950" y="520304"/>
            <a:chExt cx="164882" cy="274320"/>
          </a:xfrm>
        </p:grpSpPr>
        <p:cxnSp>
          <p:nvCxnSpPr>
            <p:cNvPr id="124" name="Straight Connector 123">
              <a:extLst>
                <a:ext uri="{FF2B5EF4-FFF2-40B4-BE49-F238E27FC236}">
                  <a16:creationId xmlns:a16="http://schemas.microsoft.com/office/drawing/2014/main" id="{EBAE4C75-7D05-479D-A0C3-770F9FAB40F4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5" name="Straight Connector 124">
              <a:extLst>
                <a:ext uri="{FF2B5EF4-FFF2-40B4-BE49-F238E27FC236}">
                  <a16:creationId xmlns:a16="http://schemas.microsoft.com/office/drawing/2014/main" id="{7D1B90CC-AAFC-4158-A049-2E0290EEB7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89950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5" name="Group 64">
            <a:extLst>
              <a:ext uri="{FF2B5EF4-FFF2-40B4-BE49-F238E27FC236}">
                <a16:creationId xmlns:a16="http://schemas.microsoft.com/office/drawing/2014/main" id="{7BC1115B-89F2-4CA7-871A-6A9AF392C541}"/>
              </a:ext>
            </a:extLst>
          </p:cNvPr>
          <p:cNvGrpSpPr/>
          <p:nvPr/>
        </p:nvGrpSpPr>
        <p:grpSpPr>
          <a:xfrm>
            <a:off x="7545914" y="3886217"/>
            <a:ext cx="164882" cy="274320"/>
            <a:chOff x="8894183" y="520304"/>
            <a:chExt cx="164882" cy="274320"/>
          </a:xfrm>
        </p:grpSpPr>
        <p:cxnSp>
          <p:nvCxnSpPr>
            <p:cNvPr id="122" name="Straight Connector 121">
              <a:extLst>
                <a:ext uri="{FF2B5EF4-FFF2-40B4-BE49-F238E27FC236}">
                  <a16:creationId xmlns:a16="http://schemas.microsoft.com/office/drawing/2014/main" id="{6AB095C6-DC91-457E-866D-88A603229957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3" name="Straight Connector 122">
              <a:extLst>
                <a:ext uri="{FF2B5EF4-FFF2-40B4-BE49-F238E27FC236}">
                  <a16:creationId xmlns:a16="http://schemas.microsoft.com/office/drawing/2014/main" id="{519F7DE0-BA8E-49A4-8FC0-A9E6EF8061A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6" name="Group 65">
            <a:extLst>
              <a:ext uri="{FF2B5EF4-FFF2-40B4-BE49-F238E27FC236}">
                <a16:creationId xmlns:a16="http://schemas.microsoft.com/office/drawing/2014/main" id="{0A72E067-DF8A-4E6B-8F98-68B3D41B5457}"/>
              </a:ext>
            </a:extLst>
          </p:cNvPr>
          <p:cNvGrpSpPr/>
          <p:nvPr/>
        </p:nvGrpSpPr>
        <p:grpSpPr>
          <a:xfrm>
            <a:off x="7288443" y="3886217"/>
            <a:ext cx="164882" cy="274320"/>
            <a:chOff x="8889950" y="520304"/>
            <a:chExt cx="164882" cy="274320"/>
          </a:xfrm>
        </p:grpSpPr>
        <p:cxnSp>
          <p:nvCxnSpPr>
            <p:cNvPr id="120" name="Straight Connector 119">
              <a:extLst>
                <a:ext uri="{FF2B5EF4-FFF2-40B4-BE49-F238E27FC236}">
                  <a16:creationId xmlns:a16="http://schemas.microsoft.com/office/drawing/2014/main" id="{7A2EB6F9-9854-421B-81EB-7A80EAD8004F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1" name="Straight Connector 120">
              <a:extLst>
                <a:ext uri="{FF2B5EF4-FFF2-40B4-BE49-F238E27FC236}">
                  <a16:creationId xmlns:a16="http://schemas.microsoft.com/office/drawing/2014/main" id="{6EF3CBFD-51F6-49AF-901E-3D618BE8D53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89950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7" name="Group 66">
            <a:extLst>
              <a:ext uri="{FF2B5EF4-FFF2-40B4-BE49-F238E27FC236}">
                <a16:creationId xmlns:a16="http://schemas.microsoft.com/office/drawing/2014/main" id="{187032AD-C2D0-41CE-984D-FF3F71765E0D}"/>
              </a:ext>
            </a:extLst>
          </p:cNvPr>
          <p:cNvGrpSpPr/>
          <p:nvPr/>
        </p:nvGrpSpPr>
        <p:grpSpPr>
          <a:xfrm>
            <a:off x="7024945" y="3886217"/>
            <a:ext cx="164882" cy="274320"/>
            <a:chOff x="8893961" y="520304"/>
            <a:chExt cx="164882" cy="274320"/>
          </a:xfrm>
        </p:grpSpPr>
        <p:cxnSp>
          <p:nvCxnSpPr>
            <p:cNvPr id="118" name="Straight Connector 117">
              <a:extLst>
                <a:ext uri="{FF2B5EF4-FFF2-40B4-BE49-F238E27FC236}">
                  <a16:creationId xmlns:a16="http://schemas.microsoft.com/office/drawing/2014/main" id="{1BB78CB8-9B66-414F-A260-B7CB35244C7A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9" name="Straight Connector 118">
              <a:extLst>
                <a:ext uri="{FF2B5EF4-FFF2-40B4-BE49-F238E27FC236}">
                  <a16:creationId xmlns:a16="http://schemas.microsoft.com/office/drawing/2014/main" id="{5C43558F-3C4C-4786-A758-98FAFB1CFF8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3961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8" name="Group 67">
            <a:extLst>
              <a:ext uri="{FF2B5EF4-FFF2-40B4-BE49-F238E27FC236}">
                <a16:creationId xmlns:a16="http://schemas.microsoft.com/office/drawing/2014/main" id="{5A31E1EF-DEC3-42A3-BC7B-D10D6D701C18}"/>
              </a:ext>
            </a:extLst>
          </p:cNvPr>
          <p:cNvGrpSpPr/>
          <p:nvPr/>
        </p:nvGrpSpPr>
        <p:grpSpPr>
          <a:xfrm>
            <a:off x="6758174" y="3892772"/>
            <a:ext cx="164882" cy="274320"/>
            <a:chOff x="8894183" y="520304"/>
            <a:chExt cx="164882" cy="274320"/>
          </a:xfrm>
        </p:grpSpPr>
        <p:cxnSp>
          <p:nvCxnSpPr>
            <p:cNvPr id="116" name="Straight Connector 115">
              <a:extLst>
                <a:ext uri="{FF2B5EF4-FFF2-40B4-BE49-F238E27FC236}">
                  <a16:creationId xmlns:a16="http://schemas.microsoft.com/office/drawing/2014/main" id="{A1681FA3-0719-4FE1-8D60-9B562F13E8C6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Straight Connector 116">
              <a:extLst>
                <a:ext uri="{FF2B5EF4-FFF2-40B4-BE49-F238E27FC236}">
                  <a16:creationId xmlns:a16="http://schemas.microsoft.com/office/drawing/2014/main" id="{59E73DFB-A347-4AE3-BDD0-A0FAA73E08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8A645C2B-D025-4A6B-A425-512ABCC94AA8}"/>
              </a:ext>
            </a:extLst>
          </p:cNvPr>
          <p:cNvGrpSpPr/>
          <p:nvPr/>
        </p:nvGrpSpPr>
        <p:grpSpPr>
          <a:xfrm>
            <a:off x="6478262" y="3892772"/>
            <a:ext cx="164882" cy="274320"/>
            <a:chOff x="8894183" y="520304"/>
            <a:chExt cx="164882" cy="274320"/>
          </a:xfrm>
        </p:grpSpPr>
        <p:cxnSp>
          <p:nvCxnSpPr>
            <p:cNvPr id="114" name="Straight Connector 113">
              <a:extLst>
                <a:ext uri="{FF2B5EF4-FFF2-40B4-BE49-F238E27FC236}">
                  <a16:creationId xmlns:a16="http://schemas.microsoft.com/office/drawing/2014/main" id="{3056FFDA-65A5-4636-A315-13C50110C27E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5" name="Straight Connector 114">
              <a:extLst>
                <a:ext uri="{FF2B5EF4-FFF2-40B4-BE49-F238E27FC236}">
                  <a16:creationId xmlns:a16="http://schemas.microsoft.com/office/drawing/2014/main" id="{8F355472-B2D8-4936-AB06-7476A3068F0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0" name="Group 69">
            <a:extLst>
              <a:ext uri="{FF2B5EF4-FFF2-40B4-BE49-F238E27FC236}">
                <a16:creationId xmlns:a16="http://schemas.microsoft.com/office/drawing/2014/main" id="{D2DF2AD5-1BE8-45FD-943E-1B4CA6166AE2}"/>
              </a:ext>
            </a:extLst>
          </p:cNvPr>
          <p:cNvGrpSpPr/>
          <p:nvPr/>
        </p:nvGrpSpPr>
        <p:grpSpPr>
          <a:xfrm>
            <a:off x="6213171" y="3897535"/>
            <a:ext cx="164882" cy="274320"/>
            <a:chOff x="8894183" y="520304"/>
            <a:chExt cx="164882" cy="274320"/>
          </a:xfrm>
        </p:grpSpPr>
        <p:cxnSp>
          <p:nvCxnSpPr>
            <p:cNvPr id="112" name="Straight Connector 111">
              <a:extLst>
                <a:ext uri="{FF2B5EF4-FFF2-40B4-BE49-F238E27FC236}">
                  <a16:creationId xmlns:a16="http://schemas.microsoft.com/office/drawing/2014/main" id="{BAF64009-CBB6-4604-A157-AC1E2E9DE02E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3" name="Straight Connector 112">
              <a:extLst>
                <a:ext uri="{FF2B5EF4-FFF2-40B4-BE49-F238E27FC236}">
                  <a16:creationId xmlns:a16="http://schemas.microsoft.com/office/drawing/2014/main" id="{4FD72B63-2F8B-4475-B87D-BFE729B13C1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1" name="Group 70">
            <a:extLst>
              <a:ext uri="{FF2B5EF4-FFF2-40B4-BE49-F238E27FC236}">
                <a16:creationId xmlns:a16="http://schemas.microsoft.com/office/drawing/2014/main" id="{C7DB39CE-4441-4D32-A84B-E3921D486801}"/>
              </a:ext>
            </a:extLst>
          </p:cNvPr>
          <p:cNvGrpSpPr/>
          <p:nvPr/>
        </p:nvGrpSpPr>
        <p:grpSpPr>
          <a:xfrm rot="10800000">
            <a:off x="4514440" y="3887174"/>
            <a:ext cx="164882" cy="274320"/>
            <a:chOff x="8894183" y="520304"/>
            <a:chExt cx="164882" cy="274320"/>
          </a:xfrm>
        </p:grpSpPr>
        <p:cxnSp>
          <p:nvCxnSpPr>
            <p:cNvPr id="110" name="Straight Connector 109">
              <a:extLst>
                <a:ext uri="{FF2B5EF4-FFF2-40B4-BE49-F238E27FC236}">
                  <a16:creationId xmlns:a16="http://schemas.microsoft.com/office/drawing/2014/main" id="{374F5FD4-089E-4A31-B18F-4D018373EFCE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1" name="Straight Connector 110">
              <a:extLst>
                <a:ext uri="{FF2B5EF4-FFF2-40B4-BE49-F238E27FC236}">
                  <a16:creationId xmlns:a16="http://schemas.microsoft.com/office/drawing/2014/main" id="{29C762D2-F9DB-4EA6-B64B-7DD8070162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76" name="TextBox 75">
            <a:extLst>
              <a:ext uri="{FF2B5EF4-FFF2-40B4-BE49-F238E27FC236}">
                <a16:creationId xmlns:a16="http://schemas.microsoft.com/office/drawing/2014/main" id="{0E8D960C-BED7-4CB3-8330-8DEF1C90A831}"/>
              </a:ext>
            </a:extLst>
          </p:cNvPr>
          <p:cNvSpPr txBox="1"/>
          <p:nvPr/>
        </p:nvSpPr>
        <p:spPr>
          <a:xfrm>
            <a:off x="6650693" y="3593642"/>
            <a:ext cx="32239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2 </a:t>
            </a:r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1</a:t>
            </a:r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0   y9   </a:t>
            </a:r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8 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7   </a:t>
            </a:r>
            <a:r>
              <a:rPr lang="en-US" sz="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6</a:t>
            </a:r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5   </a:t>
            </a:r>
            <a:r>
              <a: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4  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3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2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E35D9D5-94C0-4448-9915-DE9E183E427D}"/>
              </a:ext>
            </a:extLst>
          </p:cNvPr>
          <p:cNvSpPr txBox="1"/>
          <p:nvPr/>
        </p:nvSpPr>
        <p:spPr>
          <a:xfrm>
            <a:off x="4172525" y="4158801"/>
            <a:ext cx="185980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2 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3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4   b5   b6  </a:t>
            </a:r>
            <a:r>
              <a:rPr lang="en-US" sz="1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7   b8</a:t>
            </a:r>
          </a:p>
        </p:txBody>
      </p:sp>
      <p:grpSp>
        <p:nvGrpSpPr>
          <p:cNvPr id="78" name="Group 77">
            <a:extLst>
              <a:ext uri="{FF2B5EF4-FFF2-40B4-BE49-F238E27FC236}">
                <a16:creationId xmlns:a16="http://schemas.microsoft.com/office/drawing/2014/main" id="{326D1D0B-6348-484F-9D1E-6953A7B50972}"/>
              </a:ext>
            </a:extLst>
          </p:cNvPr>
          <p:cNvGrpSpPr/>
          <p:nvPr/>
        </p:nvGrpSpPr>
        <p:grpSpPr>
          <a:xfrm>
            <a:off x="5956206" y="3897535"/>
            <a:ext cx="164882" cy="274320"/>
            <a:chOff x="8894183" y="520304"/>
            <a:chExt cx="164882" cy="274320"/>
          </a:xfrm>
        </p:grpSpPr>
        <p:cxnSp>
          <p:nvCxnSpPr>
            <p:cNvPr id="100" name="Straight Connector 99">
              <a:extLst>
                <a:ext uri="{FF2B5EF4-FFF2-40B4-BE49-F238E27FC236}">
                  <a16:creationId xmlns:a16="http://schemas.microsoft.com/office/drawing/2014/main" id="{02126C4E-4B9A-40FD-8004-3C65215EB54D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01" name="Straight Connector 100">
              <a:extLst>
                <a:ext uri="{FF2B5EF4-FFF2-40B4-BE49-F238E27FC236}">
                  <a16:creationId xmlns:a16="http://schemas.microsoft.com/office/drawing/2014/main" id="{C37C268B-A4B7-438D-AFA5-57A09E236B1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79" name="Group 78">
            <a:extLst>
              <a:ext uri="{FF2B5EF4-FFF2-40B4-BE49-F238E27FC236}">
                <a16:creationId xmlns:a16="http://schemas.microsoft.com/office/drawing/2014/main" id="{47271C18-15C6-40D3-A4F4-D5C485B58001}"/>
              </a:ext>
            </a:extLst>
          </p:cNvPr>
          <p:cNvGrpSpPr/>
          <p:nvPr/>
        </p:nvGrpSpPr>
        <p:grpSpPr>
          <a:xfrm>
            <a:off x="5694037" y="3897535"/>
            <a:ext cx="164882" cy="274320"/>
            <a:chOff x="8894183" y="520304"/>
            <a:chExt cx="164882" cy="274320"/>
          </a:xfrm>
        </p:grpSpPr>
        <p:cxnSp>
          <p:nvCxnSpPr>
            <p:cNvPr id="98" name="Straight Connector 97">
              <a:extLst>
                <a:ext uri="{FF2B5EF4-FFF2-40B4-BE49-F238E27FC236}">
                  <a16:creationId xmlns:a16="http://schemas.microsoft.com/office/drawing/2014/main" id="{930B1E20-CD2A-4547-B4B9-7633B75EC8FD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9" name="Straight Connector 98">
              <a:extLst>
                <a:ext uri="{FF2B5EF4-FFF2-40B4-BE49-F238E27FC236}">
                  <a16:creationId xmlns:a16="http://schemas.microsoft.com/office/drawing/2014/main" id="{D03CDD9C-AD9C-4C4B-B681-156CA596C78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0" name="Group 79">
            <a:extLst>
              <a:ext uri="{FF2B5EF4-FFF2-40B4-BE49-F238E27FC236}">
                <a16:creationId xmlns:a16="http://schemas.microsoft.com/office/drawing/2014/main" id="{D1A16079-6D41-44A5-9459-3A824602F64D}"/>
              </a:ext>
            </a:extLst>
          </p:cNvPr>
          <p:cNvGrpSpPr/>
          <p:nvPr/>
        </p:nvGrpSpPr>
        <p:grpSpPr>
          <a:xfrm>
            <a:off x="5452708" y="3895212"/>
            <a:ext cx="164882" cy="274320"/>
            <a:chOff x="8894183" y="520304"/>
            <a:chExt cx="164882" cy="274320"/>
          </a:xfrm>
        </p:grpSpPr>
        <p:cxnSp>
          <p:nvCxnSpPr>
            <p:cNvPr id="96" name="Straight Connector 95">
              <a:extLst>
                <a:ext uri="{FF2B5EF4-FFF2-40B4-BE49-F238E27FC236}">
                  <a16:creationId xmlns:a16="http://schemas.microsoft.com/office/drawing/2014/main" id="{2CE50D29-AEBF-4239-81AE-9134D51099F6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7" name="Straight Connector 96">
              <a:extLst>
                <a:ext uri="{FF2B5EF4-FFF2-40B4-BE49-F238E27FC236}">
                  <a16:creationId xmlns:a16="http://schemas.microsoft.com/office/drawing/2014/main" id="{661F915F-5126-47A1-BA11-7E5748E9CF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73F8B7D0-E6AA-4589-AE69-F2DD27720CA2}"/>
              </a:ext>
            </a:extLst>
          </p:cNvPr>
          <p:cNvGrpSpPr/>
          <p:nvPr/>
        </p:nvGrpSpPr>
        <p:grpSpPr>
          <a:xfrm>
            <a:off x="5194752" y="3902467"/>
            <a:ext cx="164882" cy="274320"/>
            <a:chOff x="8894183" y="520304"/>
            <a:chExt cx="164882" cy="274320"/>
          </a:xfrm>
        </p:grpSpPr>
        <p:cxnSp>
          <p:nvCxnSpPr>
            <p:cNvPr id="94" name="Straight Connector 93">
              <a:extLst>
                <a:ext uri="{FF2B5EF4-FFF2-40B4-BE49-F238E27FC236}">
                  <a16:creationId xmlns:a16="http://schemas.microsoft.com/office/drawing/2014/main" id="{688C4563-86F2-4AF4-AD87-F3BB86703763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95" name="Straight Connector 94">
              <a:extLst>
                <a:ext uri="{FF2B5EF4-FFF2-40B4-BE49-F238E27FC236}">
                  <a16:creationId xmlns:a16="http://schemas.microsoft.com/office/drawing/2014/main" id="{F242DE10-59DD-4586-924B-946B7D6FB76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82" name="TextBox 81">
            <a:extLst>
              <a:ext uri="{FF2B5EF4-FFF2-40B4-BE49-F238E27FC236}">
                <a16:creationId xmlns:a16="http://schemas.microsoft.com/office/drawing/2014/main" id="{89269016-9EF8-4E7A-A412-62C02C9241C6}"/>
              </a:ext>
            </a:extLst>
          </p:cNvPr>
          <p:cNvSpPr txBox="1"/>
          <p:nvPr/>
        </p:nvSpPr>
        <p:spPr>
          <a:xfrm>
            <a:off x="5638950" y="3590301"/>
            <a:ext cx="11624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6 y15 </a:t>
            </a:r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4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3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71E2D63B-A994-4FDF-9EFD-BDFD46BB3136}"/>
              </a:ext>
            </a:extLst>
          </p:cNvPr>
          <p:cNvSpPr txBox="1"/>
          <p:nvPr/>
        </p:nvSpPr>
        <p:spPr>
          <a:xfrm>
            <a:off x="6155768" y="4127410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0</a:t>
            </a:r>
          </a:p>
        </p:txBody>
      </p:sp>
      <p:cxnSp>
        <p:nvCxnSpPr>
          <p:cNvPr id="87" name="Straight Connector 86">
            <a:extLst>
              <a:ext uri="{FF2B5EF4-FFF2-40B4-BE49-F238E27FC236}">
                <a16:creationId xmlns:a16="http://schemas.microsoft.com/office/drawing/2014/main" id="{8C9F45BE-D26F-456D-8ECF-4FC0216839CD}"/>
              </a:ext>
            </a:extLst>
          </p:cNvPr>
          <p:cNvCxnSpPr>
            <a:cxnSpLocks/>
          </p:cNvCxnSpPr>
          <p:nvPr/>
        </p:nvCxnSpPr>
        <p:spPr>
          <a:xfrm>
            <a:off x="4298067" y="3795882"/>
            <a:ext cx="0" cy="114266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4" name="TextBox 133">
            <a:extLst>
              <a:ext uri="{FF2B5EF4-FFF2-40B4-BE49-F238E27FC236}">
                <a16:creationId xmlns:a16="http://schemas.microsoft.com/office/drawing/2014/main" id="{B13D5432-BC94-445E-A095-F1867D6D53C5}"/>
              </a:ext>
            </a:extLst>
          </p:cNvPr>
          <p:cNvSpPr txBox="1"/>
          <p:nvPr/>
        </p:nvSpPr>
        <p:spPr>
          <a:xfrm>
            <a:off x="4869935" y="3643647"/>
            <a:ext cx="65915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9 </a:t>
            </a:r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y18</a:t>
            </a:r>
          </a:p>
        </p:txBody>
      </p: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122708B5-6116-4413-81FB-4FD3524B9250}"/>
              </a:ext>
            </a:extLst>
          </p:cNvPr>
          <p:cNvGrpSpPr/>
          <p:nvPr/>
        </p:nvGrpSpPr>
        <p:grpSpPr>
          <a:xfrm>
            <a:off x="8850451" y="3881312"/>
            <a:ext cx="164882" cy="274320"/>
            <a:chOff x="8894183" y="520304"/>
            <a:chExt cx="164882" cy="274320"/>
          </a:xfrm>
        </p:grpSpPr>
        <p:cxnSp>
          <p:nvCxnSpPr>
            <p:cNvPr id="136" name="Straight Connector 135">
              <a:extLst>
                <a:ext uri="{FF2B5EF4-FFF2-40B4-BE49-F238E27FC236}">
                  <a16:creationId xmlns:a16="http://schemas.microsoft.com/office/drawing/2014/main" id="{EAA1178B-94E6-4F02-9979-22CB81C46294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7" name="Straight Connector 136">
              <a:extLst>
                <a:ext uri="{FF2B5EF4-FFF2-40B4-BE49-F238E27FC236}">
                  <a16:creationId xmlns:a16="http://schemas.microsoft.com/office/drawing/2014/main" id="{C9848C20-6213-4044-8C03-CBE7AAD6B22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38" name="Group 137">
            <a:extLst>
              <a:ext uri="{FF2B5EF4-FFF2-40B4-BE49-F238E27FC236}">
                <a16:creationId xmlns:a16="http://schemas.microsoft.com/office/drawing/2014/main" id="{72BA6BF7-F733-430D-A7F1-937B18FCC8BA}"/>
              </a:ext>
            </a:extLst>
          </p:cNvPr>
          <p:cNvGrpSpPr/>
          <p:nvPr/>
        </p:nvGrpSpPr>
        <p:grpSpPr>
          <a:xfrm>
            <a:off x="8583114" y="3881312"/>
            <a:ext cx="164882" cy="274320"/>
            <a:chOff x="8894183" y="520304"/>
            <a:chExt cx="164882" cy="274320"/>
          </a:xfrm>
        </p:grpSpPr>
        <p:cxnSp>
          <p:nvCxnSpPr>
            <p:cNvPr id="139" name="Straight Connector 138">
              <a:extLst>
                <a:ext uri="{FF2B5EF4-FFF2-40B4-BE49-F238E27FC236}">
                  <a16:creationId xmlns:a16="http://schemas.microsoft.com/office/drawing/2014/main" id="{379A50F0-475D-4CE9-BD33-71EB4A375B51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0" name="Straight Connector 139">
              <a:extLst>
                <a:ext uri="{FF2B5EF4-FFF2-40B4-BE49-F238E27FC236}">
                  <a16:creationId xmlns:a16="http://schemas.microsoft.com/office/drawing/2014/main" id="{2C6C036A-4C3E-4E56-80D1-E817524A506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41" name="TextBox 140">
            <a:extLst>
              <a:ext uri="{FF2B5EF4-FFF2-40B4-BE49-F238E27FC236}">
                <a16:creationId xmlns:a16="http://schemas.microsoft.com/office/drawing/2014/main" id="{4D585AB9-7B65-46E4-8C9C-A09E29EEFC47}"/>
              </a:ext>
            </a:extLst>
          </p:cNvPr>
          <p:cNvSpPr txBox="1"/>
          <p:nvPr/>
        </p:nvSpPr>
        <p:spPr>
          <a:xfrm>
            <a:off x="1064995" y="3145657"/>
            <a:ext cx="12057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rgbClr val="00B0F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xonium Ion</a:t>
            </a:r>
          </a:p>
        </p:txBody>
      </p:sp>
      <p:sp>
        <p:nvSpPr>
          <p:cNvPr id="142" name="TextBox 141">
            <a:extLst>
              <a:ext uri="{FF2B5EF4-FFF2-40B4-BE49-F238E27FC236}">
                <a16:creationId xmlns:a16="http://schemas.microsoft.com/office/drawing/2014/main" id="{304BE799-D452-438E-B87C-61F0CF5D4DA3}"/>
              </a:ext>
            </a:extLst>
          </p:cNvPr>
          <p:cNvSpPr txBox="1"/>
          <p:nvPr/>
        </p:nvSpPr>
        <p:spPr>
          <a:xfrm>
            <a:off x="4734619" y="2497222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</a:t>
            </a:r>
          </a:p>
        </p:txBody>
      </p:sp>
      <p:sp>
        <p:nvSpPr>
          <p:cNvPr id="143" name="TextBox 142">
            <a:extLst>
              <a:ext uri="{FF2B5EF4-FFF2-40B4-BE49-F238E27FC236}">
                <a16:creationId xmlns:a16="http://schemas.microsoft.com/office/drawing/2014/main" id="{0F812162-BC25-468F-B68F-3341CEBD43E4}"/>
              </a:ext>
            </a:extLst>
          </p:cNvPr>
          <p:cNvSpPr txBox="1"/>
          <p:nvPr/>
        </p:nvSpPr>
        <p:spPr>
          <a:xfrm>
            <a:off x="5861384" y="2548625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5</a:t>
            </a:r>
          </a:p>
        </p:txBody>
      </p:sp>
      <p:cxnSp>
        <p:nvCxnSpPr>
          <p:cNvPr id="144" name="Straight Connector 143">
            <a:extLst>
              <a:ext uri="{FF2B5EF4-FFF2-40B4-BE49-F238E27FC236}">
                <a16:creationId xmlns:a16="http://schemas.microsoft.com/office/drawing/2014/main" id="{93C16388-1A59-43F0-8B8D-E15A2C70838E}"/>
              </a:ext>
            </a:extLst>
          </p:cNvPr>
          <p:cNvCxnSpPr>
            <a:cxnSpLocks/>
          </p:cNvCxnSpPr>
          <p:nvPr/>
        </p:nvCxnSpPr>
        <p:spPr>
          <a:xfrm flipH="1">
            <a:off x="7489148" y="2381709"/>
            <a:ext cx="123967" cy="54784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TextBox 144">
            <a:extLst>
              <a:ext uri="{FF2B5EF4-FFF2-40B4-BE49-F238E27FC236}">
                <a16:creationId xmlns:a16="http://schemas.microsoft.com/office/drawing/2014/main" id="{12AB9659-9284-41B9-B044-35DB31234D47}"/>
              </a:ext>
            </a:extLst>
          </p:cNvPr>
          <p:cNvSpPr txBox="1"/>
          <p:nvPr/>
        </p:nvSpPr>
        <p:spPr>
          <a:xfrm>
            <a:off x="7464079" y="2163040"/>
            <a:ext cx="31771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9</a:t>
            </a:r>
          </a:p>
        </p:txBody>
      </p:sp>
      <p:cxnSp>
        <p:nvCxnSpPr>
          <p:cNvPr id="146" name="Straight Connector 145">
            <a:extLst>
              <a:ext uri="{FF2B5EF4-FFF2-40B4-BE49-F238E27FC236}">
                <a16:creationId xmlns:a16="http://schemas.microsoft.com/office/drawing/2014/main" id="{D52AC403-38C0-46D5-973E-6E8019805B40}"/>
              </a:ext>
            </a:extLst>
          </p:cNvPr>
          <p:cNvCxnSpPr>
            <a:cxnSpLocks/>
          </p:cNvCxnSpPr>
          <p:nvPr/>
        </p:nvCxnSpPr>
        <p:spPr>
          <a:xfrm>
            <a:off x="2510941" y="2460150"/>
            <a:ext cx="75946" cy="49259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6">
            <a:extLst>
              <a:ext uri="{FF2B5EF4-FFF2-40B4-BE49-F238E27FC236}">
                <a16:creationId xmlns:a16="http://schemas.microsoft.com/office/drawing/2014/main" id="{237B9B9C-CCDE-4BD7-AA7D-FC3A5D10CD4F}"/>
              </a:ext>
            </a:extLst>
          </p:cNvPr>
          <p:cNvSpPr txBox="1"/>
          <p:nvPr/>
        </p:nvSpPr>
        <p:spPr>
          <a:xfrm>
            <a:off x="2342158" y="2250904"/>
            <a:ext cx="3177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6</a:t>
            </a:r>
          </a:p>
        </p:txBody>
      </p:sp>
      <p:cxnSp>
        <p:nvCxnSpPr>
          <p:cNvPr id="148" name="Straight Connector 147">
            <a:extLst>
              <a:ext uri="{FF2B5EF4-FFF2-40B4-BE49-F238E27FC236}">
                <a16:creationId xmlns:a16="http://schemas.microsoft.com/office/drawing/2014/main" id="{88334DC3-E8D2-446A-8FDA-CE611CDB2D78}"/>
              </a:ext>
            </a:extLst>
          </p:cNvPr>
          <p:cNvCxnSpPr>
            <a:cxnSpLocks/>
          </p:cNvCxnSpPr>
          <p:nvPr/>
        </p:nvCxnSpPr>
        <p:spPr>
          <a:xfrm>
            <a:off x="2819856" y="2424650"/>
            <a:ext cx="26728" cy="50306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TextBox 149">
            <a:extLst>
              <a:ext uri="{FF2B5EF4-FFF2-40B4-BE49-F238E27FC236}">
                <a16:creationId xmlns:a16="http://schemas.microsoft.com/office/drawing/2014/main" id="{43F79247-E071-43E7-8D4C-F44EEA69EBE7}"/>
              </a:ext>
            </a:extLst>
          </p:cNvPr>
          <p:cNvSpPr txBox="1"/>
          <p:nvPr/>
        </p:nvSpPr>
        <p:spPr>
          <a:xfrm>
            <a:off x="2678825" y="2197867"/>
            <a:ext cx="3177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7</a:t>
            </a:r>
          </a:p>
        </p:txBody>
      </p:sp>
      <p:cxnSp>
        <p:nvCxnSpPr>
          <p:cNvPr id="151" name="Straight Connector 150">
            <a:extLst>
              <a:ext uri="{FF2B5EF4-FFF2-40B4-BE49-F238E27FC236}">
                <a16:creationId xmlns:a16="http://schemas.microsoft.com/office/drawing/2014/main" id="{864EAE15-6ED3-4443-991A-532BE9CC361A}"/>
              </a:ext>
            </a:extLst>
          </p:cNvPr>
          <p:cNvCxnSpPr>
            <a:cxnSpLocks/>
          </p:cNvCxnSpPr>
          <p:nvPr/>
        </p:nvCxnSpPr>
        <p:spPr>
          <a:xfrm>
            <a:off x="3301534" y="2512514"/>
            <a:ext cx="81032" cy="4075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id="{025CCD4F-0189-4833-AB81-4AF6E9B3832D}"/>
              </a:ext>
            </a:extLst>
          </p:cNvPr>
          <p:cNvSpPr txBox="1"/>
          <p:nvPr/>
        </p:nvSpPr>
        <p:spPr>
          <a:xfrm>
            <a:off x="3144260" y="2287015"/>
            <a:ext cx="31771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9</a:t>
            </a:r>
          </a:p>
        </p:txBody>
      </p:sp>
      <p:cxnSp>
        <p:nvCxnSpPr>
          <p:cNvPr id="154" name="Straight Connector 153">
            <a:extLst>
              <a:ext uri="{FF2B5EF4-FFF2-40B4-BE49-F238E27FC236}">
                <a16:creationId xmlns:a16="http://schemas.microsoft.com/office/drawing/2014/main" id="{E5695020-83B5-43D0-AE40-AC88DD0EA48F}"/>
              </a:ext>
            </a:extLst>
          </p:cNvPr>
          <p:cNvCxnSpPr>
            <a:cxnSpLocks/>
          </p:cNvCxnSpPr>
          <p:nvPr/>
        </p:nvCxnSpPr>
        <p:spPr>
          <a:xfrm flipH="1">
            <a:off x="6159787" y="2548625"/>
            <a:ext cx="48401" cy="391778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6" name="TextBox 155">
            <a:extLst>
              <a:ext uri="{FF2B5EF4-FFF2-40B4-BE49-F238E27FC236}">
                <a16:creationId xmlns:a16="http://schemas.microsoft.com/office/drawing/2014/main" id="{15D84B92-B966-482D-817D-07ABA3274B8B}"/>
              </a:ext>
            </a:extLst>
          </p:cNvPr>
          <p:cNvSpPr txBox="1"/>
          <p:nvPr/>
        </p:nvSpPr>
        <p:spPr>
          <a:xfrm>
            <a:off x="6032330" y="2328672"/>
            <a:ext cx="40097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14</a:t>
            </a:r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2220A255-6E79-429F-AFBA-0E3B2A5C31E5}"/>
              </a:ext>
            </a:extLst>
          </p:cNvPr>
          <p:cNvSpPr txBox="1"/>
          <p:nvPr/>
        </p:nvSpPr>
        <p:spPr>
          <a:xfrm>
            <a:off x="3612851" y="352676"/>
            <a:ext cx="86395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5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lcNAc</a:t>
            </a:r>
            <a:endParaRPr lang="en-US" sz="15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9" name="Rectangle 158">
            <a:extLst>
              <a:ext uri="{FF2B5EF4-FFF2-40B4-BE49-F238E27FC236}">
                <a16:creationId xmlns:a16="http://schemas.microsoft.com/office/drawing/2014/main" id="{251351DE-91BF-4427-BBE8-0067AF8890E1}"/>
              </a:ext>
            </a:extLst>
          </p:cNvPr>
          <p:cNvSpPr/>
          <p:nvPr/>
        </p:nvSpPr>
        <p:spPr>
          <a:xfrm>
            <a:off x="3872868" y="684844"/>
            <a:ext cx="5973174" cy="3231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   </a:t>
            </a:r>
            <a:r>
              <a:rPr lang="en-US" sz="15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A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T   F   S   E   Q   V  G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S  G  </a:t>
            </a:r>
            <a:r>
              <a:rPr lang="en-US" sz="15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sz="15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A  G  R</a:t>
            </a:r>
          </a:p>
        </p:txBody>
      </p:sp>
      <p:grpSp>
        <p:nvGrpSpPr>
          <p:cNvPr id="166" name="Group 165">
            <a:extLst>
              <a:ext uri="{FF2B5EF4-FFF2-40B4-BE49-F238E27FC236}">
                <a16:creationId xmlns:a16="http://schemas.microsoft.com/office/drawing/2014/main" id="{123AD277-89BD-49BD-92C3-DAEE409EA1FF}"/>
              </a:ext>
            </a:extLst>
          </p:cNvPr>
          <p:cNvGrpSpPr/>
          <p:nvPr/>
        </p:nvGrpSpPr>
        <p:grpSpPr>
          <a:xfrm>
            <a:off x="8336790" y="713003"/>
            <a:ext cx="164882" cy="274320"/>
            <a:chOff x="8894183" y="520304"/>
            <a:chExt cx="164882" cy="274320"/>
          </a:xfrm>
        </p:grpSpPr>
        <p:cxnSp>
          <p:nvCxnSpPr>
            <p:cNvPr id="167" name="Straight Connector 166">
              <a:extLst>
                <a:ext uri="{FF2B5EF4-FFF2-40B4-BE49-F238E27FC236}">
                  <a16:creationId xmlns:a16="http://schemas.microsoft.com/office/drawing/2014/main" id="{57FC593D-C36D-4C5F-8784-486C3E1C5263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8" name="Straight Connector 167">
              <a:extLst>
                <a:ext uri="{FF2B5EF4-FFF2-40B4-BE49-F238E27FC236}">
                  <a16:creationId xmlns:a16="http://schemas.microsoft.com/office/drawing/2014/main" id="{DE4ED9CF-7FE8-45CC-BF1E-F266ABC7B12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69" name="Group 168">
            <a:extLst>
              <a:ext uri="{FF2B5EF4-FFF2-40B4-BE49-F238E27FC236}">
                <a16:creationId xmlns:a16="http://schemas.microsoft.com/office/drawing/2014/main" id="{320E3BE0-DA65-4178-99CA-B6D9FE46C348}"/>
              </a:ext>
            </a:extLst>
          </p:cNvPr>
          <p:cNvGrpSpPr/>
          <p:nvPr/>
        </p:nvGrpSpPr>
        <p:grpSpPr>
          <a:xfrm>
            <a:off x="8048602" y="716701"/>
            <a:ext cx="164882" cy="274320"/>
            <a:chOff x="8894713" y="520304"/>
            <a:chExt cx="164882" cy="274320"/>
          </a:xfrm>
        </p:grpSpPr>
        <p:cxnSp>
          <p:nvCxnSpPr>
            <p:cNvPr id="170" name="Straight Connector 169">
              <a:extLst>
                <a:ext uri="{FF2B5EF4-FFF2-40B4-BE49-F238E27FC236}">
                  <a16:creationId xmlns:a16="http://schemas.microsoft.com/office/drawing/2014/main" id="{01A33C59-954D-46C8-A678-33F15C376909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1" name="Straight Connector 170">
              <a:extLst>
                <a:ext uri="{FF2B5EF4-FFF2-40B4-BE49-F238E27FC236}">
                  <a16:creationId xmlns:a16="http://schemas.microsoft.com/office/drawing/2014/main" id="{1A433354-0021-4F84-82F7-C7C0CAA9FF1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71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75" name="Group 174">
            <a:extLst>
              <a:ext uri="{FF2B5EF4-FFF2-40B4-BE49-F238E27FC236}">
                <a16:creationId xmlns:a16="http://schemas.microsoft.com/office/drawing/2014/main" id="{80FD4AB8-868B-4BBC-A502-A2C2A1D2E227}"/>
              </a:ext>
            </a:extLst>
          </p:cNvPr>
          <p:cNvGrpSpPr/>
          <p:nvPr/>
        </p:nvGrpSpPr>
        <p:grpSpPr>
          <a:xfrm>
            <a:off x="7523054" y="717766"/>
            <a:ext cx="164882" cy="274320"/>
            <a:chOff x="8894183" y="520304"/>
            <a:chExt cx="164882" cy="274320"/>
          </a:xfrm>
        </p:grpSpPr>
        <p:cxnSp>
          <p:nvCxnSpPr>
            <p:cNvPr id="176" name="Straight Connector 175">
              <a:extLst>
                <a:ext uri="{FF2B5EF4-FFF2-40B4-BE49-F238E27FC236}">
                  <a16:creationId xmlns:a16="http://schemas.microsoft.com/office/drawing/2014/main" id="{C01DDC6A-1321-430B-A3CB-1018FEB4CDE3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7" name="Straight Connector 176">
              <a:extLst>
                <a:ext uri="{FF2B5EF4-FFF2-40B4-BE49-F238E27FC236}">
                  <a16:creationId xmlns:a16="http://schemas.microsoft.com/office/drawing/2014/main" id="{BD2D7C6B-60D7-4EF6-916F-8FCFACE6EC2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0" name="Group 189">
            <a:extLst>
              <a:ext uri="{FF2B5EF4-FFF2-40B4-BE49-F238E27FC236}">
                <a16:creationId xmlns:a16="http://schemas.microsoft.com/office/drawing/2014/main" id="{335E92EC-97F6-44D4-9649-66DA572C41ED}"/>
              </a:ext>
            </a:extLst>
          </p:cNvPr>
          <p:cNvGrpSpPr/>
          <p:nvPr/>
        </p:nvGrpSpPr>
        <p:grpSpPr>
          <a:xfrm>
            <a:off x="6213171" y="729084"/>
            <a:ext cx="164882" cy="274320"/>
            <a:chOff x="8894183" y="520304"/>
            <a:chExt cx="164882" cy="274320"/>
          </a:xfrm>
        </p:grpSpPr>
        <p:cxnSp>
          <p:nvCxnSpPr>
            <p:cNvPr id="191" name="Straight Connector 190">
              <a:extLst>
                <a:ext uri="{FF2B5EF4-FFF2-40B4-BE49-F238E27FC236}">
                  <a16:creationId xmlns:a16="http://schemas.microsoft.com/office/drawing/2014/main" id="{A6BEE01A-B714-42A7-870F-6AD24C6B80C9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2" name="Straight Connector 191">
              <a:extLst>
                <a:ext uri="{FF2B5EF4-FFF2-40B4-BE49-F238E27FC236}">
                  <a16:creationId xmlns:a16="http://schemas.microsoft.com/office/drawing/2014/main" id="{7F8FA2F9-A88C-4811-92F4-9BAB4C9E31D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193" name="Group 192">
            <a:extLst>
              <a:ext uri="{FF2B5EF4-FFF2-40B4-BE49-F238E27FC236}">
                <a16:creationId xmlns:a16="http://schemas.microsoft.com/office/drawing/2014/main" id="{B7B8D18B-4D83-4CE0-9339-F991E9E94136}"/>
              </a:ext>
            </a:extLst>
          </p:cNvPr>
          <p:cNvGrpSpPr/>
          <p:nvPr/>
        </p:nvGrpSpPr>
        <p:grpSpPr>
          <a:xfrm rot="10800000">
            <a:off x="6053771" y="733689"/>
            <a:ext cx="164882" cy="274320"/>
            <a:chOff x="8894183" y="520304"/>
            <a:chExt cx="164882" cy="274320"/>
          </a:xfrm>
        </p:grpSpPr>
        <p:cxnSp>
          <p:nvCxnSpPr>
            <p:cNvPr id="194" name="Straight Connector 193">
              <a:extLst>
                <a:ext uri="{FF2B5EF4-FFF2-40B4-BE49-F238E27FC236}">
                  <a16:creationId xmlns:a16="http://schemas.microsoft.com/office/drawing/2014/main" id="{B7D7D369-B0A0-42F8-9474-8E7FCB41C5F5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5" name="Straight Connector 194">
              <a:extLst>
                <a:ext uri="{FF2B5EF4-FFF2-40B4-BE49-F238E27FC236}">
                  <a16:creationId xmlns:a16="http://schemas.microsoft.com/office/drawing/2014/main" id="{BBDE1C9E-39C8-4B4A-AE7B-F41E1A52AFB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96" name="TextBox 195">
            <a:extLst>
              <a:ext uri="{FF2B5EF4-FFF2-40B4-BE49-F238E27FC236}">
                <a16:creationId xmlns:a16="http://schemas.microsoft.com/office/drawing/2014/main" id="{96479E22-EB61-4F4F-91E0-55C34565BCB7}"/>
              </a:ext>
            </a:extLst>
          </p:cNvPr>
          <p:cNvSpPr txBox="1"/>
          <p:nvPr/>
        </p:nvSpPr>
        <p:spPr>
          <a:xfrm>
            <a:off x="6650693" y="425191"/>
            <a:ext cx="322395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12 </a:t>
            </a:r>
            <a:r>
              <a:rPr lang="en-US" sz="5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11</a:t>
            </a:r>
            <a:r>
              <a:rPr lang="en-US" sz="5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10  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9   </a:t>
            </a:r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8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7   </a:t>
            </a:r>
            <a:r>
              <a:rPr lang="en-US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3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6</a:t>
            </a:r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5   </a:t>
            </a:r>
            <a:r>
              <a:rPr lang="en-US" sz="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4   y3 </a:t>
            </a:r>
            <a:r>
              <a:rPr lang="en-US" sz="8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2 </a:t>
            </a:r>
            <a:r>
              <a:rPr lang="en-US" sz="12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6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1</a:t>
            </a:r>
          </a:p>
        </p:txBody>
      </p:sp>
      <p:sp>
        <p:nvSpPr>
          <p:cNvPr id="197" name="TextBox 196">
            <a:extLst>
              <a:ext uri="{FF2B5EF4-FFF2-40B4-BE49-F238E27FC236}">
                <a16:creationId xmlns:a16="http://schemas.microsoft.com/office/drawing/2014/main" id="{4CCE5622-E559-4D8B-9C1D-C42D3F342594}"/>
              </a:ext>
            </a:extLst>
          </p:cNvPr>
          <p:cNvSpPr txBox="1"/>
          <p:nvPr/>
        </p:nvSpPr>
        <p:spPr>
          <a:xfrm>
            <a:off x="4174228" y="984328"/>
            <a:ext cx="21210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2  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3   b4    </a:t>
            </a:r>
            <a:r>
              <a:rPr lang="en-US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5  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6  </a:t>
            </a:r>
            <a:r>
              <a:rPr lang="en-US" sz="1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7   b8    </a:t>
            </a:r>
            <a:r>
              <a:rPr lang="en-US" sz="11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9</a:t>
            </a:r>
          </a:p>
        </p:txBody>
      </p:sp>
      <p:sp>
        <p:nvSpPr>
          <p:cNvPr id="210" name="TextBox 209">
            <a:extLst>
              <a:ext uri="{FF2B5EF4-FFF2-40B4-BE49-F238E27FC236}">
                <a16:creationId xmlns:a16="http://schemas.microsoft.com/office/drawing/2014/main" id="{32833D0B-421A-4FAD-B1F0-4B1D6CE57CFD}"/>
              </a:ext>
            </a:extLst>
          </p:cNvPr>
          <p:cNvSpPr txBox="1"/>
          <p:nvPr/>
        </p:nvSpPr>
        <p:spPr>
          <a:xfrm>
            <a:off x="5638950" y="421850"/>
            <a:ext cx="11624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16 y15 </a:t>
            </a:r>
            <a:r>
              <a:rPr lang="en-US" sz="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z14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13</a:t>
            </a:r>
          </a:p>
        </p:txBody>
      </p:sp>
      <p:sp>
        <p:nvSpPr>
          <p:cNvPr id="211" name="TextBox 210">
            <a:extLst>
              <a:ext uri="{FF2B5EF4-FFF2-40B4-BE49-F238E27FC236}">
                <a16:creationId xmlns:a16="http://schemas.microsoft.com/office/drawing/2014/main" id="{B9EA0C5A-9D5B-4DE6-8B4F-FC5F737D3657}"/>
              </a:ext>
            </a:extLst>
          </p:cNvPr>
          <p:cNvSpPr txBox="1"/>
          <p:nvPr/>
        </p:nvSpPr>
        <p:spPr>
          <a:xfrm>
            <a:off x="6155768" y="958959"/>
            <a:ext cx="4042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b10</a:t>
            </a:r>
          </a:p>
        </p:txBody>
      </p:sp>
      <p:cxnSp>
        <p:nvCxnSpPr>
          <p:cNvPr id="212" name="Straight Connector 211">
            <a:extLst>
              <a:ext uri="{FF2B5EF4-FFF2-40B4-BE49-F238E27FC236}">
                <a16:creationId xmlns:a16="http://schemas.microsoft.com/office/drawing/2014/main" id="{11AA74AF-65EA-4352-8040-36DA9E50BE55}"/>
              </a:ext>
            </a:extLst>
          </p:cNvPr>
          <p:cNvCxnSpPr>
            <a:cxnSpLocks/>
          </p:cNvCxnSpPr>
          <p:nvPr/>
        </p:nvCxnSpPr>
        <p:spPr>
          <a:xfrm>
            <a:off x="4298067" y="627431"/>
            <a:ext cx="0" cy="114266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20" name="Group 219">
            <a:extLst>
              <a:ext uri="{FF2B5EF4-FFF2-40B4-BE49-F238E27FC236}">
                <a16:creationId xmlns:a16="http://schemas.microsoft.com/office/drawing/2014/main" id="{08ED5324-967B-4CAD-A30D-C57BB8BF3852}"/>
              </a:ext>
            </a:extLst>
          </p:cNvPr>
          <p:cNvGrpSpPr/>
          <p:nvPr/>
        </p:nvGrpSpPr>
        <p:grpSpPr>
          <a:xfrm rot="10800000">
            <a:off x="4241800" y="719001"/>
            <a:ext cx="164882" cy="274320"/>
            <a:chOff x="8894183" y="520304"/>
            <a:chExt cx="164882" cy="274320"/>
          </a:xfrm>
        </p:grpSpPr>
        <p:cxnSp>
          <p:nvCxnSpPr>
            <p:cNvPr id="221" name="Straight Connector 220">
              <a:extLst>
                <a:ext uri="{FF2B5EF4-FFF2-40B4-BE49-F238E27FC236}">
                  <a16:creationId xmlns:a16="http://schemas.microsoft.com/office/drawing/2014/main" id="{4530254B-BD72-4C36-AEDE-B92CCA7A0CD3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2" name="Straight Connector 221">
              <a:extLst>
                <a:ext uri="{FF2B5EF4-FFF2-40B4-BE49-F238E27FC236}">
                  <a16:creationId xmlns:a16="http://schemas.microsoft.com/office/drawing/2014/main" id="{4F90AE0D-F2A7-428D-8E3D-DA25F3C8511B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223" name="Group 222">
            <a:extLst>
              <a:ext uri="{FF2B5EF4-FFF2-40B4-BE49-F238E27FC236}">
                <a16:creationId xmlns:a16="http://schemas.microsoft.com/office/drawing/2014/main" id="{581410A2-F562-47A0-A8AF-21D4CB51380C}"/>
              </a:ext>
            </a:extLst>
          </p:cNvPr>
          <p:cNvGrpSpPr/>
          <p:nvPr/>
        </p:nvGrpSpPr>
        <p:grpSpPr>
          <a:xfrm rot="10800000">
            <a:off x="5047976" y="728778"/>
            <a:ext cx="164882" cy="274320"/>
            <a:chOff x="8894183" y="520304"/>
            <a:chExt cx="164882" cy="274320"/>
          </a:xfrm>
        </p:grpSpPr>
        <p:cxnSp>
          <p:nvCxnSpPr>
            <p:cNvPr id="224" name="Straight Connector 223">
              <a:extLst>
                <a:ext uri="{FF2B5EF4-FFF2-40B4-BE49-F238E27FC236}">
                  <a16:creationId xmlns:a16="http://schemas.microsoft.com/office/drawing/2014/main" id="{532A8946-5697-415A-8A25-C728527DAD64}"/>
                </a:ext>
              </a:extLst>
            </p:cNvPr>
            <p:cNvCxnSpPr>
              <a:cxnSpLocks/>
            </p:cNvCxnSpPr>
            <p:nvPr/>
          </p:nvCxnSpPr>
          <p:spPr>
            <a:xfrm>
              <a:off x="8896722" y="520304"/>
              <a:ext cx="0" cy="2743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5" name="Straight Connector 224">
              <a:extLst>
                <a:ext uri="{FF2B5EF4-FFF2-40B4-BE49-F238E27FC236}">
                  <a16:creationId xmlns:a16="http://schemas.microsoft.com/office/drawing/2014/main" id="{B080DE09-84A4-4886-BE39-FB41F12F3C1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8894183" y="521651"/>
              <a:ext cx="16488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27" name="TextBox 226">
            <a:extLst>
              <a:ext uri="{FF2B5EF4-FFF2-40B4-BE49-F238E27FC236}">
                <a16:creationId xmlns:a16="http://schemas.microsoft.com/office/drawing/2014/main" id="{99E4EFFC-209A-481F-BA8D-4FE306494044}"/>
              </a:ext>
            </a:extLst>
          </p:cNvPr>
          <p:cNvSpPr txBox="1"/>
          <p:nvPr/>
        </p:nvSpPr>
        <p:spPr>
          <a:xfrm>
            <a:off x="8535545" y="1065401"/>
            <a:ext cx="1690018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1_MOUSE</a:t>
            </a:r>
          </a:p>
          <a:p>
            <a:r>
              <a:rPr lang="en-US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ynapsin-1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6F6A5927-571F-4D0C-95AA-0308996E2F64}"/>
              </a:ext>
            </a:extLst>
          </p:cNvPr>
          <p:cNvSpPr txBox="1"/>
          <p:nvPr/>
        </p:nvSpPr>
        <p:spPr>
          <a:xfrm>
            <a:off x="694901" y="854123"/>
            <a:ext cx="17967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-score: 54.007</a:t>
            </a:r>
          </a:p>
        </p:txBody>
      </p:sp>
      <p:sp>
        <p:nvSpPr>
          <p:cNvPr id="149" name="TextBox 148">
            <a:extLst>
              <a:ext uri="{FF2B5EF4-FFF2-40B4-BE49-F238E27FC236}">
                <a16:creationId xmlns:a16="http://schemas.microsoft.com/office/drawing/2014/main" id="{60B5DF37-A4D2-4E9B-9532-7F9EE02A802D}"/>
              </a:ext>
            </a:extLst>
          </p:cNvPr>
          <p:cNvSpPr txBox="1"/>
          <p:nvPr/>
        </p:nvSpPr>
        <p:spPr>
          <a:xfrm>
            <a:off x="694901" y="347457"/>
            <a:ext cx="17967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TD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0E3A88D4-475A-4E3C-9812-5D8D22D70A26}"/>
              </a:ext>
            </a:extLst>
          </p:cNvPr>
          <p:cNvSpPr txBox="1"/>
          <p:nvPr/>
        </p:nvSpPr>
        <p:spPr>
          <a:xfrm>
            <a:off x="694901" y="3639800"/>
            <a:ext cx="179679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D</a:t>
            </a:r>
          </a:p>
        </p:txBody>
      </p:sp>
      <p:sp>
        <p:nvSpPr>
          <p:cNvPr id="2" name="Rectangle 1"/>
          <p:cNvSpPr/>
          <p:nvPr/>
        </p:nvSpPr>
        <p:spPr>
          <a:xfrm>
            <a:off x="10034370" y="53593"/>
            <a:ext cx="2056473" cy="61863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b="1" dirty="0" smtClean="0"/>
              <a:t>Supplemental Figure 3. </a:t>
            </a:r>
            <a:r>
              <a:rPr lang="en-US" dirty="0" smtClean="0"/>
              <a:t>MS/MS </a:t>
            </a:r>
            <a:r>
              <a:rPr lang="en-US" dirty="0"/>
              <a:t>spectra illustrate the identification of an O-GlcNAcylated peptide from SYN1 in the mouse brain.  The labeled O-GlcNAc peptides were identified with electron-transfer dissociation (ETD) (top panel) and high-energy collisional dissociation (HCD) (bottom panel).  The position of O-GlcNAcylation is indicated.  </a:t>
            </a:r>
          </a:p>
        </p:txBody>
      </p:sp>
    </p:spTree>
    <p:extLst>
      <p:ext uri="{BB962C8B-B14F-4D97-AF65-F5344CB8AC3E}">
        <p14:creationId xmlns:p14="http://schemas.microsoft.com/office/powerpoint/2010/main" val="11048596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</TotalTime>
  <Words>368</Words>
  <Application>Microsoft Office PowerPoint</Application>
  <PresentationFormat>Widescreen</PresentationFormat>
  <Paragraphs>71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, Xiaolu</dc:creator>
  <cp:lastModifiedBy>Zhang, Jianhua (Campus)</cp:lastModifiedBy>
  <cp:revision>29</cp:revision>
  <dcterms:created xsi:type="dcterms:W3CDTF">2021-08-12T04:57:57Z</dcterms:created>
  <dcterms:modified xsi:type="dcterms:W3CDTF">2021-08-12T17:48:48Z</dcterms:modified>
</cp:coreProperties>
</file>